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10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1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2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3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4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5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6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7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charts/chart18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ppt/charts/chart19.xml" ContentType="application/vnd.openxmlformats-officedocument.drawingml.chart+xml"/>
  <Override PartName="/ppt/charts/style18.xml" ContentType="application/vnd.ms-office.chartstyle+xml"/>
  <Override PartName="/ppt/charts/colors18.xml" ContentType="application/vnd.ms-office.chartcolorstyle+xml"/>
  <Override PartName="/ppt/charts/chart20.xml" ContentType="application/vnd.openxmlformats-officedocument.drawingml.chart+xml"/>
  <Override PartName="/ppt/charts/style19.xml" ContentType="application/vnd.ms-office.chartstyle+xml"/>
  <Override PartName="/ppt/charts/colors19.xml" ContentType="application/vnd.ms-office.chartcolorstyl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166" autoAdjust="0"/>
    <p:restoredTop sz="94660"/>
  </p:normalViewPr>
  <p:slideViewPr>
    <p:cSldViewPr snapToGrid="0">
      <p:cViewPr varScale="1">
        <p:scale>
          <a:sx n="68" d="100"/>
          <a:sy n="68" d="100"/>
        </p:scale>
        <p:origin x="166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OKAGAWA Tomohiro" userId="d74b3e309c52a267" providerId="LiveId" clId="{75BADE36-D135-44E3-A78F-3516F48BF828}"/>
    <pc:docChg chg="undo custSel modSld">
      <pc:chgData name="OKAGAWA Tomohiro" userId="d74b3e309c52a267" providerId="LiveId" clId="{75BADE36-D135-44E3-A78F-3516F48BF828}" dt="2021-12-28T01:53:35.412" v="96" actId="14100"/>
      <pc:docMkLst>
        <pc:docMk/>
      </pc:docMkLst>
      <pc:sldChg chg="addSp modSp mod">
        <pc:chgData name="OKAGAWA Tomohiro" userId="d74b3e309c52a267" providerId="LiveId" clId="{75BADE36-D135-44E3-A78F-3516F48BF828}" dt="2021-12-28T01:53:35.412" v="96" actId="14100"/>
        <pc:sldMkLst>
          <pc:docMk/>
          <pc:sldMk cId="4282525776" sldId="256"/>
        </pc:sldMkLst>
        <pc:spChg chg="mod">
          <ac:chgData name="OKAGAWA Tomohiro" userId="d74b3e309c52a267" providerId="LiveId" clId="{75BADE36-D135-44E3-A78F-3516F48BF828}" dt="2021-12-28T01:52:45.602" v="67" actId="1035"/>
          <ac:spMkLst>
            <pc:docMk/>
            <pc:sldMk cId="4282525776" sldId="256"/>
            <ac:spMk id="138" creationId="{DFDF95D8-B357-43DF-9B17-8601D803838E}"/>
          </ac:spMkLst>
        </pc:spChg>
        <pc:spChg chg="mod">
          <ac:chgData name="OKAGAWA Tomohiro" userId="d74b3e309c52a267" providerId="LiveId" clId="{75BADE36-D135-44E3-A78F-3516F48BF828}" dt="2021-12-28T01:52:45.602" v="67" actId="1035"/>
          <ac:spMkLst>
            <pc:docMk/>
            <pc:sldMk cId="4282525776" sldId="256"/>
            <ac:spMk id="139" creationId="{CD601760-96FA-4B3A-8C3A-744723CEDE29}"/>
          </ac:spMkLst>
        </pc:spChg>
        <pc:spChg chg="mod">
          <ac:chgData name="OKAGAWA Tomohiro" userId="d74b3e309c52a267" providerId="LiveId" clId="{75BADE36-D135-44E3-A78F-3516F48BF828}" dt="2021-12-28T01:52:45.602" v="67" actId="1035"/>
          <ac:spMkLst>
            <pc:docMk/>
            <pc:sldMk cId="4282525776" sldId="256"/>
            <ac:spMk id="140" creationId="{59D467CB-33B1-4CA3-8E6D-3183ED61E224}"/>
          </ac:spMkLst>
        </pc:spChg>
        <pc:spChg chg="mod">
          <ac:chgData name="OKAGAWA Tomohiro" userId="d74b3e309c52a267" providerId="LiveId" clId="{75BADE36-D135-44E3-A78F-3516F48BF828}" dt="2021-12-28T01:52:45.602" v="67" actId="1035"/>
          <ac:spMkLst>
            <pc:docMk/>
            <pc:sldMk cId="4282525776" sldId="256"/>
            <ac:spMk id="141" creationId="{1AFC04EB-1A16-4F14-A864-35E7E44F8273}"/>
          </ac:spMkLst>
        </pc:spChg>
        <pc:spChg chg="mod">
          <ac:chgData name="OKAGAWA Tomohiro" userId="d74b3e309c52a267" providerId="LiveId" clId="{75BADE36-D135-44E3-A78F-3516F48BF828}" dt="2021-12-28T01:52:45.602" v="67" actId="1035"/>
          <ac:spMkLst>
            <pc:docMk/>
            <pc:sldMk cId="4282525776" sldId="256"/>
            <ac:spMk id="142" creationId="{5F15F3C2-BFC9-4ECD-A783-3B956FD0F51C}"/>
          </ac:spMkLst>
        </pc:spChg>
        <pc:spChg chg="mod">
          <ac:chgData name="OKAGAWA Tomohiro" userId="d74b3e309c52a267" providerId="LiveId" clId="{75BADE36-D135-44E3-A78F-3516F48BF828}" dt="2021-12-28T01:52:29.821" v="61" actId="164"/>
          <ac:spMkLst>
            <pc:docMk/>
            <pc:sldMk cId="4282525776" sldId="256"/>
            <ac:spMk id="204" creationId="{0802CD19-DB20-49F2-A6BB-6A8C3D0ABCD6}"/>
          </ac:spMkLst>
        </pc:spChg>
        <pc:spChg chg="mod">
          <ac:chgData name="OKAGAWA Tomohiro" userId="d74b3e309c52a267" providerId="LiveId" clId="{75BADE36-D135-44E3-A78F-3516F48BF828}" dt="2021-12-28T01:52:29.821" v="61" actId="164"/>
          <ac:spMkLst>
            <pc:docMk/>
            <pc:sldMk cId="4282525776" sldId="256"/>
            <ac:spMk id="205" creationId="{17160D7E-FD91-4AD5-8210-857F5E7A9BD5}"/>
          </ac:spMkLst>
        </pc:spChg>
        <pc:spChg chg="mod">
          <ac:chgData name="OKAGAWA Tomohiro" userId="d74b3e309c52a267" providerId="LiveId" clId="{75BADE36-D135-44E3-A78F-3516F48BF828}" dt="2021-12-28T01:52:29.821" v="61" actId="164"/>
          <ac:spMkLst>
            <pc:docMk/>
            <pc:sldMk cId="4282525776" sldId="256"/>
            <ac:spMk id="206" creationId="{2282024B-C8B5-4EB0-AD3F-F981B7E23CB3}"/>
          </ac:spMkLst>
        </pc:spChg>
        <pc:spChg chg="mod">
          <ac:chgData name="OKAGAWA Tomohiro" userId="d74b3e309c52a267" providerId="LiveId" clId="{75BADE36-D135-44E3-A78F-3516F48BF828}" dt="2021-12-28T01:52:29.821" v="61" actId="164"/>
          <ac:spMkLst>
            <pc:docMk/>
            <pc:sldMk cId="4282525776" sldId="256"/>
            <ac:spMk id="207" creationId="{0A527773-E1A2-4E82-BAFC-43C6DFAC76E0}"/>
          </ac:spMkLst>
        </pc:spChg>
        <pc:spChg chg="mod">
          <ac:chgData name="OKAGAWA Tomohiro" userId="d74b3e309c52a267" providerId="LiveId" clId="{75BADE36-D135-44E3-A78F-3516F48BF828}" dt="2021-12-28T01:52:29.821" v="61" actId="164"/>
          <ac:spMkLst>
            <pc:docMk/>
            <pc:sldMk cId="4282525776" sldId="256"/>
            <ac:spMk id="208" creationId="{A0B6099F-3D33-4E27-A28A-6CC8393BC4D9}"/>
          </ac:spMkLst>
        </pc:spChg>
        <pc:spChg chg="mod">
          <ac:chgData name="OKAGAWA Tomohiro" userId="d74b3e309c52a267" providerId="LiveId" clId="{75BADE36-D135-44E3-A78F-3516F48BF828}" dt="2021-12-28T01:52:33.848" v="64" actId="164"/>
          <ac:spMkLst>
            <pc:docMk/>
            <pc:sldMk cId="4282525776" sldId="256"/>
            <ac:spMk id="251" creationId="{327858A6-8BD7-4702-AA64-66C7353FDB49}"/>
          </ac:spMkLst>
        </pc:spChg>
        <pc:spChg chg="mod">
          <ac:chgData name="OKAGAWA Tomohiro" userId="d74b3e309c52a267" providerId="LiveId" clId="{75BADE36-D135-44E3-A78F-3516F48BF828}" dt="2021-12-28T01:52:33.848" v="64" actId="164"/>
          <ac:spMkLst>
            <pc:docMk/>
            <pc:sldMk cId="4282525776" sldId="256"/>
            <ac:spMk id="252" creationId="{E8FBFB14-E75E-456B-9C75-31B9CC63A5DA}"/>
          </ac:spMkLst>
        </pc:spChg>
        <pc:spChg chg="mod">
          <ac:chgData name="OKAGAWA Tomohiro" userId="d74b3e309c52a267" providerId="LiveId" clId="{75BADE36-D135-44E3-A78F-3516F48BF828}" dt="2021-12-28T01:52:33.848" v="64" actId="164"/>
          <ac:spMkLst>
            <pc:docMk/>
            <pc:sldMk cId="4282525776" sldId="256"/>
            <ac:spMk id="253" creationId="{72C8FA85-0255-487E-B937-100177028455}"/>
          </ac:spMkLst>
        </pc:spChg>
        <pc:spChg chg="mod">
          <ac:chgData name="OKAGAWA Tomohiro" userId="d74b3e309c52a267" providerId="LiveId" clId="{75BADE36-D135-44E3-A78F-3516F48BF828}" dt="2021-12-28T01:52:33.848" v="64" actId="164"/>
          <ac:spMkLst>
            <pc:docMk/>
            <pc:sldMk cId="4282525776" sldId="256"/>
            <ac:spMk id="254" creationId="{5B779BCD-4354-4A05-BD9D-BDB6B012E7E3}"/>
          </ac:spMkLst>
        </pc:spChg>
        <pc:spChg chg="mod">
          <ac:chgData name="OKAGAWA Tomohiro" userId="d74b3e309c52a267" providerId="LiveId" clId="{75BADE36-D135-44E3-A78F-3516F48BF828}" dt="2021-12-28T01:52:33.848" v="64" actId="164"/>
          <ac:spMkLst>
            <pc:docMk/>
            <pc:sldMk cId="4282525776" sldId="256"/>
            <ac:spMk id="255" creationId="{15D5D17E-E35D-4A87-852A-87B5DE35D7ED}"/>
          </ac:spMkLst>
        </pc:spChg>
        <pc:spChg chg="mod">
          <ac:chgData name="OKAGAWA Tomohiro" userId="d74b3e309c52a267" providerId="LiveId" clId="{75BADE36-D135-44E3-A78F-3516F48BF828}" dt="2021-12-28T01:53:35.412" v="96" actId="14100"/>
          <ac:spMkLst>
            <pc:docMk/>
            <pc:sldMk cId="4282525776" sldId="256"/>
            <ac:spMk id="308" creationId="{8A6F30CD-D532-4CA6-9841-22602DF89725}"/>
          </ac:spMkLst>
        </pc:spChg>
        <pc:spChg chg="mod">
          <ac:chgData name="OKAGAWA Tomohiro" userId="d74b3e309c52a267" providerId="LiveId" clId="{75BADE36-D135-44E3-A78F-3516F48BF828}" dt="2021-12-28T01:53:35.412" v="96" actId="14100"/>
          <ac:spMkLst>
            <pc:docMk/>
            <pc:sldMk cId="4282525776" sldId="256"/>
            <ac:spMk id="309" creationId="{7C92B87B-CC46-4D21-BB8F-D53E6DDB4792}"/>
          </ac:spMkLst>
        </pc:spChg>
        <pc:spChg chg="mod">
          <ac:chgData name="OKAGAWA Tomohiro" userId="d74b3e309c52a267" providerId="LiveId" clId="{75BADE36-D135-44E3-A78F-3516F48BF828}" dt="2021-12-28T01:53:35.412" v="96" actId="14100"/>
          <ac:spMkLst>
            <pc:docMk/>
            <pc:sldMk cId="4282525776" sldId="256"/>
            <ac:spMk id="310" creationId="{80EB3888-B9C9-4315-B4A0-56B89F6B3D24}"/>
          </ac:spMkLst>
        </pc:spChg>
        <pc:spChg chg="mod">
          <ac:chgData name="OKAGAWA Tomohiro" userId="d74b3e309c52a267" providerId="LiveId" clId="{75BADE36-D135-44E3-A78F-3516F48BF828}" dt="2021-12-28T01:53:35.412" v="96" actId="14100"/>
          <ac:spMkLst>
            <pc:docMk/>
            <pc:sldMk cId="4282525776" sldId="256"/>
            <ac:spMk id="311" creationId="{CC823E47-B3A3-4341-A6DB-3BAC2163F0C8}"/>
          </ac:spMkLst>
        </pc:spChg>
        <pc:grpChg chg="mod">
          <ac:chgData name="OKAGAWA Tomohiro" userId="d74b3e309c52a267" providerId="LiveId" clId="{75BADE36-D135-44E3-A78F-3516F48BF828}" dt="2021-12-28T01:52:20.262" v="58" actId="1035"/>
          <ac:grpSpMkLst>
            <pc:docMk/>
            <pc:sldMk cId="4282525776" sldId="256"/>
            <ac:grpSpMk id="4" creationId="{9BE6D51C-D593-4FF4-8141-2F4998AC97DA}"/>
          </ac:grpSpMkLst>
        </pc:grpChg>
        <pc:grpChg chg="mod">
          <ac:chgData name="OKAGAWA Tomohiro" userId="d74b3e309c52a267" providerId="LiveId" clId="{75BADE36-D135-44E3-A78F-3516F48BF828}" dt="2021-12-28T01:52:20.262" v="58" actId="1035"/>
          <ac:grpSpMkLst>
            <pc:docMk/>
            <pc:sldMk cId="4282525776" sldId="256"/>
            <ac:grpSpMk id="5" creationId="{BC69CD75-CBAE-4804-BDF4-348C5967991B}"/>
          </ac:grpSpMkLst>
        </pc:grpChg>
        <pc:grpChg chg="mod">
          <ac:chgData name="OKAGAWA Tomohiro" userId="d74b3e309c52a267" providerId="LiveId" clId="{75BADE36-D135-44E3-A78F-3516F48BF828}" dt="2021-12-28T01:52:20.262" v="58" actId="1035"/>
          <ac:grpSpMkLst>
            <pc:docMk/>
            <pc:sldMk cId="4282525776" sldId="256"/>
            <ac:grpSpMk id="6" creationId="{DE80BE6E-0CC8-4C43-99BE-B86CF2E32327}"/>
          </ac:grpSpMkLst>
        </pc:grpChg>
        <pc:grpChg chg="mod">
          <ac:chgData name="OKAGAWA Tomohiro" userId="d74b3e309c52a267" providerId="LiveId" clId="{75BADE36-D135-44E3-A78F-3516F48BF828}" dt="2021-12-28T01:52:20.262" v="58" actId="1035"/>
          <ac:grpSpMkLst>
            <pc:docMk/>
            <pc:sldMk cId="4282525776" sldId="256"/>
            <ac:grpSpMk id="7" creationId="{9A958313-3D83-40CD-9200-C980C5416034}"/>
          </ac:grpSpMkLst>
        </pc:grpChg>
        <pc:grpChg chg="mod">
          <ac:chgData name="OKAGAWA Tomohiro" userId="d74b3e309c52a267" providerId="LiveId" clId="{75BADE36-D135-44E3-A78F-3516F48BF828}" dt="2021-12-28T01:52:20.262" v="58" actId="1035"/>
          <ac:grpSpMkLst>
            <pc:docMk/>
            <pc:sldMk cId="4282525776" sldId="256"/>
            <ac:grpSpMk id="9" creationId="{9D2128F1-42F6-44D8-B0FB-56D5DEC35194}"/>
          </ac:grpSpMkLst>
        </pc:grpChg>
        <pc:grpChg chg="mod">
          <ac:chgData name="OKAGAWA Tomohiro" userId="d74b3e309c52a267" providerId="LiveId" clId="{75BADE36-D135-44E3-A78F-3516F48BF828}" dt="2021-12-28T01:52:20.262" v="58" actId="1035"/>
          <ac:grpSpMkLst>
            <pc:docMk/>
            <pc:sldMk cId="4282525776" sldId="256"/>
            <ac:grpSpMk id="10" creationId="{D10B65A6-B7F2-4CC8-9B23-8DD22B70097A}"/>
          </ac:grpSpMkLst>
        </pc:grpChg>
        <pc:grpChg chg="mod">
          <ac:chgData name="OKAGAWA Tomohiro" userId="d74b3e309c52a267" providerId="LiveId" clId="{75BADE36-D135-44E3-A78F-3516F48BF828}" dt="2021-12-28T01:52:20.262" v="58" actId="1035"/>
          <ac:grpSpMkLst>
            <pc:docMk/>
            <pc:sldMk cId="4282525776" sldId="256"/>
            <ac:grpSpMk id="11" creationId="{F6AB37EA-CAC2-46B2-955B-0AA8697E5BAE}"/>
          </ac:grpSpMkLst>
        </pc:grpChg>
        <pc:grpChg chg="mod">
          <ac:chgData name="OKAGAWA Tomohiro" userId="d74b3e309c52a267" providerId="LiveId" clId="{75BADE36-D135-44E3-A78F-3516F48BF828}" dt="2021-12-28T01:52:20.262" v="58" actId="1035"/>
          <ac:grpSpMkLst>
            <pc:docMk/>
            <pc:sldMk cId="4282525776" sldId="256"/>
            <ac:grpSpMk id="12" creationId="{36541772-1164-4173-ABF4-A504A338E005}"/>
          </ac:grpSpMkLst>
        </pc:grpChg>
        <pc:grpChg chg="mod">
          <ac:chgData name="OKAGAWA Tomohiro" userId="d74b3e309c52a267" providerId="LiveId" clId="{75BADE36-D135-44E3-A78F-3516F48BF828}" dt="2021-12-28T01:52:20.262" v="58" actId="1035"/>
          <ac:grpSpMkLst>
            <pc:docMk/>
            <pc:sldMk cId="4282525776" sldId="256"/>
            <ac:grpSpMk id="13" creationId="{C65EA468-A233-40C9-8795-C55863616DA0}"/>
          </ac:grpSpMkLst>
        </pc:grpChg>
        <pc:grpChg chg="mod">
          <ac:chgData name="OKAGAWA Tomohiro" userId="d74b3e309c52a267" providerId="LiveId" clId="{75BADE36-D135-44E3-A78F-3516F48BF828}" dt="2021-12-28T01:52:25.341" v="60" actId="1076"/>
          <ac:grpSpMkLst>
            <pc:docMk/>
            <pc:sldMk cId="4282525776" sldId="256"/>
            <ac:grpSpMk id="14" creationId="{1F3D668B-7FE1-4C08-8B21-C56885343819}"/>
          </ac:grpSpMkLst>
        </pc:grpChg>
        <pc:grpChg chg="add mod">
          <ac:chgData name="OKAGAWA Tomohiro" userId="d74b3e309c52a267" providerId="LiveId" clId="{75BADE36-D135-44E3-A78F-3516F48BF828}" dt="2021-12-28T01:52:29.821" v="61" actId="164"/>
          <ac:grpSpMkLst>
            <pc:docMk/>
            <pc:sldMk cId="4282525776" sldId="256"/>
            <ac:grpSpMk id="16" creationId="{B993CF61-7C51-4103-B6EC-1B08611A8C58}"/>
          </ac:grpSpMkLst>
        </pc:grpChg>
        <pc:grpChg chg="add mod">
          <ac:chgData name="OKAGAWA Tomohiro" userId="d74b3e309c52a267" providerId="LiveId" clId="{75BADE36-D135-44E3-A78F-3516F48BF828}" dt="2021-12-28T01:52:32.920" v="63" actId="164"/>
          <ac:grpSpMkLst>
            <pc:docMk/>
            <pc:sldMk cId="4282525776" sldId="256"/>
            <ac:grpSpMk id="17" creationId="{89622BE6-29C2-4EAE-8B93-66CB0234CA32}"/>
          </ac:grpSpMkLst>
        </pc:grpChg>
        <pc:grpChg chg="add mod">
          <ac:chgData name="OKAGAWA Tomohiro" userId="d74b3e309c52a267" providerId="LiveId" clId="{75BADE36-D135-44E3-A78F-3516F48BF828}" dt="2021-12-28T01:52:33.848" v="64" actId="164"/>
          <ac:grpSpMkLst>
            <pc:docMk/>
            <pc:sldMk cId="4282525776" sldId="256"/>
            <ac:grpSpMk id="18" creationId="{0E2D5BCA-DA66-4B1C-B91E-6C1E250891FF}"/>
          </ac:grpSpMkLst>
        </pc:grpChg>
        <pc:grpChg chg="mod">
          <ac:chgData name="OKAGAWA Tomohiro" userId="d74b3e309c52a267" providerId="LiveId" clId="{75BADE36-D135-44E3-A78F-3516F48BF828}" dt="2021-12-28T01:52:20.262" v="58" actId="1035"/>
          <ac:grpSpMkLst>
            <pc:docMk/>
            <pc:sldMk cId="4282525776" sldId="256"/>
            <ac:grpSpMk id="157" creationId="{E1B9FD43-D08C-431D-B1DD-B3DE34C4537C}"/>
          </ac:grpSpMkLst>
        </pc:grpChg>
        <pc:grpChg chg="mod">
          <ac:chgData name="OKAGAWA Tomohiro" userId="d74b3e309c52a267" providerId="LiveId" clId="{75BADE36-D135-44E3-A78F-3516F48BF828}" dt="2021-12-28T01:52:20.262" v="58" actId="1035"/>
          <ac:grpSpMkLst>
            <pc:docMk/>
            <pc:sldMk cId="4282525776" sldId="256"/>
            <ac:grpSpMk id="171" creationId="{D301B339-8E17-45F2-A858-119DB467AB8A}"/>
          </ac:grpSpMkLst>
        </pc:grpChg>
        <pc:grpChg chg="mod">
          <ac:chgData name="OKAGAWA Tomohiro" userId="d74b3e309c52a267" providerId="LiveId" clId="{75BADE36-D135-44E3-A78F-3516F48BF828}" dt="2021-12-28T01:52:20.262" v="58" actId="1035"/>
          <ac:grpSpMkLst>
            <pc:docMk/>
            <pc:sldMk cId="4282525776" sldId="256"/>
            <ac:grpSpMk id="178" creationId="{17690C5A-1723-49C8-9F6D-5B106591572F}"/>
          </ac:grpSpMkLst>
        </pc:grpChg>
        <pc:grpChg chg="mod">
          <ac:chgData name="OKAGAWA Tomohiro" userId="d74b3e309c52a267" providerId="LiveId" clId="{75BADE36-D135-44E3-A78F-3516F48BF828}" dt="2021-12-28T01:52:20.262" v="58" actId="1035"/>
          <ac:grpSpMkLst>
            <pc:docMk/>
            <pc:sldMk cId="4282525776" sldId="256"/>
            <ac:grpSpMk id="238" creationId="{244B0FFD-3C66-415C-ABFB-316E6B40E8D4}"/>
          </ac:grpSpMkLst>
        </pc:grpChg>
        <pc:grpChg chg="mod">
          <ac:chgData name="OKAGAWA Tomohiro" userId="d74b3e309c52a267" providerId="LiveId" clId="{75BADE36-D135-44E3-A78F-3516F48BF828}" dt="2021-12-28T01:52:20.262" v="58" actId="1035"/>
          <ac:grpSpMkLst>
            <pc:docMk/>
            <pc:sldMk cId="4282525776" sldId="256"/>
            <ac:grpSpMk id="268" creationId="{3D0D53C5-B584-405E-BA17-01CD6BE9D5F9}"/>
          </ac:grpSpMkLst>
        </pc:grpChg>
        <pc:graphicFrameChg chg="mod">
          <ac:chgData name="OKAGAWA Tomohiro" userId="d74b3e309c52a267" providerId="LiveId" clId="{75BADE36-D135-44E3-A78F-3516F48BF828}" dt="2021-12-28T01:52:20.262" v="58" actId="1035"/>
          <ac:graphicFrameMkLst>
            <pc:docMk/>
            <pc:sldMk cId="4282525776" sldId="256"/>
            <ac:graphicFrameMk id="156" creationId="{96020893-7042-40DD-B397-AF04A8A5C00F}"/>
          </ac:graphicFrameMkLst>
        </pc:graphicFrameChg>
        <pc:graphicFrameChg chg="mod">
          <ac:chgData name="OKAGAWA Tomohiro" userId="d74b3e309c52a267" providerId="LiveId" clId="{75BADE36-D135-44E3-A78F-3516F48BF828}" dt="2021-12-28T01:52:29.821" v="61" actId="164"/>
          <ac:graphicFrameMkLst>
            <pc:docMk/>
            <pc:sldMk cId="4282525776" sldId="256"/>
            <ac:graphicFrameMk id="203" creationId="{66B028DD-37F9-4778-81DC-F3028C748A39}"/>
          </ac:graphicFrameMkLst>
        </pc:graphicFrameChg>
        <pc:graphicFrameChg chg="mod">
          <ac:chgData name="OKAGAWA Tomohiro" userId="d74b3e309c52a267" providerId="LiveId" clId="{75BADE36-D135-44E3-A78F-3516F48BF828}" dt="2021-12-28T01:52:33.848" v="64" actId="164"/>
          <ac:graphicFrameMkLst>
            <pc:docMk/>
            <pc:sldMk cId="4282525776" sldId="256"/>
            <ac:graphicFrameMk id="250" creationId="{6EAD10FA-D65A-49A6-95B9-4321DC2B44BE}"/>
          </ac:graphicFrameMkLst>
        </pc:graphicFrameChg>
      </pc:sldChg>
      <pc:sldChg chg="modSp mod">
        <pc:chgData name="OKAGAWA Tomohiro" userId="d74b3e309c52a267" providerId="LiveId" clId="{75BADE36-D135-44E3-A78F-3516F48BF828}" dt="2021-12-28T01:53:29.050" v="95" actId="14100"/>
        <pc:sldMkLst>
          <pc:docMk/>
          <pc:sldMk cId="1049214770" sldId="258"/>
        </pc:sldMkLst>
        <pc:spChg chg="mod">
          <ac:chgData name="OKAGAWA Tomohiro" userId="d74b3e309c52a267" providerId="LiveId" clId="{75BADE36-D135-44E3-A78F-3516F48BF828}" dt="2021-12-28T01:52:52.002" v="68" actId="1036"/>
          <ac:spMkLst>
            <pc:docMk/>
            <pc:sldMk cId="1049214770" sldId="258"/>
            <ac:spMk id="14" creationId="{62B2D419-117B-4197-875F-48323B0501C5}"/>
          </ac:spMkLst>
        </pc:spChg>
        <pc:spChg chg="mod">
          <ac:chgData name="OKAGAWA Tomohiro" userId="d74b3e309c52a267" providerId="LiveId" clId="{75BADE36-D135-44E3-A78F-3516F48BF828}" dt="2021-12-28T01:52:52.002" v="68" actId="1036"/>
          <ac:spMkLst>
            <pc:docMk/>
            <pc:sldMk cId="1049214770" sldId="258"/>
            <ac:spMk id="22" creationId="{5E11D11A-0430-4FDE-ABEE-2327C1EF2331}"/>
          </ac:spMkLst>
        </pc:spChg>
        <pc:spChg chg="mod">
          <ac:chgData name="OKAGAWA Tomohiro" userId="d74b3e309c52a267" providerId="LiveId" clId="{75BADE36-D135-44E3-A78F-3516F48BF828}" dt="2021-12-28T01:52:52.002" v="68" actId="1036"/>
          <ac:spMkLst>
            <pc:docMk/>
            <pc:sldMk cId="1049214770" sldId="258"/>
            <ac:spMk id="23" creationId="{E0AF336E-F4C2-402B-8F6B-FB6919BF1C3E}"/>
          </ac:spMkLst>
        </pc:spChg>
        <pc:spChg chg="mod">
          <ac:chgData name="OKAGAWA Tomohiro" userId="d74b3e309c52a267" providerId="LiveId" clId="{75BADE36-D135-44E3-A78F-3516F48BF828}" dt="2021-12-28T01:52:52.002" v="68" actId="1036"/>
          <ac:spMkLst>
            <pc:docMk/>
            <pc:sldMk cId="1049214770" sldId="258"/>
            <ac:spMk id="24" creationId="{0C62D14F-DB67-4342-8167-8D35A5D4EBE3}"/>
          </ac:spMkLst>
        </pc:spChg>
        <pc:spChg chg="mod">
          <ac:chgData name="OKAGAWA Tomohiro" userId="d74b3e309c52a267" providerId="LiveId" clId="{75BADE36-D135-44E3-A78F-3516F48BF828}" dt="2021-12-28T01:52:52.002" v="68" actId="1036"/>
          <ac:spMkLst>
            <pc:docMk/>
            <pc:sldMk cId="1049214770" sldId="258"/>
            <ac:spMk id="25" creationId="{58405EC4-F9F3-4AEF-9058-A71A143BA2B7}"/>
          </ac:spMkLst>
        </pc:spChg>
        <pc:spChg chg="mod">
          <ac:chgData name="OKAGAWA Tomohiro" userId="d74b3e309c52a267" providerId="LiveId" clId="{75BADE36-D135-44E3-A78F-3516F48BF828}" dt="2021-12-28T01:53:29.050" v="95" actId="14100"/>
          <ac:spMkLst>
            <pc:docMk/>
            <pc:sldMk cId="1049214770" sldId="258"/>
            <ac:spMk id="48" creationId="{183674AD-C712-4537-AC33-0F276CBA7671}"/>
          </ac:spMkLst>
        </pc:spChg>
        <pc:spChg chg="mod">
          <ac:chgData name="OKAGAWA Tomohiro" userId="d74b3e309c52a267" providerId="LiveId" clId="{75BADE36-D135-44E3-A78F-3516F48BF828}" dt="2021-12-28T01:53:29.050" v="95" actId="14100"/>
          <ac:spMkLst>
            <pc:docMk/>
            <pc:sldMk cId="1049214770" sldId="258"/>
            <ac:spMk id="49" creationId="{7141F538-6366-428F-889F-852B285C5170}"/>
          </ac:spMkLst>
        </pc:spChg>
        <pc:spChg chg="mod">
          <ac:chgData name="OKAGAWA Tomohiro" userId="d74b3e309c52a267" providerId="LiveId" clId="{75BADE36-D135-44E3-A78F-3516F48BF828}" dt="2021-12-28T01:53:29.050" v="95" actId="14100"/>
          <ac:spMkLst>
            <pc:docMk/>
            <pc:sldMk cId="1049214770" sldId="258"/>
            <ac:spMk id="50" creationId="{4002E3E0-C19F-4E1A-B12B-9379560EC1AB}"/>
          </ac:spMkLst>
        </pc:spChg>
        <pc:spChg chg="mod">
          <ac:chgData name="OKAGAWA Tomohiro" userId="d74b3e309c52a267" providerId="LiveId" clId="{75BADE36-D135-44E3-A78F-3516F48BF828}" dt="2021-12-28T01:53:29.050" v="95" actId="14100"/>
          <ac:spMkLst>
            <pc:docMk/>
            <pc:sldMk cId="1049214770" sldId="258"/>
            <ac:spMk id="51" creationId="{20FE2F89-C457-463A-832F-F0816CC83C66}"/>
          </ac:spMkLst>
        </pc:spChg>
        <pc:graphicFrameChg chg="mod">
          <ac:chgData name="OKAGAWA Tomohiro" userId="d74b3e309c52a267" providerId="LiveId" clId="{75BADE36-D135-44E3-A78F-3516F48BF828}" dt="2021-12-28T01:52:00.405" v="54" actId="1035"/>
          <ac:graphicFrameMkLst>
            <pc:docMk/>
            <pc:sldMk cId="1049214770" sldId="258"/>
            <ac:graphicFrameMk id="28" creationId="{89D90997-1294-41F5-9F63-7E5FA8E45FB0}"/>
          </ac:graphicFrameMkLst>
        </pc:graphicFrameChg>
        <pc:graphicFrameChg chg="mod">
          <ac:chgData name="OKAGAWA Tomohiro" userId="d74b3e309c52a267" providerId="LiveId" clId="{75BADE36-D135-44E3-A78F-3516F48BF828}" dt="2021-12-28T01:52:00.405" v="54" actId="1035"/>
          <ac:graphicFrameMkLst>
            <pc:docMk/>
            <pc:sldMk cId="1049214770" sldId="258"/>
            <ac:graphicFrameMk id="29" creationId="{C3FDBCDA-F007-4832-876C-FC6C973E33D0}"/>
          </ac:graphicFrameMkLst>
        </pc:graphicFrameChg>
        <pc:graphicFrameChg chg="mod">
          <ac:chgData name="OKAGAWA Tomohiro" userId="d74b3e309c52a267" providerId="LiveId" clId="{75BADE36-D135-44E3-A78F-3516F48BF828}" dt="2021-12-28T01:51:27.036" v="38" actId="1035"/>
          <ac:graphicFrameMkLst>
            <pc:docMk/>
            <pc:sldMk cId="1049214770" sldId="258"/>
            <ac:graphicFrameMk id="30" creationId="{36364805-0C32-4061-8ED5-8440657D6BC8}"/>
          </ac:graphicFrameMkLst>
        </pc:graphicFrameChg>
        <pc:graphicFrameChg chg="mod">
          <ac:chgData name="OKAGAWA Tomohiro" userId="d74b3e309c52a267" providerId="LiveId" clId="{75BADE36-D135-44E3-A78F-3516F48BF828}" dt="2021-12-28T01:51:27.036" v="38" actId="1035"/>
          <ac:graphicFrameMkLst>
            <pc:docMk/>
            <pc:sldMk cId="1049214770" sldId="258"/>
            <ac:graphicFrameMk id="31" creationId="{E17D7C43-FE12-4072-B07F-E5350C93098C}"/>
          </ac:graphicFrameMkLst>
        </pc:graphicFrameChg>
        <pc:graphicFrameChg chg="mod">
          <ac:chgData name="OKAGAWA Tomohiro" userId="d74b3e309c52a267" providerId="LiveId" clId="{75BADE36-D135-44E3-A78F-3516F48BF828}" dt="2021-12-28T01:51:38.239" v="42" actId="1036"/>
          <ac:graphicFrameMkLst>
            <pc:docMk/>
            <pc:sldMk cId="1049214770" sldId="258"/>
            <ac:graphicFrameMk id="32" creationId="{95D1890E-7118-43C1-BE3A-F1140E6D1AC3}"/>
          </ac:graphicFrameMkLst>
        </pc:graphicFrameChg>
        <pc:graphicFrameChg chg="mod">
          <ac:chgData name="OKAGAWA Tomohiro" userId="d74b3e309c52a267" providerId="LiveId" clId="{75BADE36-D135-44E3-A78F-3516F48BF828}" dt="2021-12-28T01:51:38.239" v="42" actId="1036"/>
          <ac:graphicFrameMkLst>
            <pc:docMk/>
            <pc:sldMk cId="1049214770" sldId="258"/>
            <ac:graphicFrameMk id="33" creationId="{4149C239-CF2C-485B-BF44-3785E054F06B}"/>
          </ac:graphicFrameMkLst>
        </pc:graphicFrameChg>
        <pc:graphicFrameChg chg="mod">
          <ac:chgData name="OKAGAWA Tomohiro" userId="d74b3e309c52a267" providerId="LiveId" clId="{75BADE36-D135-44E3-A78F-3516F48BF828}" dt="2021-12-28T01:49:40.660" v="12"/>
          <ac:graphicFrameMkLst>
            <pc:docMk/>
            <pc:sldMk cId="1049214770" sldId="258"/>
            <ac:graphicFrameMk id="34" creationId="{062DDB20-E2D7-4D16-AD4F-919A2FFAE435}"/>
          </ac:graphicFrameMkLst>
        </pc:graphicFrameChg>
        <pc:graphicFrameChg chg="mod">
          <ac:chgData name="OKAGAWA Tomohiro" userId="d74b3e309c52a267" providerId="LiveId" clId="{75BADE36-D135-44E3-A78F-3516F48BF828}" dt="2021-12-28T01:49:43.530" v="13"/>
          <ac:graphicFrameMkLst>
            <pc:docMk/>
            <pc:sldMk cId="1049214770" sldId="258"/>
            <ac:graphicFrameMk id="35" creationId="{005F1329-1588-4275-BDAF-79CBDDFAAC74}"/>
          </ac:graphicFrameMkLst>
        </pc:graphicFrameChg>
        <pc:graphicFrameChg chg="mod">
          <ac:chgData name="OKAGAWA Tomohiro" userId="d74b3e309c52a267" providerId="LiveId" clId="{75BADE36-D135-44E3-A78F-3516F48BF828}" dt="2021-12-28T01:52:00.405" v="54" actId="1035"/>
          <ac:graphicFrameMkLst>
            <pc:docMk/>
            <pc:sldMk cId="1049214770" sldId="258"/>
            <ac:graphicFrameMk id="36" creationId="{852803FF-B353-469B-BFA8-CBF8E946285C}"/>
          </ac:graphicFrameMkLst>
        </pc:graphicFrameChg>
        <pc:graphicFrameChg chg="mod">
          <ac:chgData name="OKAGAWA Tomohiro" userId="d74b3e309c52a267" providerId="LiveId" clId="{75BADE36-D135-44E3-A78F-3516F48BF828}" dt="2021-12-28T01:51:27.036" v="38" actId="1035"/>
          <ac:graphicFrameMkLst>
            <pc:docMk/>
            <pc:sldMk cId="1049214770" sldId="258"/>
            <ac:graphicFrameMk id="37" creationId="{768778D3-03C8-42C2-B2D6-BE80D1D759DB}"/>
          </ac:graphicFrameMkLst>
        </pc:graphicFrameChg>
        <pc:graphicFrameChg chg="mod">
          <ac:chgData name="OKAGAWA Tomohiro" userId="d74b3e309c52a267" providerId="LiveId" clId="{75BADE36-D135-44E3-A78F-3516F48BF828}" dt="2021-12-28T01:51:38.239" v="42" actId="1036"/>
          <ac:graphicFrameMkLst>
            <pc:docMk/>
            <pc:sldMk cId="1049214770" sldId="258"/>
            <ac:graphicFrameMk id="38" creationId="{773C2F7C-5F1B-4EB8-85D4-F6B78F9E523E}"/>
          </ac:graphicFrameMkLst>
        </pc:graphicFrameChg>
        <pc:graphicFrameChg chg="mod">
          <ac:chgData name="OKAGAWA Tomohiro" userId="d74b3e309c52a267" providerId="LiveId" clId="{75BADE36-D135-44E3-A78F-3516F48BF828}" dt="2021-12-28T01:49:46.645" v="14"/>
          <ac:graphicFrameMkLst>
            <pc:docMk/>
            <pc:sldMk cId="1049214770" sldId="258"/>
            <ac:graphicFrameMk id="39" creationId="{00A8CE87-EB03-4E6E-8B74-FB97B57C7656}"/>
          </ac:graphicFrameMkLst>
        </pc:graphicFrameChg>
        <pc:graphicFrameChg chg="mod">
          <ac:chgData name="OKAGAWA Tomohiro" userId="d74b3e309c52a267" providerId="LiveId" clId="{75BADE36-D135-44E3-A78F-3516F48BF828}" dt="2021-12-28T01:52:00.405" v="54" actId="1035"/>
          <ac:graphicFrameMkLst>
            <pc:docMk/>
            <pc:sldMk cId="1049214770" sldId="258"/>
            <ac:graphicFrameMk id="40" creationId="{064EA0AA-C22F-49AE-9CEA-E0356656FF6F}"/>
          </ac:graphicFrameMkLst>
        </pc:graphicFrameChg>
        <pc:graphicFrameChg chg="mod">
          <ac:chgData name="OKAGAWA Tomohiro" userId="d74b3e309c52a267" providerId="LiveId" clId="{75BADE36-D135-44E3-A78F-3516F48BF828}" dt="2021-12-28T01:51:27.036" v="38" actId="1035"/>
          <ac:graphicFrameMkLst>
            <pc:docMk/>
            <pc:sldMk cId="1049214770" sldId="258"/>
            <ac:graphicFrameMk id="41" creationId="{F44D814E-1B36-4F4C-896D-050F941198C6}"/>
          </ac:graphicFrameMkLst>
        </pc:graphicFrameChg>
        <pc:graphicFrameChg chg="mod">
          <ac:chgData name="OKAGAWA Tomohiro" userId="d74b3e309c52a267" providerId="LiveId" clId="{75BADE36-D135-44E3-A78F-3516F48BF828}" dt="2021-12-28T01:51:38.239" v="42" actId="1036"/>
          <ac:graphicFrameMkLst>
            <pc:docMk/>
            <pc:sldMk cId="1049214770" sldId="258"/>
            <ac:graphicFrameMk id="42" creationId="{08DE84B1-09F9-44BE-AFED-D8B84AEA3580}"/>
          </ac:graphicFrameMkLst>
        </pc:graphicFrameChg>
        <pc:graphicFrameChg chg="mod">
          <ac:chgData name="OKAGAWA Tomohiro" userId="d74b3e309c52a267" providerId="LiveId" clId="{75BADE36-D135-44E3-A78F-3516F48BF828}" dt="2021-12-28T01:49:49.011" v="15"/>
          <ac:graphicFrameMkLst>
            <pc:docMk/>
            <pc:sldMk cId="1049214770" sldId="258"/>
            <ac:graphicFrameMk id="43" creationId="{098280B6-CF08-4590-8775-7050A3206417}"/>
          </ac:graphicFrameMkLst>
        </pc:graphicFrameChg>
        <pc:graphicFrameChg chg="mod">
          <ac:chgData name="OKAGAWA Tomohiro" userId="d74b3e309c52a267" providerId="LiveId" clId="{75BADE36-D135-44E3-A78F-3516F48BF828}" dt="2021-12-28T01:52:00.405" v="54" actId="1035"/>
          <ac:graphicFrameMkLst>
            <pc:docMk/>
            <pc:sldMk cId="1049214770" sldId="258"/>
            <ac:graphicFrameMk id="44" creationId="{835EE864-141E-4AA5-997F-45BF4B12A918}"/>
          </ac:graphicFrameMkLst>
        </pc:graphicFrameChg>
        <pc:graphicFrameChg chg="mod">
          <ac:chgData name="OKAGAWA Tomohiro" userId="d74b3e309c52a267" providerId="LiveId" clId="{75BADE36-D135-44E3-A78F-3516F48BF828}" dt="2021-12-28T01:51:38.239" v="42" actId="1036"/>
          <ac:graphicFrameMkLst>
            <pc:docMk/>
            <pc:sldMk cId="1049214770" sldId="258"/>
            <ac:graphicFrameMk id="46" creationId="{9F987B25-799C-48E5-900E-F7EF58B5E46A}"/>
          </ac:graphicFrameMkLst>
        </pc:graphicFrameChg>
        <pc:graphicFrameChg chg="mod">
          <ac:chgData name="OKAGAWA Tomohiro" userId="d74b3e309c52a267" providerId="LiveId" clId="{75BADE36-D135-44E3-A78F-3516F48BF828}" dt="2021-12-28T01:49:51.726" v="16"/>
          <ac:graphicFrameMkLst>
            <pc:docMk/>
            <pc:sldMk cId="1049214770" sldId="258"/>
            <ac:graphicFrameMk id="47" creationId="{9D4EB86F-164B-4135-A230-59F3E074F67F}"/>
          </ac:graphicFrameMkLst>
        </pc:graphicFrameChg>
        <pc:graphicFrameChg chg="mod">
          <ac:chgData name="OKAGAWA Tomohiro" userId="d74b3e309c52a267" providerId="LiveId" clId="{75BADE36-D135-44E3-A78F-3516F48BF828}" dt="2021-12-28T01:51:27.036" v="38" actId="1035"/>
          <ac:graphicFrameMkLst>
            <pc:docMk/>
            <pc:sldMk cId="1049214770" sldId="258"/>
            <ac:graphicFrameMk id="53" creationId="{E833D5E4-9383-4B5C-9543-3FAD1A76F9A5}"/>
          </ac:graphicFrameMkLst>
        </pc:graphicFrame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Infectious%20Diseases\&#21608;&#29987;&#26399;&#20813;&#30123;\BLV\&#22922;&#23072;&#29275;&#12469;&#12531;&#12503;&#12523;\&#21608;&#29987;&#26399;%20&#33256;&#24202;&#12469;&#12531;&#12503;&#12523;%20(&#27494;&#30000;&#20808;&#29983;&#12424;&#12426;)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F:\Infectious%20Diseases\&#21608;&#29987;&#26399;&#20813;&#30123;\BLV\&#22922;&#23072;&#29275;&#12469;&#12531;&#12503;&#12523;\&#21608;&#29987;&#26399;%20&#33256;&#24202;&#12469;&#12531;&#12503;&#12523;%20(&#31402;&#30000;&#20808;&#29983;&#12424;&#12426;)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F:\Infectious%20Diseases\&#21608;&#29987;&#26399;&#20813;&#30123;\BLV\&#22922;&#23072;&#29275;&#12469;&#12531;&#12503;&#12523;\&#21608;&#29987;&#26399;%20&#33256;&#24202;&#12469;&#12531;&#12503;&#12523;%20(&#31402;&#30000;&#20808;&#29983;&#12424;&#12426;)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F:\Infectious%20Diseases\&#21608;&#29987;&#26399;&#20813;&#30123;\BLV\&#22922;&#23072;&#29275;&#12469;&#12531;&#12503;&#12523;\&#21608;&#29987;&#26399;%20&#33256;&#24202;&#12469;&#12531;&#12503;&#12523;%20(&#27494;&#30000;&#20808;&#29983;&#12424;&#12426;)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E:\Infectious%20Diseases\&#21608;&#29987;&#26399;&#20813;&#30123;\BLV\&#22922;&#23072;&#29275;&#12469;&#12531;&#12503;&#12523;\&#21608;&#29987;&#26399;%20&#33256;&#24202;&#12469;&#12531;&#12503;&#12523;%20(&#39640;&#27211;&#20808;&#29983;&#12424;&#12426;)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file:///E:\Infectious%20Diseases\&#21608;&#29987;&#26399;&#20813;&#30123;\BLV\&#22922;&#23072;&#29275;&#12469;&#12531;&#12503;&#12523;\&#21608;&#29987;&#26399;%20&#33256;&#24202;&#12469;&#12531;&#12503;&#12523;%20(&#39640;&#27211;&#20808;&#29983;&#12424;&#12426;)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file:///E:\Infectious%20Diseases\&#21608;&#29987;&#26399;&#20813;&#30123;\BLV\&#22922;&#23072;&#29275;&#12469;&#12531;&#12503;&#12523;\&#21608;&#29987;&#26399;%20&#33256;&#24202;&#12469;&#12531;&#12503;&#12523;%20(&#39640;&#27211;&#20808;&#29983;&#12424;&#12426;)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oleObject" Target="file:///E:\Infectious%20Diseases\&#21608;&#29987;&#26399;&#20813;&#30123;\BLV\&#22922;&#23072;&#29275;&#12469;&#12531;&#12503;&#12523;\&#21608;&#29987;&#26399;%20&#33256;&#24202;&#12469;&#12531;&#12503;&#12523;%20(&#39640;&#27211;&#20808;&#29983;&#12424;&#12426;).xlsx" TargetMode="External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oleObject" Target="file:///D:\Infectious%20Diseases\&#21608;&#29987;&#26399;&#20813;&#30123;\BLV\&#22922;&#23072;&#29275;&#12469;&#12531;&#12503;&#12523;\&#21608;&#29987;&#26399;%20&#33256;&#24202;&#12469;&#12531;&#12503;&#12523;%20(&#27494;&#30000;&#20808;&#29983;&#12424;&#12426;).xlsx" TargetMode="External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oleObject" Target="file:///D:\Infectious%20Diseases\&#21608;&#29987;&#26399;&#20813;&#30123;\BLV\&#22922;&#23072;&#29275;&#12469;&#12531;&#12503;&#12523;\&#21608;&#29987;&#26399;%20&#33256;&#24202;&#12469;&#12531;&#12503;&#12523;%20(&#27494;&#30000;&#20808;&#29983;&#12424;&#12426;).xlsx" TargetMode="External"/><Relationship Id="rId2" Type="http://schemas.microsoft.com/office/2011/relationships/chartColorStyle" Target="colors17.xml"/><Relationship Id="rId1" Type="http://schemas.microsoft.com/office/2011/relationships/chartStyle" Target="style17.xml"/></Relationships>
</file>

<file path=ppt/charts/_rels/chart19.xml.rels><?xml version="1.0" encoding="UTF-8" standalone="yes"?>
<Relationships xmlns="http://schemas.openxmlformats.org/package/2006/relationships"><Relationship Id="rId3" Type="http://schemas.openxmlformats.org/officeDocument/2006/relationships/oleObject" Target="file:///F:\Infectious%20Diseases\&#21608;&#29987;&#26399;&#20813;&#30123;\BLV\&#22922;&#23072;&#29275;&#12469;&#12531;&#12503;&#12523;\&#21608;&#29987;&#26399;%20&#33256;&#24202;&#12469;&#12531;&#12503;&#12523;%20(&#27494;&#30000;&#20808;&#29983;&#12424;&#12426;).xlsx" TargetMode="External"/><Relationship Id="rId2" Type="http://schemas.microsoft.com/office/2011/relationships/chartColorStyle" Target="colors18.xml"/><Relationship Id="rId1" Type="http://schemas.microsoft.com/office/2011/relationships/chartStyle" Target="style18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Infectious%20Diseases\&#21608;&#29987;&#26399;&#20813;&#30123;\BLV\&#22922;&#23072;&#29275;&#12469;&#12531;&#12503;&#12523;\&#21608;&#29987;&#26399;%20&#33256;&#24202;&#12469;&#12531;&#12503;&#12523;%20(&#27494;&#30000;&#20808;&#29983;&#12424;&#12426;)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20.xml.rels><?xml version="1.0" encoding="UTF-8" standalone="yes"?>
<Relationships xmlns="http://schemas.openxmlformats.org/package/2006/relationships"><Relationship Id="rId3" Type="http://schemas.openxmlformats.org/officeDocument/2006/relationships/oleObject" Target="file:///F:\Infectious%20Diseases\&#21608;&#29987;&#26399;&#20813;&#30123;\BLV\&#22922;&#23072;&#29275;&#12469;&#12531;&#12503;&#12523;\&#21608;&#29987;&#26399;%20&#33256;&#24202;&#12469;&#12531;&#12503;&#12523;%20(&#27494;&#30000;&#20808;&#29983;&#12424;&#12426;).xlsx" TargetMode="External"/><Relationship Id="rId2" Type="http://schemas.microsoft.com/office/2011/relationships/chartColorStyle" Target="colors19.xml"/><Relationship Id="rId1" Type="http://schemas.microsoft.com/office/2011/relationships/chartStyle" Target="style19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F:\Infectious%20Diseases\&#21608;&#29987;&#26399;&#20813;&#30123;\BLV\&#22922;&#23072;&#29275;&#12469;&#12531;&#12503;&#12523;\&#21608;&#29987;&#26399;%20&#33256;&#24202;&#12469;&#12531;&#12503;&#12523;%20(&#27494;&#30000;&#20808;&#29983;&#12424;&#12426;)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D:\Infectious%20Diseases\&#21608;&#29987;&#26399;&#20813;&#30123;\BLV\&#22922;&#23072;&#29275;&#12469;&#12531;&#12503;&#12523;\&#21608;&#29987;&#26399;%20&#33256;&#24202;&#12469;&#12531;&#12503;&#12523;%20(&#31402;&#30000;&#20808;&#29983;&#12424;&#12426;)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D:\Infectious%20Diseases\&#21608;&#29987;&#26399;&#20813;&#30123;\BLV\&#22922;&#23072;&#29275;&#12469;&#12531;&#12503;&#12523;\&#21608;&#29987;&#26399;%20&#33256;&#24202;&#12469;&#12531;&#12503;&#12523;%20(&#31402;&#30000;&#20808;&#29983;&#12424;&#12426;)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F:\Infectious%20Diseases\&#21608;&#29987;&#26399;&#20813;&#30123;\BLV\&#22922;&#23072;&#29275;&#12469;&#12531;&#12503;&#12523;\&#21608;&#29987;&#26399;%20&#33256;&#24202;&#12469;&#12531;&#12503;&#12523;%20(&#31402;&#30000;&#20808;&#29983;&#12424;&#12426;)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F:\Infectious%20Diseases\&#21608;&#29987;&#26399;&#20813;&#30123;\BLV\&#22922;&#23072;&#29275;&#12469;&#12531;&#12503;&#12523;\&#21608;&#29987;&#26399;%20&#33256;&#24202;&#12469;&#12531;&#12503;&#12523;%20(&#31402;&#30000;&#20808;&#29983;&#12424;&#12426;)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D:\Infectious%20Diseases\&#21608;&#29987;&#26399;&#20813;&#30123;\BLV\&#22922;&#23072;&#29275;&#12469;&#12531;&#12503;&#12523;\&#21608;&#29987;&#26399;%20&#33256;&#24202;&#12469;&#12531;&#12503;&#12523;%20(&#31402;&#30000;&#20808;&#29983;&#12424;&#12426;).xlsx" TargetMode="Externa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D:\Infectious%20Diseases\&#21608;&#29987;&#26399;&#20813;&#30123;\BLV\&#22922;&#23072;&#29275;&#12469;&#12531;&#12503;&#12523;\&#21608;&#29987;&#26399;%20&#33256;&#24202;&#12469;&#12531;&#12503;&#12523;%20(&#31402;&#30000;&#20808;&#29983;&#12424;&#12426;)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471098650053443"/>
          <c:y val="8.3449417825321309E-2"/>
          <c:w val="0.65032810364065829"/>
          <c:h val="0.57364042980142749"/>
        </c:manualLayout>
      </c:layout>
      <c:lineChart>
        <c:grouping val="standard"/>
        <c:varyColors val="0"/>
        <c:ser>
          <c:idx val="0"/>
          <c:order val="0"/>
          <c:tx>
            <c:strRef>
              <c:f>'O4'!$F$4:$J$4</c:f>
              <c:strCache>
                <c:ptCount val="1"/>
                <c:pt idx="0">
                  <c:v>PGE2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dPt>
            <c:idx val="2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A471-4183-880A-49515D293D92}"/>
              </c:ext>
            </c:extLst>
          </c:dPt>
          <c:dPt>
            <c:idx val="3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A471-4183-880A-49515D293D92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'O4'!$J$6:$J$11</c:f>
                <c:numCache>
                  <c:formatCode>General</c:formatCode>
                  <c:ptCount val="6"/>
                  <c:pt idx="0">
                    <c:v>27.031978439365492</c:v>
                  </c:pt>
                  <c:pt idx="1">
                    <c:v>71.066506622969655</c:v>
                  </c:pt>
                  <c:pt idx="2">
                    <c:v>137.91776873727781</c:v>
                  </c:pt>
                  <c:pt idx="3">
                    <c:v>341.36748862746578</c:v>
                  </c:pt>
                  <c:pt idx="4">
                    <c:v>47.898048886990786</c:v>
                  </c:pt>
                  <c:pt idx="5">
                    <c:v>8.8616903127196149</c:v>
                  </c:pt>
                </c:numCache>
              </c:numRef>
            </c:plus>
            <c:minus>
              <c:numRef>
                <c:f>'O4'!$J$6:$J$11</c:f>
                <c:numCache>
                  <c:formatCode>General</c:formatCode>
                  <c:ptCount val="6"/>
                  <c:pt idx="0">
                    <c:v>27.031978439365492</c:v>
                  </c:pt>
                  <c:pt idx="1">
                    <c:v>71.066506622969655</c:v>
                  </c:pt>
                  <c:pt idx="2">
                    <c:v>137.91776873727781</c:v>
                  </c:pt>
                  <c:pt idx="3">
                    <c:v>341.36748862746578</c:v>
                  </c:pt>
                  <c:pt idx="4">
                    <c:v>47.898048886990786</c:v>
                  </c:pt>
                  <c:pt idx="5">
                    <c:v>8.861690312719614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O4'!$B$6:$B$11</c:f>
              <c:numCache>
                <c:formatCode>General</c:formatCode>
                <c:ptCount val="6"/>
                <c:pt idx="0">
                  <c:v>0</c:v>
                </c:pt>
                <c:pt idx="1">
                  <c:v>7</c:v>
                </c:pt>
                <c:pt idx="2">
                  <c:v>12</c:v>
                </c:pt>
                <c:pt idx="3">
                  <c:v>13</c:v>
                </c:pt>
                <c:pt idx="4">
                  <c:v>19</c:v>
                </c:pt>
                <c:pt idx="5">
                  <c:v>26</c:v>
                </c:pt>
              </c:numCache>
            </c:numRef>
          </c:cat>
          <c:val>
            <c:numRef>
              <c:f>'O4'!$I$6:$I$11</c:f>
              <c:numCache>
                <c:formatCode>General</c:formatCode>
                <c:ptCount val="6"/>
                <c:pt idx="0">
                  <c:v>295.8664248187273</c:v>
                </c:pt>
                <c:pt idx="1">
                  <c:v>627.3818432518525</c:v>
                </c:pt>
                <c:pt idx="2">
                  <c:v>2393.5111775948421</c:v>
                </c:pt>
                <c:pt idx="3">
                  <c:v>1871.2659157520072</c:v>
                </c:pt>
                <c:pt idx="4">
                  <c:v>534.43151254484553</c:v>
                </c:pt>
                <c:pt idx="5">
                  <c:v>313.7734887641798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A471-4183-880A-49515D293D9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43040896"/>
        <c:axId val="343010720"/>
      </c:lineChart>
      <c:dateAx>
        <c:axId val="34304089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</a:t>
                </a:r>
                <a:r>
                  <a:rPr lang="en-US" altLang="ja-JP" sz="600" b="0" i="0" u="none" strike="noStrike" baseline="0" dirty="0">
                    <a:effectLst/>
                  </a:rPr>
                  <a:t>(relative to calving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_ " sourceLinked="0"/>
        <c:majorTickMark val="out"/>
        <c:minorTickMark val="out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bg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43010720"/>
        <c:crosses val="autoZero"/>
        <c:auto val="0"/>
        <c:lblOffset val="100"/>
        <c:baseTimeUnit val="days"/>
        <c:majorUnit val="7"/>
        <c:majorTimeUnit val="days"/>
      </c:dateAx>
      <c:valAx>
        <c:axId val="343010720"/>
        <c:scaling>
          <c:orientation val="minMax"/>
          <c:max val="25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E</a:t>
                </a:r>
                <a:r>
                  <a:rPr lang="en-US" altLang="ja-JP" sz="600" baseline="-250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</a:t>
                </a:r>
                <a:r>
                  <a:rPr lang="en-US" altLang="ja-JP" sz="6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</a:t>
                </a: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mL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2.5160851692807074E-2"/>
              <c:y val="0.1776425734268598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_);[Red]\(#,##0\)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43040896"/>
        <c:crosses val="autoZero"/>
        <c:crossBetween val="between"/>
        <c:majorUnit val="5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dPt>
            <c:idx val="0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89E0-4B2B-A25E-82C776DE9964}"/>
              </c:ext>
            </c:extLst>
          </c:dPt>
          <c:dPt>
            <c:idx val="1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89E0-4B2B-A25E-82C776DE9964}"/>
              </c:ext>
            </c:extLst>
          </c:dPt>
          <c:dPt>
            <c:idx val="2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89E0-4B2B-A25E-82C776DE9964}"/>
              </c:ext>
            </c:extLst>
          </c:dPt>
          <c:dPt>
            <c:idx val="3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89E0-4B2B-A25E-82C776DE9964}"/>
              </c:ext>
            </c:extLst>
          </c:dPt>
          <c:dPt>
            <c:idx val="4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4-89E0-4B2B-A25E-82C776DE9964}"/>
              </c:ext>
            </c:extLst>
          </c:dPt>
          <c:dPt>
            <c:idx val="5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5-89E0-4B2B-A25E-82C776DE9964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'R2'!$T$16:$T$21</c:f>
                <c:numCache>
                  <c:formatCode>General</c:formatCode>
                  <c:ptCount val="6"/>
                  <c:pt idx="0">
                    <c:v>121.74885985046795</c:v>
                  </c:pt>
                  <c:pt idx="1">
                    <c:v>140.76868186101933</c:v>
                  </c:pt>
                  <c:pt idx="2">
                    <c:v>81.498249506763472</c:v>
                  </c:pt>
                  <c:pt idx="3">
                    <c:v>154.99752507916588</c:v>
                  </c:pt>
                  <c:pt idx="4">
                    <c:v>59.136104442774013</c:v>
                  </c:pt>
                  <c:pt idx="5">
                    <c:v>32.599026437405634</c:v>
                  </c:pt>
                </c:numCache>
              </c:numRef>
            </c:plus>
            <c:minus>
              <c:numRef>
                <c:f>'R2'!$T$16:$T$21</c:f>
                <c:numCache>
                  <c:formatCode>General</c:formatCode>
                  <c:ptCount val="6"/>
                  <c:pt idx="0">
                    <c:v>121.74885985046795</c:v>
                  </c:pt>
                  <c:pt idx="1">
                    <c:v>140.76868186101933</c:v>
                  </c:pt>
                  <c:pt idx="2">
                    <c:v>81.498249506763472</c:v>
                  </c:pt>
                  <c:pt idx="3">
                    <c:v>154.99752507916588</c:v>
                  </c:pt>
                  <c:pt idx="4">
                    <c:v>59.136104442774013</c:v>
                  </c:pt>
                  <c:pt idx="5">
                    <c:v>32.59902643740563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R2'!$B$6:$B$11</c:f>
              <c:numCache>
                <c:formatCode>General</c:formatCode>
                <c:ptCount val="6"/>
                <c:pt idx="0">
                  <c:v>0</c:v>
                </c:pt>
                <c:pt idx="1">
                  <c:v>7</c:v>
                </c:pt>
                <c:pt idx="2">
                  <c:v>16</c:v>
                </c:pt>
                <c:pt idx="3">
                  <c:v>17</c:v>
                </c:pt>
                <c:pt idx="4">
                  <c:v>23</c:v>
                </c:pt>
                <c:pt idx="5">
                  <c:v>30</c:v>
                </c:pt>
              </c:numCache>
            </c:numRef>
          </c:cat>
          <c:val>
            <c:numRef>
              <c:f>'R2'!$S$16:$S$21</c:f>
              <c:numCache>
                <c:formatCode>General</c:formatCode>
                <c:ptCount val="6"/>
                <c:pt idx="0">
                  <c:v>1564.7123333333336</c:v>
                </c:pt>
                <c:pt idx="1">
                  <c:v>1500.0656666666666</c:v>
                </c:pt>
                <c:pt idx="2">
                  <c:v>1131.386</c:v>
                </c:pt>
                <c:pt idx="3">
                  <c:v>1680.1859999999999</c:v>
                </c:pt>
                <c:pt idx="4">
                  <c:v>2034.6469999999999</c:v>
                </c:pt>
                <c:pt idx="5">
                  <c:v>2069.8870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89E0-4B2B-A25E-82C776DE996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43040896"/>
        <c:axId val="343010720"/>
      </c:lineChart>
      <c:dateAx>
        <c:axId val="34304089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</a:t>
                </a:r>
                <a:r>
                  <a:rPr lang="en-US" altLang="ja-JP" sz="600" b="0" i="0" u="none" strike="noStrike" baseline="0" dirty="0">
                    <a:effectLst/>
                  </a:rPr>
                  <a:t>(relative to calving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_ " sourceLinked="0"/>
        <c:majorTickMark val="out"/>
        <c:minorTickMark val="out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bg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43010720"/>
        <c:crosses val="autoZero"/>
        <c:auto val="0"/>
        <c:lblOffset val="100"/>
        <c:baseTimeUnit val="days"/>
        <c:majorUnit val="7"/>
        <c:majorTimeUnit val="days"/>
      </c:dateAx>
      <c:valAx>
        <c:axId val="34301072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FN-γ (</a:t>
                </a:r>
                <a:r>
                  <a:rPr lang="en-US" altLang="ja-JP" sz="6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</a:t>
                </a: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mL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7.6093679745543569E-2"/>
              <c:y val="0.1944904314981220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_);[Red]\(#,##0\)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43040896"/>
        <c:crossesAt val="0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dPt>
            <c:idx val="0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B1E1-401D-BF0E-9C6A1739D600}"/>
              </c:ext>
            </c:extLst>
          </c:dPt>
          <c:dPt>
            <c:idx val="1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B1E1-401D-BF0E-9C6A1739D600}"/>
              </c:ext>
            </c:extLst>
          </c:dPt>
          <c:dPt>
            <c:idx val="2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B1E1-401D-BF0E-9C6A1739D600}"/>
              </c:ext>
            </c:extLst>
          </c:dPt>
          <c:dPt>
            <c:idx val="3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B1E1-401D-BF0E-9C6A1739D600}"/>
              </c:ext>
            </c:extLst>
          </c:dPt>
          <c:dPt>
            <c:idx val="4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4-B1E1-401D-BF0E-9C6A1739D600}"/>
              </c:ext>
            </c:extLst>
          </c:dPt>
          <c:dPt>
            <c:idx val="5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5-B1E1-401D-BF0E-9C6A1739D600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'R2'!$O$6:$O$11</c:f>
                <c:numCache>
                  <c:formatCode>General</c:formatCode>
                  <c:ptCount val="6"/>
                  <c:pt idx="0">
                    <c:v>12.755664035578947</c:v>
                  </c:pt>
                  <c:pt idx="1">
                    <c:v>9.6220937239276996</c:v>
                  </c:pt>
                  <c:pt idx="2">
                    <c:v>38.990272096559998</c:v>
                  </c:pt>
                  <c:pt idx="3">
                    <c:v>5.1086195800524052</c:v>
                  </c:pt>
                  <c:pt idx="4">
                    <c:v>2.4994183832243717</c:v>
                  </c:pt>
                  <c:pt idx="5">
                    <c:v>3.9546400131807089</c:v>
                  </c:pt>
                </c:numCache>
              </c:numRef>
            </c:plus>
            <c:minus>
              <c:numRef>
                <c:f>'R2'!$O$6:$O$11</c:f>
                <c:numCache>
                  <c:formatCode>General</c:formatCode>
                  <c:ptCount val="6"/>
                  <c:pt idx="0">
                    <c:v>12.755664035578947</c:v>
                  </c:pt>
                  <c:pt idx="1">
                    <c:v>9.6220937239276996</c:v>
                  </c:pt>
                  <c:pt idx="2">
                    <c:v>38.990272096559998</c:v>
                  </c:pt>
                  <c:pt idx="3">
                    <c:v>5.1086195800524052</c:v>
                  </c:pt>
                  <c:pt idx="4">
                    <c:v>2.4994183832243717</c:v>
                  </c:pt>
                  <c:pt idx="5">
                    <c:v>3.954640013180708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R2'!$B$6:$B$11</c:f>
              <c:numCache>
                <c:formatCode>General</c:formatCode>
                <c:ptCount val="6"/>
                <c:pt idx="0">
                  <c:v>0</c:v>
                </c:pt>
                <c:pt idx="1">
                  <c:v>7</c:v>
                </c:pt>
                <c:pt idx="2">
                  <c:v>16</c:v>
                </c:pt>
                <c:pt idx="3">
                  <c:v>17</c:v>
                </c:pt>
                <c:pt idx="4">
                  <c:v>23</c:v>
                </c:pt>
                <c:pt idx="5">
                  <c:v>30</c:v>
                </c:pt>
              </c:numCache>
            </c:numRef>
          </c:cat>
          <c:val>
            <c:numRef>
              <c:f>'R2'!$N$6:$N$11</c:f>
              <c:numCache>
                <c:formatCode>General</c:formatCode>
                <c:ptCount val="6"/>
                <c:pt idx="0">
                  <c:v>126.04008662518849</c:v>
                </c:pt>
                <c:pt idx="1">
                  <c:v>218.9926705604372</c:v>
                </c:pt>
                <c:pt idx="2">
                  <c:v>268.48880055604133</c:v>
                </c:pt>
                <c:pt idx="3">
                  <c:v>29.231763340053618</c:v>
                </c:pt>
                <c:pt idx="4">
                  <c:v>15.818799331958155</c:v>
                </c:pt>
                <c:pt idx="5">
                  <c:v>25.62160265492581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B1E1-401D-BF0E-9C6A1739D60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43040896"/>
        <c:axId val="343010720"/>
      </c:lineChart>
      <c:dateAx>
        <c:axId val="34304089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</a:t>
                </a:r>
                <a:r>
                  <a:rPr lang="en-US" altLang="ja-JP" sz="600" b="0" i="0" u="none" strike="noStrike" baseline="0" dirty="0">
                    <a:effectLst/>
                  </a:rPr>
                  <a:t>(relative to calving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3324757073293696"/>
              <c:y val="0.7965864436306829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_ " sourceLinked="0"/>
        <c:majorTickMark val="out"/>
        <c:minorTickMark val="out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bg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43010720"/>
        <c:crosses val="autoZero"/>
        <c:auto val="0"/>
        <c:lblOffset val="100"/>
        <c:baseTimeUnit val="days"/>
        <c:majorUnit val="7"/>
        <c:majorTimeUnit val="days"/>
      </c:dateAx>
      <c:valAx>
        <c:axId val="34301072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stradiol (</a:t>
                </a:r>
                <a:r>
                  <a:rPr lang="en-US" altLang="ja-JP" sz="6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</a:t>
                </a: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mL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5.3803811689082902E-2"/>
              <c:y val="0.1615994289529902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_);[Red]\(#,##0\)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43040896"/>
        <c:crossesAt val="0"/>
        <c:crossBetween val="midCat"/>
        <c:majorUnit val="1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dPt>
            <c:idx val="0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DD79-4B7F-8BB7-57D5A5458490}"/>
              </c:ext>
            </c:extLst>
          </c:dPt>
          <c:dPt>
            <c:idx val="1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DD79-4B7F-8BB7-57D5A5458490}"/>
              </c:ext>
            </c:extLst>
          </c:dPt>
          <c:dPt>
            <c:idx val="2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DD79-4B7F-8BB7-57D5A5458490}"/>
              </c:ext>
            </c:extLst>
          </c:dPt>
          <c:dPt>
            <c:idx val="3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DD79-4B7F-8BB7-57D5A5458490}"/>
              </c:ext>
            </c:extLst>
          </c:dPt>
          <c:dPt>
            <c:idx val="4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4-DD79-4B7F-8BB7-57D5A5458490}"/>
              </c:ext>
            </c:extLst>
          </c:dPt>
          <c:dPt>
            <c:idx val="5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5-DD79-4B7F-8BB7-57D5A5458490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'O4'!$O$6:$O$11</c:f>
                <c:numCache>
                  <c:formatCode>General</c:formatCode>
                  <c:ptCount val="6"/>
                  <c:pt idx="0">
                    <c:v>26.428387727955649</c:v>
                  </c:pt>
                  <c:pt idx="1">
                    <c:v>75.423399173286867</c:v>
                  </c:pt>
                  <c:pt idx="2">
                    <c:v>62.922669227204565</c:v>
                  </c:pt>
                  <c:pt idx="3">
                    <c:v>38.83633408791377</c:v>
                  </c:pt>
                  <c:pt idx="4">
                    <c:v>10.131877648792576</c:v>
                  </c:pt>
                  <c:pt idx="5">
                    <c:v>9.3644634267418283</c:v>
                  </c:pt>
                </c:numCache>
              </c:numRef>
            </c:plus>
            <c:minus>
              <c:numRef>
                <c:f>'O4'!$O$6:$O$11</c:f>
                <c:numCache>
                  <c:formatCode>General</c:formatCode>
                  <c:ptCount val="6"/>
                  <c:pt idx="0">
                    <c:v>26.428387727955649</c:v>
                  </c:pt>
                  <c:pt idx="1">
                    <c:v>75.423399173286867</c:v>
                  </c:pt>
                  <c:pt idx="2">
                    <c:v>62.922669227204565</c:v>
                  </c:pt>
                  <c:pt idx="3">
                    <c:v>38.83633408791377</c:v>
                  </c:pt>
                  <c:pt idx="4">
                    <c:v>10.131877648792576</c:v>
                  </c:pt>
                  <c:pt idx="5">
                    <c:v>9.364463426741828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O4'!$B$6:$B$11</c:f>
              <c:numCache>
                <c:formatCode>General</c:formatCode>
                <c:ptCount val="6"/>
                <c:pt idx="0">
                  <c:v>0</c:v>
                </c:pt>
                <c:pt idx="1">
                  <c:v>7</c:v>
                </c:pt>
                <c:pt idx="2">
                  <c:v>12</c:v>
                </c:pt>
                <c:pt idx="3">
                  <c:v>13</c:v>
                </c:pt>
                <c:pt idx="4">
                  <c:v>19</c:v>
                </c:pt>
                <c:pt idx="5">
                  <c:v>26</c:v>
                </c:pt>
              </c:numCache>
            </c:numRef>
          </c:cat>
          <c:val>
            <c:numRef>
              <c:f>'O4'!$N$6:$N$11</c:f>
              <c:numCache>
                <c:formatCode>General</c:formatCode>
                <c:ptCount val="6"/>
                <c:pt idx="0">
                  <c:v>559.89860239025984</c:v>
                </c:pt>
                <c:pt idx="1">
                  <c:v>827.89952598994671</c:v>
                </c:pt>
                <c:pt idx="2">
                  <c:v>1345.776975327225</c:v>
                </c:pt>
                <c:pt idx="3">
                  <c:v>301.72114600597541</c:v>
                </c:pt>
                <c:pt idx="4">
                  <c:v>122.23878973257007</c:v>
                </c:pt>
                <c:pt idx="5">
                  <c:v>111.0719255038454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DD79-4B7F-8BB7-57D5A545849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43040896"/>
        <c:axId val="343010720"/>
      </c:lineChart>
      <c:dateAx>
        <c:axId val="34304089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</a:t>
                </a:r>
                <a:r>
                  <a:rPr lang="en-US" altLang="ja-JP" sz="600" b="0" i="0" u="none" strike="noStrike" baseline="0" dirty="0">
                    <a:effectLst/>
                  </a:rPr>
                  <a:t>(relative to calving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_ " sourceLinked="0"/>
        <c:majorTickMark val="out"/>
        <c:minorTickMark val="out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bg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43010720"/>
        <c:crosses val="autoZero"/>
        <c:auto val="0"/>
        <c:lblOffset val="100"/>
        <c:baseTimeUnit val="days"/>
        <c:majorUnit val="7"/>
        <c:majorTimeUnit val="days"/>
      </c:dateAx>
      <c:valAx>
        <c:axId val="34301072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stradiol (</a:t>
                </a:r>
                <a:r>
                  <a:rPr lang="en-US" altLang="ja-JP" sz="6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</a:t>
                </a: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mL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9.1272835967458527E-2"/>
              <c:y val="0.1733284243767649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_);[Red]\(#,##0\)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43040896"/>
        <c:crossesAt val="0"/>
        <c:crossBetween val="midCat"/>
        <c:majorUnit val="4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H1'!$J$6:$J$11</c:f>
                <c:numCache>
                  <c:formatCode>General</c:formatCode>
                  <c:ptCount val="6"/>
                  <c:pt idx="0">
                    <c:v>22.851200308858079</c:v>
                  </c:pt>
                  <c:pt idx="1">
                    <c:v>48.006148820027633</c:v>
                  </c:pt>
                  <c:pt idx="2">
                    <c:v>49.868745199985199</c:v>
                  </c:pt>
                  <c:pt idx="3">
                    <c:v>95.568408810949279</c:v>
                  </c:pt>
                  <c:pt idx="4">
                    <c:v>20.812930960537127</c:v>
                  </c:pt>
                  <c:pt idx="5">
                    <c:v>31.521799336254794</c:v>
                  </c:pt>
                </c:numCache>
              </c:numRef>
            </c:plus>
            <c:minus>
              <c:numRef>
                <c:f>'H1'!$J$6:$J$11</c:f>
                <c:numCache>
                  <c:formatCode>General</c:formatCode>
                  <c:ptCount val="6"/>
                  <c:pt idx="0">
                    <c:v>22.851200308858079</c:v>
                  </c:pt>
                  <c:pt idx="1">
                    <c:v>48.006148820027633</c:v>
                  </c:pt>
                  <c:pt idx="2">
                    <c:v>49.868745199985199</c:v>
                  </c:pt>
                  <c:pt idx="3">
                    <c:v>95.568408810949279</c:v>
                  </c:pt>
                  <c:pt idx="4">
                    <c:v>20.812930960537127</c:v>
                  </c:pt>
                  <c:pt idx="5">
                    <c:v>31.52179933625479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H1'!$A$6:$A$11</c:f>
              <c:numCache>
                <c:formatCode>General</c:formatCode>
                <c:ptCount val="6"/>
                <c:pt idx="0">
                  <c:v>0</c:v>
                </c:pt>
                <c:pt idx="1">
                  <c:v>7</c:v>
                </c:pt>
                <c:pt idx="2">
                  <c:v>16</c:v>
                </c:pt>
                <c:pt idx="3">
                  <c:v>17</c:v>
                </c:pt>
                <c:pt idx="4">
                  <c:v>23</c:v>
                </c:pt>
                <c:pt idx="5">
                  <c:v>30</c:v>
                </c:pt>
              </c:numCache>
            </c:numRef>
          </c:cat>
          <c:val>
            <c:numRef>
              <c:f>'H1'!$I$6:$I$11</c:f>
              <c:numCache>
                <c:formatCode>General</c:formatCode>
                <c:ptCount val="6"/>
                <c:pt idx="0">
                  <c:v>524.75333333333333</c:v>
                </c:pt>
                <c:pt idx="1">
                  <c:v>684.96603947051506</c:v>
                </c:pt>
                <c:pt idx="2">
                  <c:v>1098.6572959340706</c:v>
                </c:pt>
                <c:pt idx="3">
                  <c:v>1963.0015992837627</c:v>
                </c:pt>
                <c:pt idx="4">
                  <c:v>159.78475336905146</c:v>
                </c:pt>
                <c:pt idx="5">
                  <c:v>332.1644634883623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F64-4939-8AA8-F470E3478AC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88332928"/>
        <c:axId val="488332272"/>
      </c:lineChart>
      <c:dateAx>
        <c:axId val="48833292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</a:t>
                </a:r>
                <a:r>
                  <a:rPr lang="en-US" altLang="ja-JP" sz="600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relative to calving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0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bg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88332272"/>
        <c:crosses val="autoZero"/>
        <c:auto val="0"/>
        <c:lblOffset val="100"/>
        <c:baseTimeUnit val="days"/>
        <c:majorUnit val="1"/>
        <c:majorTimeUnit val="days"/>
      </c:dateAx>
      <c:valAx>
        <c:axId val="48833227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E</a:t>
                </a:r>
                <a:r>
                  <a:rPr lang="en-US" altLang="ja-JP" sz="600" baseline="-250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r>
                  <a:rPr lang="en-US" altLang="ja-JP" sz="600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</a:t>
                </a:r>
                <a:r>
                  <a:rPr lang="en-US" altLang="ja-JP" sz="600" baseline="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</a:t>
                </a:r>
                <a:r>
                  <a:rPr lang="en-US" altLang="ja-JP" sz="600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mL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7.2287771356625175E-2"/>
              <c:y val="0.2072334685319675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_);[Red]\(#,##0\)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88332928"/>
        <c:crossesAt val="0"/>
        <c:crossBetween val="midCat"/>
      </c:valAx>
      <c:spPr>
        <a:noFill/>
        <a:ln w="25400"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H1'!$T$16:$T$21</c:f>
                <c:numCache>
                  <c:formatCode>General</c:formatCode>
                  <c:ptCount val="6"/>
                  <c:pt idx="0">
                    <c:v>117.06697911879334</c:v>
                  </c:pt>
                  <c:pt idx="1">
                    <c:v>77.548086634466131</c:v>
                  </c:pt>
                  <c:pt idx="2">
                    <c:v>50.834455814929363</c:v>
                  </c:pt>
                  <c:pt idx="3">
                    <c:v>90.594477213324396</c:v>
                  </c:pt>
                  <c:pt idx="4">
                    <c:v>87.198137101660649</c:v>
                  </c:pt>
                  <c:pt idx="5">
                    <c:v>7.7773744641463773</c:v>
                  </c:pt>
                </c:numCache>
              </c:numRef>
            </c:plus>
            <c:minus>
              <c:numRef>
                <c:f>'H1'!$T$16:$T$21</c:f>
                <c:numCache>
                  <c:formatCode>General</c:formatCode>
                  <c:ptCount val="6"/>
                  <c:pt idx="0">
                    <c:v>117.06697911879334</c:v>
                  </c:pt>
                  <c:pt idx="1">
                    <c:v>77.548086634466131</c:v>
                  </c:pt>
                  <c:pt idx="2">
                    <c:v>50.834455814929363</c:v>
                  </c:pt>
                  <c:pt idx="3">
                    <c:v>90.594477213324396</c:v>
                  </c:pt>
                  <c:pt idx="4">
                    <c:v>87.198137101660649</c:v>
                  </c:pt>
                  <c:pt idx="5">
                    <c:v>7.777374464146377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H1'!$A$16:$A$21</c:f>
              <c:numCache>
                <c:formatCode>General</c:formatCode>
                <c:ptCount val="6"/>
                <c:pt idx="0">
                  <c:v>0</c:v>
                </c:pt>
                <c:pt idx="1">
                  <c:v>7</c:v>
                </c:pt>
                <c:pt idx="2">
                  <c:v>16</c:v>
                </c:pt>
                <c:pt idx="3">
                  <c:v>17</c:v>
                </c:pt>
                <c:pt idx="4">
                  <c:v>23</c:v>
                </c:pt>
                <c:pt idx="5">
                  <c:v>30</c:v>
                </c:pt>
              </c:numCache>
            </c:numRef>
          </c:cat>
          <c:val>
            <c:numRef>
              <c:f>'H1'!$S$16:$S$21</c:f>
              <c:numCache>
                <c:formatCode>General</c:formatCode>
                <c:ptCount val="6"/>
                <c:pt idx="0">
                  <c:v>2288.5499999999997</c:v>
                </c:pt>
                <c:pt idx="1">
                  <c:v>1919.75</c:v>
                </c:pt>
                <c:pt idx="2">
                  <c:v>1363.8879999999999</c:v>
                </c:pt>
                <c:pt idx="3">
                  <c:v>1258.0243333333335</c:v>
                </c:pt>
                <c:pt idx="4">
                  <c:v>1603.8239999999998</c:v>
                </c:pt>
                <c:pt idx="5">
                  <c:v>1750.096666666666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08D2-4C36-AF55-4436F616A78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88332928"/>
        <c:axId val="488332272"/>
      </c:lineChart>
      <c:dateAx>
        <c:axId val="48833292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</a:t>
                </a:r>
                <a:r>
                  <a:rPr lang="en-US" altLang="ja-JP" sz="600" baseline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relative to calving)</a:t>
                </a:r>
                <a:endParaRPr lang="ja-JP" altLang="en-US" sz="60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0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bg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88332272"/>
        <c:crosses val="autoZero"/>
        <c:auto val="0"/>
        <c:lblOffset val="100"/>
        <c:baseTimeUnit val="days"/>
        <c:majorUnit val="1"/>
        <c:majorTimeUnit val="days"/>
      </c:dateAx>
      <c:valAx>
        <c:axId val="48833227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FN-γ (</a:t>
                </a:r>
                <a:r>
                  <a:rPr lang="en-US" altLang="ja-JP" sz="600" baseline="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</a:t>
                </a:r>
                <a:r>
                  <a:rPr lang="en-US" altLang="ja-JP" sz="600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mL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7.3044338488614857E-2"/>
              <c:y val="0.1832042583362306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_);[Red]\(#,##0\)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88332928"/>
        <c:crossesAt val="0"/>
        <c:crossBetween val="midCat"/>
      </c:valAx>
      <c:spPr>
        <a:noFill/>
        <a:ln w="25400"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H1'!$O$16:$O$21</c:f>
                <c:numCache>
                  <c:formatCode>General</c:formatCode>
                  <c:ptCount val="6"/>
                  <c:pt idx="0">
                    <c:v>35.443977705042563</c:v>
                  </c:pt>
                  <c:pt idx="1">
                    <c:v>11.7833366336629</c:v>
                  </c:pt>
                  <c:pt idx="2">
                    <c:v>0.50648746831047586</c:v>
                  </c:pt>
                  <c:pt idx="3">
                    <c:v>5.2191251076103624</c:v>
                  </c:pt>
                  <c:pt idx="4">
                    <c:v>8.2054094487857352</c:v>
                  </c:pt>
                  <c:pt idx="5">
                    <c:v>9.3214377407970463</c:v>
                  </c:pt>
                </c:numCache>
              </c:numRef>
            </c:plus>
            <c:minus>
              <c:numRef>
                <c:f>'H1'!$O$16:$O$21</c:f>
                <c:numCache>
                  <c:formatCode>General</c:formatCode>
                  <c:ptCount val="6"/>
                  <c:pt idx="0">
                    <c:v>35.443977705042563</c:v>
                  </c:pt>
                  <c:pt idx="1">
                    <c:v>11.7833366336629</c:v>
                  </c:pt>
                  <c:pt idx="2">
                    <c:v>0.50648746831047586</c:v>
                  </c:pt>
                  <c:pt idx="3">
                    <c:v>5.2191251076103624</c:v>
                  </c:pt>
                  <c:pt idx="4">
                    <c:v>8.2054094487857352</c:v>
                  </c:pt>
                  <c:pt idx="5">
                    <c:v>9.321437740797046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H1'!$A$16:$A$21</c:f>
              <c:numCache>
                <c:formatCode>General</c:formatCode>
                <c:ptCount val="6"/>
                <c:pt idx="0">
                  <c:v>0</c:v>
                </c:pt>
                <c:pt idx="1">
                  <c:v>7</c:v>
                </c:pt>
                <c:pt idx="2">
                  <c:v>16</c:v>
                </c:pt>
                <c:pt idx="3">
                  <c:v>17</c:v>
                </c:pt>
                <c:pt idx="4">
                  <c:v>23</c:v>
                </c:pt>
                <c:pt idx="5">
                  <c:v>30</c:v>
                </c:pt>
              </c:numCache>
            </c:numRef>
          </c:cat>
          <c:val>
            <c:numRef>
              <c:f>'H1'!$N$16:$N$21</c:f>
              <c:numCache>
                <c:formatCode>General</c:formatCode>
                <c:ptCount val="6"/>
                <c:pt idx="0">
                  <c:v>368.2833333333333</c:v>
                </c:pt>
                <c:pt idx="1">
                  <c:v>134.33666666666667</c:v>
                </c:pt>
                <c:pt idx="2">
                  <c:v>11.796666666666667</c:v>
                </c:pt>
                <c:pt idx="3">
                  <c:v>24.188333333333333</c:v>
                </c:pt>
                <c:pt idx="4">
                  <c:v>121.77233333333334</c:v>
                </c:pt>
                <c:pt idx="5">
                  <c:v>152.3383333333333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FE6-490A-AACF-093F181A807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88332928"/>
        <c:axId val="488332272"/>
      </c:lineChart>
      <c:dateAx>
        <c:axId val="48833292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</a:t>
                </a:r>
                <a:r>
                  <a:rPr lang="en-US" altLang="ja-JP" sz="600" baseline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relative to calving)</a:t>
                </a:r>
                <a:endParaRPr lang="ja-JP" altLang="en-US" sz="60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0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bg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88332272"/>
        <c:crosses val="autoZero"/>
        <c:auto val="0"/>
        <c:lblOffset val="100"/>
        <c:baseTimeUnit val="days"/>
        <c:majorUnit val="1"/>
        <c:majorTimeUnit val="days"/>
      </c:dateAx>
      <c:valAx>
        <c:axId val="48833227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FN-γ (</a:t>
                </a:r>
                <a:r>
                  <a:rPr lang="en-US" altLang="ja-JP" sz="600" baseline="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</a:t>
                </a:r>
                <a:r>
                  <a:rPr lang="en-US" altLang="ja-JP" sz="600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mL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6.686689684947518E-2"/>
              <c:y val="0.2121259738514758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_);[Red]\(#,##0\)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88332928"/>
        <c:crossesAt val="0"/>
        <c:crossBetween val="midCat"/>
        <c:majorUnit val="100"/>
      </c:valAx>
      <c:spPr>
        <a:noFill/>
        <a:ln w="25400"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H1'!$O$6:$O$11</c:f>
                <c:numCache>
                  <c:formatCode>General</c:formatCode>
                  <c:ptCount val="6"/>
                  <c:pt idx="0">
                    <c:v>16.726550418089346</c:v>
                  </c:pt>
                  <c:pt idx="1">
                    <c:v>23.166355155019183</c:v>
                  </c:pt>
                  <c:pt idx="2">
                    <c:v>37.62606218508062</c:v>
                  </c:pt>
                  <c:pt idx="3">
                    <c:v>3.9463601257748873</c:v>
                  </c:pt>
                  <c:pt idx="4">
                    <c:v>1.3675769803583224</c:v>
                  </c:pt>
                  <c:pt idx="5">
                    <c:v>1.1264459919816847</c:v>
                  </c:pt>
                </c:numCache>
              </c:numRef>
            </c:plus>
            <c:minus>
              <c:numRef>
                <c:f>'H1'!$O$6:$O$11</c:f>
                <c:numCache>
                  <c:formatCode>General</c:formatCode>
                  <c:ptCount val="6"/>
                  <c:pt idx="0">
                    <c:v>16.726550418089346</c:v>
                  </c:pt>
                  <c:pt idx="1">
                    <c:v>23.166355155019183</c:v>
                  </c:pt>
                  <c:pt idx="2">
                    <c:v>37.62606218508062</c:v>
                  </c:pt>
                  <c:pt idx="3">
                    <c:v>3.9463601257748873</c:v>
                  </c:pt>
                  <c:pt idx="4">
                    <c:v>1.3675769803583224</c:v>
                  </c:pt>
                  <c:pt idx="5">
                    <c:v>1.126445991981684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H1'!$A$6:$A$11</c:f>
              <c:numCache>
                <c:formatCode>General</c:formatCode>
                <c:ptCount val="6"/>
                <c:pt idx="0">
                  <c:v>0</c:v>
                </c:pt>
                <c:pt idx="1">
                  <c:v>7</c:v>
                </c:pt>
                <c:pt idx="2">
                  <c:v>16</c:v>
                </c:pt>
                <c:pt idx="3">
                  <c:v>17</c:v>
                </c:pt>
                <c:pt idx="4">
                  <c:v>23</c:v>
                </c:pt>
                <c:pt idx="5">
                  <c:v>30</c:v>
                </c:pt>
              </c:numCache>
            </c:numRef>
          </c:cat>
          <c:val>
            <c:numRef>
              <c:f>'H1'!$N$6:$N$11</c:f>
              <c:numCache>
                <c:formatCode>General</c:formatCode>
                <c:ptCount val="6"/>
                <c:pt idx="0">
                  <c:v>157.03666666666666</c:v>
                </c:pt>
                <c:pt idx="1">
                  <c:v>287.19353351556305</c:v>
                </c:pt>
                <c:pt idx="2">
                  <c:v>763.23333333333323</c:v>
                </c:pt>
                <c:pt idx="3">
                  <c:v>76.758483835062052</c:v>
                </c:pt>
                <c:pt idx="4">
                  <c:v>7.3589253488657418</c:v>
                </c:pt>
                <c:pt idx="5">
                  <c:v>3.474209780797275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641-4377-B0E3-2A9C5FAB85F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88332928"/>
        <c:axId val="488332272"/>
      </c:lineChart>
      <c:dateAx>
        <c:axId val="48833292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</a:t>
                </a:r>
                <a:r>
                  <a:rPr lang="en-US" altLang="ja-JP" sz="600" baseline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relative to calving)</a:t>
                </a:r>
                <a:endParaRPr lang="ja-JP" altLang="en-US" sz="60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0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bg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88332272"/>
        <c:crosses val="autoZero"/>
        <c:auto val="0"/>
        <c:lblOffset val="100"/>
        <c:baseTimeUnit val="days"/>
        <c:majorUnit val="1"/>
        <c:majorTimeUnit val="days"/>
      </c:dateAx>
      <c:valAx>
        <c:axId val="48833227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stradiol</a:t>
                </a:r>
                <a:r>
                  <a:rPr lang="en-US" altLang="ja-JP" sz="600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</a:t>
                </a:r>
                <a:r>
                  <a:rPr lang="en-US" altLang="ja-JP" sz="600" baseline="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</a:t>
                </a:r>
                <a:r>
                  <a:rPr lang="en-US" altLang="ja-JP" sz="600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mL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5.9841972429106993E-2"/>
              <c:y val="0.1670890073500943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_);[Red]\(#,##0\)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88332928"/>
        <c:crossesAt val="0"/>
        <c:crossBetween val="midCat"/>
        <c:majorUnit val="300"/>
      </c:valAx>
      <c:spPr>
        <a:noFill/>
        <a:ln w="25400"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8648671495032257"/>
          <c:y val="0.10561522189780802"/>
          <c:w val="0.62916280487988963"/>
          <c:h val="0.62356073744675766"/>
        </c:manualLayout>
      </c:layout>
      <c:lineChart>
        <c:grouping val="standard"/>
        <c:varyColors val="0"/>
        <c:ser>
          <c:idx val="0"/>
          <c:order val="0"/>
          <c:tx>
            <c:strRef>
              <c:f>'O1'!$F$4:$J$4</c:f>
              <c:strCache>
                <c:ptCount val="1"/>
                <c:pt idx="0">
                  <c:v>PGE2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dPt>
            <c:idx val="2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D959-4EF3-9D33-2EF99B976D08}"/>
              </c:ext>
            </c:extLst>
          </c:dPt>
          <c:dPt>
            <c:idx val="4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D959-4EF3-9D33-2EF99B976D08}"/>
              </c:ext>
            </c:extLst>
          </c:dPt>
          <c:dPt>
            <c:idx val="5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D959-4EF3-9D33-2EF99B976D08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'O1'!$J$6:$J$11</c:f>
                <c:numCache>
                  <c:formatCode>General</c:formatCode>
                  <c:ptCount val="6"/>
                  <c:pt idx="0">
                    <c:v>32.800337735388581</c:v>
                  </c:pt>
                  <c:pt idx="1">
                    <c:v>30.832082730330544</c:v>
                  </c:pt>
                  <c:pt idx="2">
                    <c:v>0</c:v>
                  </c:pt>
                  <c:pt idx="3">
                    <c:v>55.062286252166224</c:v>
                  </c:pt>
                  <c:pt idx="4">
                    <c:v>12.469200096151615</c:v>
                  </c:pt>
                  <c:pt idx="5">
                    <c:v>12.125457393261492</c:v>
                  </c:pt>
                </c:numCache>
              </c:numRef>
            </c:plus>
            <c:minus>
              <c:numRef>
                <c:f>'O1'!$J$6:$J$11</c:f>
                <c:numCache>
                  <c:formatCode>General</c:formatCode>
                  <c:ptCount val="6"/>
                  <c:pt idx="0">
                    <c:v>32.800337735388581</c:v>
                  </c:pt>
                  <c:pt idx="1">
                    <c:v>30.832082730330544</c:v>
                  </c:pt>
                  <c:pt idx="2">
                    <c:v>0</c:v>
                  </c:pt>
                  <c:pt idx="3">
                    <c:v>55.062286252166224</c:v>
                  </c:pt>
                  <c:pt idx="4">
                    <c:v>12.469200096151615</c:v>
                  </c:pt>
                  <c:pt idx="5">
                    <c:v>12.12545739326149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O1'!$B$6:$B$11</c:f>
              <c:numCache>
                <c:formatCode>General</c:formatCode>
                <c:ptCount val="6"/>
                <c:pt idx="0">
                  <c:v>0</c:v>
                </c:pt>
                <c:pt idx="1">
                  <c:v>7</c:v>
                </c:pt>
                <c:pt idx="2">
                  <c:v>14</c:v>
                </c:pt>
                <c:pt idx="3">
                  <c:v>15</c:v>
                </c:pt>
                <c:pt idx="4">
                  <c:v>21</c:v>
                </c:pt>
                <c:pt idx="5">
                  <c:v>28</c:v>
                </c:pt>
              </c:numCache>
            </c:numRef>
          </c:cat>
          <c:val>
            <c:numRef>
              <c:f>'O1'!$I$6:$I$11</c:f>
              <c:numCache>
                <c:formatCode>General</c:formatCode>
                <c:ptCount val="6"/>
                <c:pt idx="0">
                  <c:v>358.72333333333336</c:v>
                </c:pt>
                <c:pt idx="1">
                  <c:v>405.91654807272306</c:v>
                </c:pt>
                <c:pt idx="2">
                  <c:v>1387.6746755244501</c:v>
                </c:pt>
                <c:pt idx="3">
                  <c:v>423.44800121023673</c:v>
                </c:pt>
                <c:pt idx="4">
                  <c:v>98.72604819323692</c:v>
                </c:pt>
                <c:pt idx="5">
                  <c:v>449.5454559021260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D959-4EF3-9D33-2EF99B976D0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43040896"/>
        <c:axId val="343010720"/>
      </c:lineChart>
      <c:dateAx>
        <c:axId val="34304089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</a:t>
                </a:r>
                <a:r>
                  <a:rPr lang="en-US" altLang="ja-JP" sz="600" b="0" i="0" u="none" strike="noStrike" baseline="0" dirty="0">
                    <a:effectLst/>
                  </a:rPr>
                  <a:t>(relative to calving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36495620960218822"/>
              <c:y val="0.8141353538072131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_ " sourceLinked="0"/>
        <c:majorTickMark val="out"/>
        <c:minorTickMark val="out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400" b="0" i="0" u="none" strike="noStrike" kern="1200" baseline="0">
                <a:solidFill>
                  <a:schemeClr val="bg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43010720"/>
        <c:crosses val="autoZero"/>
        <c:auto val="0"/>
        <c:lblOffset val="100"/>
        <c:baseTimeUnit val="days"/>
        <c:majorUnit val="7"/>
        <c:majorTimeUnit val="days"/>
      </c:dateAx>
      <c:valAx>
        <c:axId val="34301072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E</a:t>
                </a:r>
                <a:r>
                  <a:rPr lang="en-US" altLang="ja-JP" sz="600" baseline="-250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</a:t>
                </a:r>
                <a:r>
                  <a:rPr lang="en-US" altLang="ja-JP" sz="6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</a:t>
                </a: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mL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7.2854783734908835E-2"/>
              <c:y val="0.2058385485731738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_);[Red]\(#,##0\)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43040896"/>
        <c:crosses val="autoZero"/>
        <c:crossBetween val="between"/>
        <c:majorUnit val="4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v>gp51</c:v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dPt>
            <c:idx val="2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0DE6-4779-ADC9-C6FE8DA876F7}"/>
              </c:ext>
            </c:extLst>
          </c:dPt>
          <c:dPt>
            <c:idx val="3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0DE6-4779-ADC9-C6FE8DA876F7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'O1'!$O$16:$O$21</c:f>
                <c:numCache>
                  <c:formatCode>General</c:formatCode>
                  <c:ptCount val="6"/>
                  <c:pt idx="0">
                    <c:v>1.7656626706895966</c:v>
                  </c:pt>
                  <c:pt idx="1">
                    <c:v>1.5663220188283937</c:v>
                  </c:pt>
                  <c:pt idx="2">
                    <c:v>0.26770630673681683</c:v>
                  </c:pt>
                  <c:pt idx="3">
                    <c:v>0.59992017987580804</c:v>
                  </c:pt>
                  <c:pt idx="4">
                    <c:v>1.2544941432926551</c:v>
                  </c:pt>
                  <c:pt idx="5">
                    <c:v>1.1916166423066683</c:v>
                  </c:pt>
                </c:numCache>
              </c:numRef>
            </c:plus>
            <c:minus>
              <c:numRef>
                <c:f>'O1'!$O$16:$O$21</c:f>
                <c:numCache>
                  <c:formatCode>General</c:formatCode>
                  <c:ptCount val="6"/>
                  <c:pt idx="0">
                    <c:v>1.7656626706895966</c:v>
                  </c:pt>
                  <c:pt idx="1">
                    <c:v>1.5663220188283937</c:v>
                  </c:pt>
                  <c:pt idx="2">
                    <c:v>0.26770630673681683</c:v>
                  </c:pt>
                  <c:pt idx="3">
                    <c:v>0.59992017987580804</c:v>
                  </c:pt>
                  <c:pt idx="4">
                    <c:v>1.2544941432926551</c:v>
                  </c:pt>
                  <c:pt idx="5">
                    <c:v>1.191616642306668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O1'!$B$16:$B$21</c:f>
              <c:numCache>
                <c:formatCode>General</c:formatCode>
                <c:ptCount val="6"/>
                <c:pt idx="0">
                  <c:v>0</c:v>
                </c:pt>
                <c:pt idx="1">
                  <c:v>7</c:v>
                </c:pt>
                <c:pt idx="2">
                  <c:v>14</c:v>
                </c:pt>
                <c:pt idx="3">
                  <c:v>15</c:v>
                </c:pt>
                <c:pt idx="4">
                  <c:v>21</c:v>
                </c:pt>
                <c:pt idx="5">
                  <c:v>28</c:v>
                </c:pt>
              </c:numCache>
            </c:numRef>
          </c:cat>
          <c:val>
            <c:numRef>
              <c:f>'O1'!$N$16:$N$21</c:f>
              <c:numCache>
                <c:formatCode>General</c:formatCode>
                <c:ptCount val="6"/>
                <c:pt idx="0">
                  <c:v>13.460999999999999</c:v>
                </c:pt>
                <c:pt idx="1">
                  <c:v>14.207000000000001</c:v>
                </c:pt>
                <c:pt idx="2">
                  <c:v>0.3</c:v>
                </c:pt>
                <c:pt idx="3">
                  <c:v>3.0203333333333333</c:v>
                </c:pt>
                <c:pt idx="4">
                  <c:v>10.383333333333333</c:v>
                </c:pt>
                <c:pt idx="5">
                  <c:v>11.57133333333333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0DE6-4779-ADC9-C6FE8DA876F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43040896"/>
        <c:axId val="343010720"/>
      </c:lineChart>
      <c:dateAx>
        <c:axId val="34304089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</a:t>
                </a:r>
                <a:r>
                  <a:rPr lang="en-US" altLang="ja-JP" sz="600" b="0" i="0" u="none" strike="noStrike" baseline="0" dirty="0">
                    <a:effectLst/>
                  </a:rPr>
                  <a:t>(relative to calving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_ " sourceLinked="0"/>
        <c:majorTickMark val="out"/>
        <c:minorTickMark val="out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bg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43010720"/>
        <c:crosses val="autoZero"/>
        <c:auto val="0"/>
        <c:lblOffset val="100"/>
        <c:baseTimeUnit val="days"/>
        <c:majorUnit val="7"/>
        <c:majorTimeUnit val="days"/>
      </c:dateAx>
      <c:valAx>
        <c:axId val="343010720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FN-γ (</a:t>
                </a:r>
                <a:r>
                  <a:rPr lang="en-US" altLang="ja-JP" sz="6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</a:t>
                </a: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mL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6.3039175596003541E-2"/>
              <c:y val="0.2032197144382132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_);[Red]\(#,##0\)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43040896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8598641490334564"/>
          <c:y val="0.1057068854756318"/>
          <c:w val="0.61083874455762166"/>
          <c:h val="0.58769547639603836"/>
        </c:manualLayout>
      </c:layout>
      <c:lineChart>
        <c:grouping val="standard"/>
        <c:varyColors val="0"/>
        <c:ser>
          <c:idx val="0"/>
          <c:order val="0"/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dPt>
            <c:idx val="0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946E-460A-8987-69FD8E423B5C}"/>
              </c:ext>
            </c:extLst>
          </c:dPt>
          <c:dPt>
            <c:idx val="1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946E-460A-8987-69FD8E423B5C}"/>
              </c:ext>
            </c:extLst>
          </c:dPt>
          <c:dPt>
            <c:idx val="2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946E-460A-8987-69FD8E423B5C}"/>
              </c:ext>
            </c:extLst>
          </c:dPt>
          <c:dPt>
            <c:idx val="3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946E-460A-8987-69FD8E423B5C}"/>
              </c:ext>
            </c:extLst>
          </c:dPt>
          <c:dPt>
            <c:idx val="4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4-946E-460A-8987-69FD8E423B5C}"/>
              </c:ext>
            </c:extLst>
          </c:dPt>
          <c:dPt>
            <c:idx val="5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5-946E-460A-8987-69FD8E423B5C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'O1'!$T$16:$T$21</c:f>
                <c:numCache>
                  <c:formatCode>General</c:formatCode>
                  <c:ptCount val="6"/>
                  <c:pt idx="0">
                    <c:v>184.18914999773696</c:v>
                  </c:pt>
                  <c:pt idx="1">
                    <c:v>199.26436107105411</c:v>
                  </c:pt>
                  <c:pt idx="2">
                    <c:v>52.688883288813606</c:v>
                  </c:pt>
                  <c:pt idx="3">
                    <c:v>119.35830295677894</c:v>
                  </c:pt>
                  <c:pt idx="4">
                    <c:v>109.46571693787178</c:v>
                  </c:pt>
                  <c:pt idx="5">
                    <c:v>377.02077016355781</c:v>
                  </c:pt>
                </c:numCache>
              </c:numRef>
            </c:plus>
            <c:minus>
              <c:numRef>
                <c:f>'O1'!$T$16:$T$21</c:f>
                <c:numCache>
                  <c:formatCode>General</c:formatCode>
                  <c:ptCount val="6"/>
                  <c:pt idx="0">
                    <c:v>184.18914999773696</c:v>
                  </c:pt>
                  <c:pt idx="1">
                    <c:v>199.26436107105411</c:v>
                  </c:pt>
                  <c:pt idx="2">
                    <c:v>52.688883288813606</c:v>
                  </c:pt>
                  <c:pt idx="3">
                    <c:v>119.35830295677894</c:v>
                  </c:pt>
                  <c:pt idx="4">
                    <c:v>109.46571693787178</c:v>
                  </c:pt>
                  <c:pt idx="5">
                    <c:v>377.0207701635578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O1'!$B$16:$B$21</c:f>
              <c:numCache>
                <c:formatCode>General</c:formatCode>
                <c:ptCount val="6"/>
                <c:pt idx="0">
                  <c:v>0</c:v>
                </c:pt>
                <c:pt idx="1">
                  <c:v>7</c:v>
                </c:pt>
                <c:pt idx="2">
                  <c:v>14</c:v>
                </c:pt>
                <c:pt idx="3">
                  <c:v>15</c:v>
                </c:pt>
                <c:pt idx="4">
                  <c:v>21</c:v>
                </c:pt>
                <c:pt idx="5">
                  <c:v>28</c:v>
                </c:pt>
              </c:numCache>
            </c:numRef>
          </c:cat>
          <c:val>
            <c:numRef>
              <c:f>'O1'!$S$16:$S$21</c:f>
              <c:numCache>
                <c:formatCode>General</c:formatCode>
                <c:ptCount val="6"/>
                <c:pt idx="0">
                  <c:v>3262.7813333333338</c:v>
                </c:pt>
                <c:pt idx="1">
                  <c:v>3468.8941666666665</c:v>
                </c:pt>
                <c:pt idx="2">
                  <c:v>540.00416666666661</c:v>
                </c:pt>
                <c:pt idx="3">
                  <c:v>1402.4733333333334</c:v>
                </c:pt>
                <c:pt idx="4">
                  <c:v>3283.5066666666667</c:v>
                </c:pt>
                <c:pt idx="5">
                  <c:v>4304.27583333333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946E-460A-8987-69FD8E423B5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43040896"/>
        <c:axId val="343010720"/>
      </c:lineChart>
      <c:dateAx>
        <c:axId val="34304089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</a:t>
                </a:r>
                <a:r>
                  <a:rPr lang="en-US" altLang="ja-JP" sz="600" b="0" i="0" u="none" strike="noStrike" baseline="0" dirty="0">
                    <a:effectLst/>
                  </a:rPr>
                  <a:t>(relative to calving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3496193659641682"/>
              <c:y val="0.7679911394369199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_ " sourceLinked="0"/>
        <c:majorTickMark val="out"/>
        <c:minorTickMark val="out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bg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43010720"/>
        <c:crosses val="autoZero"/>
        <c:auto val="0"/>
        <c:lblOffset val="100"/>
        <c:baseTimeUnit val="days"/>
        <c:majorUnit val="7"/>
        <c:majorTimeUnit val="days"/>
      </c:dateAx>
      <c:valAx>
        <c:axId val="343010720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FN-γ (</a:t>
                </a:r>
                <a:r>
                  <a:rPr lang="en-US" altLang="ja-JP" sz="6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</a:t>
                </a: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mL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7.5517493256339635E-2"/>
              <c:y val="0.1936252013689685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_);[Red]\(#,##0\)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43040896"/>
        <c:crossesAt val="0"/>
        <c:crossBetween val="midCat"/>
        <c:majorUnit val="10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161040192278662"/>
          <c:y val="7.4578559731947505E-2"/>
          <c:w val="0.67676598735406213"/>
          <c:h val="0.61275955866899112"/>
        </c:manualLayout>
      </c:layout>
      <c:lineChart>
        <c:grouping val="standard"/>
        <c:varyColors val="0"/>
        <c:ser>
          <c:idx val="0"/>
          <c:order val="0"/>
          <c:tx>
            <c:v>gp51</c:v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dPt>
            <c:idx val="2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0AE8-4E8C-905A-AF801063E7B1}"/>
              </c:ext>
            </c:extLst>
          </c:dPt>
          <c:dPt>
            <c:idx val="3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0AE8-4E8C-905A-AF801063E7B1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'O4'!$O$16:$O$21</c:f>
                <c:numCache>
                  <c:formatCode>General</c:formatCode>
                  <c:ptCount val="6"/>
                  <c:pt idx="0">
                    <c:v>74.94866624267236</c:v>
                  </c:pt>
                  <c:pt idx="1">
                    <c:v>32.407337464771089</c:v>
                  </c:pt>
                  <c:pt idx="2">
                    <c:v>15.305614663326082</c:v>
                  </c:pt>
                  <c:pt idx="3">
                    <c:v>61.583368156959018</c:v>
                  </c:pt>
                  <c:pt idx="4">
                    <c:v>25.479646936329395</c:v>
                  </c:pt>
                  <c:pt idx="5">
                    <c:v>11.563606425140707</c:v>
                  </c:pt>
                </c:numCache>
              </c:numRef>
            </c:plus>
            <c:minus>
              <c:numRef>
                <c:f>'O4'!$O$16:$O$21</c:f>
                <c:numCache>
                  <c:formatCode>General</c:formatCode>
                  <c:ptCount val="6"/>
                  <c:pt idx="0">
                    <c:v>74.94866624267236</c:v>
                  </c:pt>
                  <c:pt idx="1">
                    <c:v>32.407337464771089</c:v>
                  </c:pt>
                  <c:pt idx="2">
                    <c:v>15.305614663326082</c:v>
                  </c:pt>
                  <c:pt idx="3">
                    <c:v>61.583368156959018</c:v>
                  </c:pt>
                  <c:pt idx="4">
                    <c:v>25.479646936329395</c:v>
                  </c:pt>
                  <c:pt idx="5">
                    <c:v>11.56360642514070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O4'!$B$16:$B$21</c:f>
              <c:numCache>
                <c:formatCode>General</c:formatCode>
                <c:ptCount val="6"/>
                <c:pt idx="0">
                  <c:v>0</c:v>
                </c:pt>
                <c:pt idx="1">
                  <c:v>7</c:v>
                </c:pt>
                <c:pt idx="2">
                  <c:v>12</c:v>
                </c:pt>
                <c:pt idx="3">
                  <c:v>13</c:v>
                </c:pt>
                <c:pt idx="4">
                  <c:v>19</c:v>
                </c:pt>
                <c:pt idx="5">
                  <c:v>26</c:v>
                </c:pt>
              </c:numCache>
            </c:numRef>
          </c:cat>
          <c:val>
            <c:numRef>
              <c:f>'O4'!$N$16:$N$21</c:f>
              <c:numCache>
                <c:formatCode>General</c:formatCode>
                <c:ptCount val="6"/>
                <c:pt idx="0">
                  <c:v>432.45066666666668</c:v>
                </c:pt>
                <c:pt idx="1">
                  <c:v>356.19333333333333</c:v>
                </c:pt>
                <c:pt idx="2">
                  <c:v>174.01366666666669</c:v>
                </c:pt>
                <c:pt idx="3">
                  <c:v>203.77533333333335</c:v>
                </c:pt>
                <c:pt idx="4">
                  <c:v>365.54899999999998</c:v>
                </c:pt>
                <c:pt idx="5">
                  <c:v>387.9743333333333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0AE8-4E8C-905A-AF801063E7B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43040896"/>
        <c:axId val="343010720"/>
      </c:lineChart>
      <c:dateAx>
        <c:axId val="34304089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</a:t>
                </a:r>
                <a:r>
                  <a:rPr lang="en-US" altLang="ja-JP" sz="600" b="0" i="0" u="none" strike="noStrike" baseline="0" dirty="0">
                    <a:effectLst/>
                  </a:rPr>
                  <a:t>(relative to calving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33349011945532619"/>
              <c:y val="0.7639231405446026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_ " sourceLinked="0"/>
        <c:majorTickMark val="out"/>
        <c:minorTickMark val="out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bg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43010720"/>
        <c:crosses val="autoZero"/>
        <c:auto val="0"/>
        <c:lblOffset val="100"/>
        <c:baseTimeUnit val="days"/>
        <c:majorUnit val="7"/>
        <c:majorTimeUnit val="days"/>
      </c:dateAx>
      <c:valAx>
        <c:axId val="343010720"/>
        <c:scaling>
          <c:orientation val="minMax"/>
          <c:max val="8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FN-γ (</a:t>
                </a:r>
                <a:r>
                  <a:rPr lang="en-US" altLang="ja-JP" sz="6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</a:t>
                </a: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mL) 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3.8854378499007351E-3"/>
              <c:y val="0.1734849091951015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_);[Red]\(#,##0\)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43040896"/>
        <c:crosses val="autoZero"/>
        <c:crossBetween val="between"/>
        <c:majorUnit val="2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dPt>
            <c:idx val="0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2231-4835-B9A1-6506EF74B431}"/>
              </c:ext>
            </c:extLst>
          </c:dPt>
          <c:dPt>
            <c:idx val="1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2231-4835-B9A1-6506EF74B431}"/>
              </c:ext>
            </c:extLst>
          </c:dPt>
          <c:dPt>
            <c:idx val="2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2231-4835-B9A1-6506EF74B431}"/>
              </c:ext>
            </c:extLst>
          </c:dPt>
          <c:dPt>
            <c:idx val="3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2231-4835-B9A1-6506EF74B431}"/>
              </c:ext>
            </c:extLst>
          </c:dPt>
          <c:dPt>
            <c:idx val="4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4-2231-4835-B9A1-6506EF74B431}"/>
              </c:ext>
            </c:extLst>
          </c:dPt>
          <c:dPt>
            <c:idx val="5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5-2231-4835-B9A1-6506EF74B431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'O1'!$O$6:$O$11</c:f>
                <c:numCache>
                  <c:formatCode>General</c:formatCode>
                  <c:ptCount val="6"/>
                  <c:pt idx="0">
                    <c:v>4.4178451258000644</c:v>
                  </c:pt>
                  <c:pt idx="1">
                    <c:v>12.530088708500596</c:v>
                  </c:pt>
                  <c:pt idx="2">
                    <c:v>33.451390295608121</c:v>
                  </c:pt>
                  <c:pt idx="3">
                    <c:v>4.1933094314589985</c:v>
                  </c:pt>
                  <c:pt idx="4">
                    <c:v>2.7654397321709823</c:v>
                  </c:pt>
                  <c:pt idx="5">
                    <c:v>1.1263060137925849</c:v>
                  </c:pt>
                </c:numCache>
              </c:numRef>
            </c:plus>
            <c:minus>
              <c:numRef>
                <c:f>'O1'!$O$6:$O$11</c:f>
                <c:numCache>
                  <c:formatCode>General</c:formatCode>
                  <c:ptCount val="6"/>
                  <c:pt idx="0">
                    <c:v>4.4178451258000644</c:v>
                  </c:pt>
                  <c:pt idx="1">
                    <c:v>12.530088708500596</c:v>
                  </c:pt>
                  <c:pt idx="2">
                    <c:v>33.451390295608121</c:v>
                  </c:pt>
                  <c:pt idx="3">
                    <c:v>4.1933094314589985</c:v>
                  </c:pt>
                  <c:pt idx="4">
                    <c:v>2.7654397321709823</c:v>
                  </c:pt>
                  <c:pt idx="5">
                    <c:v>1.126306013792584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O1'!$B$6:$B$11</c:f>
              <c:numCache>
                <c:formatCode>General</c:formatCode>
                <c:ptCount val="6"/>
                <c:pt idx="0">
                  <c:v>0</c:v>
                </c:pt>
                <c:pt idx="1">
                  <c:v>7</c:v>
                </c:pt>
                <c:pt idx="2">
                  <c:v>14</c:v>
                </c:pt>
                <c:pt idx="3">
                  <c:v>15</c:v>
                </c:pt>
                <c:pt idx="4">
                  <c:v>21</c:v>
                </c:pt>
                <c:pt idx="5">
                  <c:v>28</c:v>
                </c:pt>
              </c:numCache>
            </c:numRef>
          </c:cat>
          <c:val>
            <c:numRef>
              <c:f>'O1'!$N$6:$N$11</c:f>
              <c:numCache>
                <c:formatCode>General</c:formatCode>
                <c:ptCount val="6"/>
                <c:pt idx="0">
                  <c:v>264.94666666666666</c:v>
                </c:pt>
                <c:pt idx="1">
                  <c:v>301.98578081086868</c:v>
                </c:pt>
                <c:pt idx="2">
                  <c:v>334.58729956190467</c:v>
                </c:pt>
                <c:pt idx="3">
                  <c:v>14.090182959731974</c:v>
                </c:pt>
                <c:pt idx="4">
                  <c:v>5.4772025130306341</c:v>
                </c:pt>
                <c:pt idx="5">
                  <c:v>5.407431318102813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2231-4835-B9A1-6506EF74B43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43040896"/>
        <c:axId val="343010720"/>
      </c:lineChart>
      <c:dateAx>
        <c:axId val="34304089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</a:t>
                </a:r>
                <a:r>
                  <a:rPr lang="en-US" altLang="ja-JP" sz="600" b="0" i="0" u="none" strike="noStrike" baseline="0" dirty="0">
                    <a:effectLst/>
                  </a:rPr>
                  <a:t>(relative to calving)</a:t>
                </a:r>
                <a:r>
                  <a:rPr lang="en-US" altLang="ja-JP" sz="600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32690086080421482"/>
              <c:y val="0.7792260043117845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_ " sourceLinked="0"/>
        <c:majorTickMark val="out"/>
        <c:minorTickMark val="out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bg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43010720"/>
        <c:crosses val="autoZero"/>
        <c:auto val="0"/>
        <c:lblOffset val="100"/>
        <c:baseTimeUnit val="days"/>
        <c:majorUnit val="7"/>
        <c:majorTimeUnit val="days"/>
      </c:dateAx>
      <c:valAx>
        <c:axId val="34301072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stradiol (</a:t>
                </a:r>
                <a:r>
                  <a:rPr lang="en-US" altLang="ja-JP" sz="6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</a:t>
                </a: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mL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7.1658097112618765E-2"/>
              <c:y val="0.1616828105547626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_);[Red]\(#,##0\)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43040896"/>
        <c:crossesAt val="0"/>
        <c:crossBetween val="midCat"/>
        <c:majorUnit val="1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dPt>
            <c:idx val="0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60E6-4026-ACBE-BA504BD5B5E9}"/>
              </c:ext>
            </c:extLst>
          </c:dPt>
          <c:dPt>
            <c:idx val="1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60E6-4026-ACBE-BA504BD5B5E9}"/>
              </c:ext>
            </c:extLst>
          </c:dPt>
          <c:dPt>
            <c:idx val="2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60E6-4026-ACBE-BA504BD5B5E9}"/>
              </c:ext>
            </c:extLst>
          </c:dPt>
          <c:dPt>
            <c:idx val="3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60E6-4026-ACBE-BA504BD5B5E9}"/>
              </c:ext>
            </c:extLst>
          </c:dPt>
          <c:dPt>
            <c:idx val="4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4-60E6-4026-ACBE-BA504BD5B5E9}"/>
              </c:ext>
            </c:extLst>
          </c:dPt>
          <c:dPt>
            <c:idx val="5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5-60E6-4026-ACBE-BA504BD5B5E9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'O4'!$T$16:$T$21</c:f>
                <c:numCache>
                  <c:formatCode>General</c:formatCode>
                  <c:ptCount val="6"/>
                  <c:pt idx="0">
                    <c:v>681.61387769534792</c:v>
                  </c:pt>
                  <c:pt idx="1">
                    <c:v>332.62144870641708</c:v>
                  </c:pt>
                  <c:pt idx="2">
                    <c:v>145.18326603603074</c:v>
                  </c:pt>
                  <c:pt idx="3">
                    <c:v>133.44409308603946</c:v>
                  </c:pt>
                  <c:pt idx="4">
                    <c:v>780.80582666983059</c:v>
                  </c:pt>
                  <c:pt idx="5">
                    <c:v>601.54901088827739</c:v>
                  </c:pt>
                </c:numCache>
              </c:numRef>
            </c:plus>
            <c:minus>
              <c:numRef>
                <c:f>'O4'!$T$16:$T$21</c:f>
                <c:numCache>
                  <c:formatCode>General</c:formatCode>
                  <c:ptCount val="6"/>
                  <c:pt idx="0">
                    <c:v>681.61387769534792</c:v>
                  </c:pt>
                  <c:pt idx="1">
                    <c:v>332.62144870641708</c:v>
                  </c:pt>
                  <c:pt idx="2">
                    <c:v>145.18326603603074</c:v>
                  </c:pt>
                  <c:pt idx="3">
                    <c:v>133.44409308603946</c:v>
                  </c:pt>
                  <c:pt idx="4">
                    <c:v>780.80582666983059</c:v>
                  </c:pt>
                  <c:pt idx="5">
                    <c:v>601.5490108882773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O4'!$B$16:$B$21</c:f>
              <c:numCache>
                <c:formatCode>General</c:formatCode>
                <c:ptCount val="6"/>
                <c:pt idx="0">
                  <c:v>0</c:v>
                </c:pt>
                <c:pt idx="1">
                  <c:v>7</c:v>
                </c:pt>
                <c:pt idx="2">
                  <c:v>12</c:v>
                </c:pt>
                <c:pt idx="3">
                  <c:v>13</c:v>
                </c:pt>
                <c:pt idx="4">
                  <c:v>19</c:v>
                </c:pt>
                <c:pt idx="5">
                  <c:v>26</c:v>
                </c:pt>
              </c:numCache>
            </c:numRef>
          </c:cat>
          <c:val>
            <c:numRef>
              <c:f>'O4'!$S$16:$S$21</c:f>
              <c:numCache>
                <c:formatCode>General</c:formatCode>
                <c:ptCount val="6"/>
                <c:pt idx="0">
                  <c:v>8181.3556666666673</c:v>
                </c:pt>
                <c:pt idx="1">
                  <c:v>6771.8036666666667</c:v>
                </c:pt>
                <c:pt idx="2">
                  <c:v>2739.0696666666663</c:v>
                </c:pt>
                <c:pt idx="3">
                  <c:v>3056.6766666666663</c:v>
                </c:pt>
                <c:pt idx="4">
                  <c:v>4673.8623333333335</c:v>
                </c:pt>
                <c:pt idx="5">
                  <c:v>5946.887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60E6-4026-ACBE-BA504BD5B5E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43040896"/>
        <c:axId val="343010720"/>
      </c:lineChart>
      <c:dateAx>
        <c:axId val="34304089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</a:t>
                </a:r>
                <a:r>
                  <a:rPr lang="en-US" altLang="ja-JP" sz="600" b="0" i="0" u="none" strike="noStrike" baseline="0" dirty="0">
                    <a:effectLst/>
                  </a:rPr>
                  <a:t>(relative to calving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36062324333670276"/>
              <c:y val="0.7794690818428052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_ " sourceLinked="0"/>
        <c:majorTickMark val="out"/>
        <c:minorTickMark val="out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bg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43010720"/>
        <c:crosses val="autoZero"/>
        <c:auto val="0"/>
        <c:lblOffset val="100"/>
        <c:baseTimeUnit val="days"/>
        <c:majorUnit val="7"/>
        <c:majorTimeUnit val="days"/>
      </c:dateAx>
      <c:valAx>
        <c:axId val="34301072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b="0" i="0" u="none" strike="noStrike" baseline="0" dirty="0">
                    <a:effectLst/>
                  </a:rPr>
                  <a:t>IFN-γ</a:t>
                </a: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</a:t>
                </a:r>
                <a:r>
                  <a:rPr lang="en-US" altLang="ja-JP" sz="6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</a:t>
                </a: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mL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9.1231473693429599E-2"/>
              <c:y val="0.1776213022417825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_);[Red]\(#,##0\)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43040896"/>
        <c:crossesAt val="0"/>
        <c:crossBetween val="midCat"/>
        <c:majorUnit val="20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R1'!$F$4:$J$4</c:f>
              <c:strCache>
                <c:ptCount val="1"/>
                <c:pt idx="0">
                  <c:v>PGE2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dPt>
            <c:idx val="2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2E49-49B7-8D4D-49A77CA2DD2C}"/>
              </c:ext>
            </c:extLst>
          </c:dPt>
          <c:dPt>
            <c:idx val="3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2E49-49B7-8D4D-49A77CA2DD2C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'R1'!$J$6:$J$11</c:f>
                <c:numCache>
                  <c:formatCode>General</c:formatCode>
                  <c:ptCount val="6"/>
                  <c:pt idx="0">
                    <c:v>45.189683802056152</c:v>
                  </c:pt>
                  <c:pt idx="1">
                    <c:v>42.662144925338147</c:v>
                  </c:pt>
                  <c:pt idx="2">
                    <c:v>194.81651299663105</c:v>
                  </c:pt>
                  <c:pt idx="3">
                    <c:v>65.317310607165808</c:v>
                  </c:pt>
                  <c:pt idx="4">
                    <c:v>46.409302611673446</c:v>
                  </c:pt>
                  <c:pt idx="5">
                    <c:v>64.451288492225615</c:v>
                  </c:pt>
                </c:numCache>
              </c:numRef>
            </c:plus>
            <c:minus>
              <c:numRef>
                <c:f>'R1'!$J$6:$J$11</c:f>
                <c:numCache>
                  <c:formatCode>General</c:formatCode>
                  <c:ptCount val="6"/>
                  <c:pt idx="0">
                    <c:v>45.189683802056152</c:v>
                  </c:pt>
                  <c:pt idx="1">
                    <c:v>42.662144925338147</c:v>
                  </c:pt>
                  <c:pt idx="2">
                    <c:v>194.81651299663105</c:v>
                  </c:pt>
                  <c:pt idx="3">
                    <c:v>65.317310607165808</c:v>
                  </c:pt>
                  <c:pt idx="4">
                    <c:v>46.409302611673446</c:v>
                  </c:pt>
                  <c:pt idx="5">
                    <c:v>64.45128849222561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R1'!$B$16:$B$21</c:f>
              <c:numCache>
                <c:formatCode>General</c:formatCode>
                <c:ptCount val="6"/>
                <c:pt idx="0">
                  <c:v>0</c:v>
                </c:pt>
                <c:pt idx="1">
                  <c:v>7</c:v>
                </c:pt>
                <c:pt idx="2">
                  <c:v>17</c:v>
                </c:pt>
                <c:pt idx="3">
                  <c:v>18</c:v>
                </c:pt>
                <c:pt idx="4">
                  <c:v>24</c:v>
                </c:pt>
                <c:pt idx="5">
                  <c:v>31</c:v>
                </c:pt>
              </c:numCache>
            </c:numRef>
          </c:cat>
          <c:val>
            <c:numRef>
              <c:f>'R1'!$I$6:$I$11</c:f>
              <c:numCache>
                <c:formatCode>General</c:formatCode>
                <c:ptCount val="6"/>
                <c:pt idx="0">
                  <c:v>540.96706991801295</c:v>
                </c:pt>
                <c:pt idx="1">
                  <c:v>619.4923389984383</c:v>
                </c:pt>
                <c:pt idx="2">
                  <c:v>1974.1886388880896</c:v>
                </c:pt>
                <c:pt idx="3">
                  <c:v>843.35855620654968</c:v>
                </c:pt>
                <c:pt idx="4">
                  <c:v>670.24700590370185</c:v>
                </c:pt>
                <c:pt idx="5">
                  <c:v>439.0792117824166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2E49-49B7-8D4D-49A77CA2DD2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43040896"/>
        <c:axId val="343010720"/>
      </c:lineChart>
      <c:dateAx>
        <c:axId val="34304089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</a:t>
                </a:r>
                <a:r>
                  <a:rPr lang="en-US" altLang="ja-JP" sz="600" b="0" i="0" u="none" strike="noStrike" baseline="0" dirty="0">
                    <a:effectLst/>
                  </a:rPr>
                  <a:t>(relative to calving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34961936596416815"/>
              <c:y val="0.7780097007851901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_ " sourceLinked="0"/>
        <c:majorTickMark val="out"/>
        <c:minorTickMark val="out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bg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43010720"/>
        <c:crosses val="autoZero"/>
        <c:auto val="0"/>
        <c:lblOffset val="100"/>
        <c:baseTimeUnit val="days"/>
        <c:majorUnit val="7"/>
        <c:majorTimeUnit val="days"/>
        <c:minorUnit val="1"/>
        <c:minorTimeUnit val="days"/>
      </c:dateAx>
      <c:valAx>
        <c:axId val="34301072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E</a:t>
                </a:r>
                <a:r>
                  <a:rPr lang="en-US" altLang="ja-JP" sz="600" baseline="-250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</a:t>
                </a:r>
                <a:r>
                  <a:rPr lang="en-US" altLang="ja-JP" sz="6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</a:t>
                </a: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mL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6.4610574670447243E-2"/>
              <c:y val="0.1944859695519383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_);[Red]\(#,##0\)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4304089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v>gp51</c:v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dPt>
            <c:idx val="2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576A-43C2-9061-CAEA4C403210}"/>
              </c:ext>
            </c:extLst>
          </c:dPt>
          <c:dPt>
            <c:idx val="3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576A-43C2-9061-CAEA4C403210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'R1'!$O$16:$O$21</c:f>
                <c:numCache>
                  <c:formatCode>General</c:formatCode>
                  <c:ptCount val="6"/>
                  <c:pt idx="0">
                    <c:v>9.4124749490591579</c:v>
                  </c:pt>
                  <c:pt idx="1">
                    <c:v>5.2342806149035965</c:v>
                  </c:pt>
                  <c:pt idx="2">
                    <c:v>5.0341654941233518</c:v>
                  </c:pt>
                  <c:pt idx="3">
                    <c:v>5.4497053742992927</c:v>
                  </c:pt>
                  <c:pt idx="4">
                    <c:v>8.0031462285500936</c:v>
                  </c:pt>
                  <c:pt idx="5">
                    <c:v>4.8202240842332449</c:v>
                  </c:pt>
                </c:numCache>
              </c:numRef>
            </c:plus>
            <c:minus>
              <c:numRef>
                <c:f>'R1'!$O$16:$O$21</c:f>
                <c:numCache>
                  <c:formatCode>General</c:formatCode>
                  <c:ptCount val="6"/>
                  <c:pt idx="0">
                    <c:v>9.4124749490591579</c:v>
                  </c:pt>
                  <c:pt idx="1">
                    <c:v>5.2342806149035965</c:v>
                  </c:pt>
                  <c:pt idx="2">
                    <c:v>5.0341654941233518</c:v>
                  </c:pt>
                  <c:pt idx="3">
                    <c:v>5.4497053742992927</c:v>
                  </c:pt>
                  <c:pt idx="4">
                    <c:v>8.0031462285500936</c:v>
                  </c:pt>
                  <c:pt idx="5">
                    <c:v>4.820224084233244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R1'!$B$16:$B$21</c:f>
              <c:numCache>
                <c:formatCode>General</c:formatCode>
                <c:ptCount val="6"/>
                <c:pt idx="0">
                  <c:v>0</c:v>
                </c:pt>
                <c:pt idx="1">
                  <c:v>7</c:v>
                </c:pt>
                <c:pt idx="2">
                  <c:v>17</c:v>
                </c:pt>
                <c:pt idx="3">
                  <c:v>18</c:v>
                </c:pt>
                <c:pt idx="4">
                  <c:v>24</c:v>
                </c:pt>
                <c:pt idx="5">
                  <c:v>31</c:v>
                </c:pt>
              </c:numCache>
            </c:numRef>
          </c:cat>
          <c:val>
            <c:numRef>
              <c:f>'R1'!$N$16:$N$21</c:f>
              <c:numCache>
                <c:formatCode>General</c:formatCode>
                <c:ptCount val="6"/>
                <c:pt idx="0">
                  <c:v>91.528999999999996</c:v>
                </c:pt>
                <c:pt idx="1">
                  <c:v>103.26366666666667</c:v>
                </c:pt>
                <c:pt idx="2">
                  <c:v>23.093333333333334</c:v>
                </c:pt>
                <c:pt idx="3">
                  <c:v>29.719000000000005</c:v>
                </c:pt>
                <c:pt idx="4">
                  <c:v>79.986333333333334</c:v>
                </c:pt>
                <c:pt idx="5">
                  <c:v>75.7496666666666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576A-43C2-9061-CAEA4C40321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43040896"/>
        <c:axId val="343010720"/>
      </c:lineChart>
      <c:dateAx>
        <c:axId val="34304089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</a:t>
                </a:r>
                <a:r>
                  <a:rPr lang="en-US" altLang="ja-JP" sz="600" b="0" i="0" u="none" strike="noStrike" baseline="0" dirty="0">
                    <a:effectLst/>
                  </a:rPr>
                  <a:t>(relative to calving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33860790830004395"/>
              <c:y val="0.7965862948617433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_ " sourceLinked="0"/>
        <c:majorTickMark val="out"/>
        <c:minorTickMark val="out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bg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43010720"/>
        <c:crosses val="autoZero"/>
        <c:auto val="0"/>
        <c:lblOffset val="100"/>
        <c:baseTimeUnit val="days"/>
        <c:majorUnit val="7"/>
        <c:majorTimeUnit val="days"/>
      </c:dateAx>
      <c:valAx>
        <c:axId val="34301072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FN-γ (</a:t>
                </a:r>
                <a:r>
                  <a:rPr lang="en-US" altLang="ja-JP" sz="6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</a:t>
                </a: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mL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5.3677610700260357E-2"/>
              <c:y val="0.2226514504370619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_);[Red]\(#,##0\)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43040896"/>
        <c:crosses val="autoZero"/>
        <c:crossBetween val="between"/>
        <c:majorUnit val="4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dPt>
            <c:idx val="2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ADEE-4193-82F3-A5D1A5ADBFC6}"/>
              </c:ext>
            </c:extLst>
          </c:dPt>
          <c:dPt>
            <c:idx val="3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ADEE-4193-82F3-A5D1A5ADBFC6}"/>
              </c:ext>
            </c:extLst>
          </c:dPt>
          <c:dPt>
            <c:idx val="4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ADEE-4193-82F3-A5D1A5ADBFC6}"/>
              </c:ext>
            </c:extLst>
          </c:dPt>
          <c:dPt>
            <c:idx val="5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ADEE-4193-82F3-A5D1A5ADBFC6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'R1'!$T$16:$T$21</c:f>
                <c:numCache>
                  <c:formatCode>General</c:formatCode>
                  <c:ptCount val="6"/>
                  <c:pt idx="0">
                    <c:v>156.65369972508012</c:v>
                  </c:pt>
                  <c:pt idx="1">
                    <c:v>404.08938800798336</c:v>
                  </c:pt>
                  <c:pt idx="2">
                    <c:v>42.605097183318108</c:v>
                  </c:pt>
                  <c:pt idx="3">
                    <c:v>14.989720952113228</c:v>
                  </c:pt>
                  <c:pt idx="4">
                    <c:v>223.39300739429274</c:v>
                  </c:pt>
                  <c:pt idx="5">
                    <c:v>352.07912503141813</c:v>
                  </c:pt>
                </c:numCache>
              </c:numRef>
            </c:plus>
            <c:minus>
              <c:numRef>
                <c:f>'R1'!$T$16:$T$21</c:f>
                <c:numCache>
                  <c:formatCode>General</c:formatCode>
                  <c:ptCount val="6"/>
                  <c:pt idx="0">
                    <c:v>156.65369972508012</c:v>
                  </c:pt>
                  <c:pt idx="1">
                    <c:v>404.08938800798336</c:v>
                  </c:pt>
                  <c:pt idx="2">
                    <c:v>42.605097183318108</c:v>
                  </c:pt>
                  <c:pt idx="3">
                    <c:v>14.989720952113228</c:v>
                  </c:pt>
                  <c:pt idx="4">
                    <c:v>223.39300739429274</c:v>
                  </c:pt>
                  <c:pt idx="5">
                    <c:v>352.0791250314181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R1'!$B$16:$B$21</c:f>
              <c:numCache>
                <c:formatCode>General</c:formatCode>
                <c:ptCount val="6"/>
                <c:pt idx="0">
                  <c:v>0</c:v>
                </c:pt>
                <c:pt idx="1">
                  <c:v>7</c:v>
                </c:pt>
                <c:pt idx="2">
                  <c:v>17</c:v>
                </c:pt>
                <c:pt idx="3">
                  <c:v>18</c:v>
                </c:pt>
                <c:pt idx="4">
                  <c:v>24</c:v>
                </c:pt>
                <c:pt idx="5">
                  <c:v>31</c:v>
                </c:pt>
              </c:numCache>
            </c:numRef>
          </c:cat>
          <c:val>
            <c:numRef>
              <c:f>'R1'!$S$16:$S$21</c:f>
              <c:numCache>
                <c:formatCode>General</c:formatCode>
                <c:ptCount val="6"/>
                <c:pt idx="0">
                  <c:v>8454.7386666666662</c:v>
                </c:pt>
                <c:pt idx="1">
                  <c:v>9155.0720000000001</c:v>
                </c:pt>
                <c:pt idx="2">
                  <c:v>417.041</c:v>
                </c:pt>
                <c:pt idx="3">
                  <c:v>190.32966666666667</c:v>
                </c:pt>
                <c:pt idx="4">
                  <c:v>5825.6410000000005</c:v>
                </c:pt>
                <c:pt idx="5">
                  <c:v>5597.62166666666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ADEE-4193-82F3-A5D1A5ADBFC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43040896"/>
        <c:axId val="343010720"/>
      </c:lineChart>
      <c:dateAx>
        <c:axId val="34304089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</a:t>
                </a:r>
                <a:r>
                  <a:rPr lang="en-US" altLang="ja-JP" sz="600" b="0" i="0" u="none" strike="noStrike" baseline="0" dirty="0">
                    <a:effectLst/>
                  </a:rPr>
                  <a:t>(relative to calving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35591248175901957"/>
              <c:y val="0.7900561827861618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_ " sourceLinked="0"/>
        <c:majorTickMark val="out"/>
        <c:minorTickMark val="out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bg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43010720"/>
        <c:crosses val="autoZero"/>
        <c:auto val="0"/>
        <c:lblOffset val="100"/>
        <c:baseTimeUnit val="days"/>
        <c:majorUnit val="7"/>
        <c:majorTimeUnit val="days"/>
      </c:dateAx>
      <c:valAx>
        <c:axId val="34301072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FN-γ (</a:t>
                </a:r>
                <a:r>
                  <a:rPr lang="en-US" altLang="ja-JP" sz="6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</a:t>
                </a: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mL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_);[Red]\(#,##0\)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4304089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dPt>
            <c:idx val="2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375E-4287-AB8B-E4054895A6E1}"/>
              </c:ext>
            </c:extLst>
          </c:dPt>
          <c:dPt>
            <c:idx val="3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375E-4287-AB8B-E4054895A6E1}"/>
              </c:ext>
            </c:extLst>
          </c:dPt>
          <c:dPt>
            <c:idx val="4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375E-4287-AB8B-E4054895A6E1}"/>
              </c:ext>
            </c:extLst>
          </c:dPt>
          <c:dPt>
            <c:idx val="5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375E-4287-AB8B-E4054895A6E1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'R1'!$O$6:$O$11</c:f>
                <c:numCache>
                  <c:formatCode>General</c:formatCode>
                  <c:ptCount val="6"/>
                  <c:pt idx="0">
                    <c:v>12.792377125651395</c:v>
                  </c:pt>
                  <c:pt idx="1">
                    <c:v>11.285437549434002</c:v>
                  </c:pt>
                  <c:pt idx="2">
                    <c:v>24.462240026343391</c:v>
                  </c:pt>
                  <c:pt idx="3">
                    <c:v>1.7805795362613426</c:v>
                  </c:pt>
                  <c:pt idx="4">
                    <c:v>1.58089835251196</c:v>
                  </c:pt>
                  <c:pt idx="5">
                    <c:v>0.22433913233734482</c:v>
                  </c:pt>
                </c:numCache>
              </c:numRef>
            </c:plus>
            <c:minus>
              <c:numRef>
                <c:f>'R1'!$O$6:$O$11</c:f>
                <c:numCache>
                  <c:formatCode>General</c:formatCode>
                  <c:ptCount val="6"/>
                  <c:pt idx="0">
                    <c:v>12.792377125651395</c:v>
                  </c:pt>
                  <c:pt idx="1">
                    <c:v>11.285437549434002</c:v>
                  </c:pt>
                  <c:pt idx="2">
                    <c:v>24.462240026343391</c:v>
                  </c:pt>
                  <c:pt idx="3">
                    <c:v>1.7805795362613426</c:v>
                  </c:pt>
                  <c:pt idx="4">
                    <c:v>1.58089835251196</c:v>
                  </c:pt>
                  <c:pt idx="5">
                    <c:v>0.2243391323373448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R1'!$B$16:$B$21</c:f>
              <c:numCache>
                <c:formatCode>General</c:formatCode>
                <c:ptCount val="6"/>
                <c:pt idx="0">
                  <c:v>0</c:v>
                </c:pt>
                <c:pt idx="1">
                  <c:v>7</c:v>
                </c:pt>
                <c:pt idx="2">
                  <c:v>17</c:v>
                </c:pt>
                <c:pt idx="3">
                  <c:v>18</c:v>
                </c:pt>
                <c:pt idx="4">
                  <c:v>24</c:v>
                </c:pt>
                <c:pt idx="5">
                  <c:v>31</c:v>
                </c:pt>
              </c:numCache>
            </c:numRef>
          </c:cat>
          <c:val>
            <c:numRef>
              <c:f>'R1'!$N$6:$N$11</c:f>
              <c:numCache>
                <c:formatCode>General</c:formatCode>
                <c:ptCount val="6"/>
                <c:pt idx="0">
                  <c:v>158.54735349033473</c:v>
                </c:pt>
                <c:pt idx="1">
                  <c:v>158.40527510672158</c:v>
                </c:pt>
                <c:pt idx="2">
                  <c:v>242.40221803075246</c:v>
                </c:pt>
                <c:pt idx="3">
                  <c:v>11.706476058230029</c:v>
                </c:pt>
                <c:pt idx="4">
                  <c:v>5.2496931348350975</c:v>
                </c:pt>
                <c:pt idx="5">
                  <c:v>3.746194377301057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375E-4287-AB8B-E4054895A6E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43040896"/>
        <c:axId val="343010720"/>
      </c:lineChart>
      <c:dateAx>
        <c:axId val="34304089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(relative to calving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_ " sourceLinked="0"/>
        <c:majorTickMark val="out"/>
        <c:minorTickMark val="out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bg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43010720"/>
        <c:crosses val="autoZero"/>
        <c:auto val="0"/>
        <c:lblOffset val="100"/>
        <c:baseTimeUnit val="days"/>
        <c:majorUnit val="7"/>
        <c:majorTimeUnit val="days"/>
      </c:dateAx>
      <c:valAx>
        <c:axId val="34301072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stradiol (</a:t>
                </a:r>
                <a:r>
                  <a:rPr lang="en-US" altLang="ja-JP" sz="6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</a:t>
                </a: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mL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5.3677610700260357E-2"/>
              <c:y val="0.1792751032683103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_);[Red]\(#,##0\)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43040896"/>
        <c:crosses val="autoZero"/>
        <c:crossBetween val="between"/>
        <c:majorUnit val="1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R2'!$F$4:$J$4</c:f>
              <c:strCache>
                <c:ptCount val="1"/>
                <c:pt idx="0">
                  <c:v>PGE2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dPt>
            <c:idx val="2"/>
            <c:bubble3D val="0"/>
            <c:extLst>
              <c:ext xmlns:c16="http://schemas.microsoft.com/office/drawing/2014/chart" uri="{C3380CC4-5D6E-409C-BE32-E72D297353CC}">
                <c16:uniqueId val="{00000000-99C5-4387-9684-E6778697B752}"/>
              </c:ext>
            </c:extLst>
          </c:dPt>
          <c:dPt>
            <c:idx val="3"/>
            <c:bubble3D val="0"/>
            <c:extLst>
              <c:ext xmlns:c16="http://schemas.microsoft.com/office/drawing/2014/chart" uri="{C3380CC4-5D6E-409C-BE32-E72D297353CC}">
                <c16:uniqueId val="{00000001-99C5-4387-9684-E6778697B752}"/>
              </c:ext>
            </c:extLst>
          </c:dPt>
          <c:dPt>
            <c:idx val="4"/>
            <c:bubble3D val="0"/>
            <c:extLst>
              <c:ext xmlns:c16="http://schemas.microsoft.com/office/drawing/2014/chart" uri="{C3380CC4-5D6E-409C-BE32-E72D297353CC}">
                <c16:uniqueId val="{00000002-99C5-4387-9684-E6778697B752}"/>
              </c:ext>
            </c:extLst>
          </c:dPt>
          <c:dPt>
            <c:idx val="5"/>
            <c:bubble3D val="0"/>
            <c:extLst>
              <c:ext xmlns:c16="http://schemas.microsoft.com/office/drawing/2014/chart" uri="{C3380CC4-5D6E-409C-BE32-E72D297353CC}">
                <c16:uniqueId val="{00000003-99C5-4387-9684-E6778697B752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'R2'!$J$6:$J$11</c:f>
                <c:numCache>
                  <c:formatCode>General</c:formatCode>
                  <c:ptCount val="6"/>
                  <c:pt idx="0">
                    <c:v>24.69818121958691</c:v>
                  </c:pt>
                  <c:pt idx="1">
                    <c:v>19.242075391579444</c:v>
                  </c:pt>
                  <c:pt idx="2">
                    <c:v>54.917718302218091</c:v>
                  </c:pt>
                  <c:pt idx="3">
                    <c:v>42.883560157178465</c:v>
                  </c:pt>
                  <c:pt idx="4">
                    <c:v>23.392729332963263</c:v>
                  </c:pt>
                  <c:pt idx="5">
                    <c:v>69.170246433803698</c:v>
                  </c:pt>
                </c:numCache>
              </c:numRef>
            </c:plus>
            <c:minus>
              <c:numRef>
                <c:f>'R2'!$J$6:$J$11</c:f>
                <c:numCache>
                  <c:formatCode>General</c:formatCode>
                  <c:ptCount val="6"/>
                  <c:pt idx="0">
                    <c:v>24.69818121958691</c:v>
                  </c:pt>
                  <c:pt idx="1">
                    <c:v>19.242075391579444</c:v>
                  </c:pt>
                  <c:pt idx="2">
                    <c:v>54.917718302218091</c:v>
                  </c:pt>
                  <c:pt idx="3">
                    <c:v>42.883560157178465</c:v>
                  </c:pt>
                  <c:pt idx="4">
                    <c:v>23.392729332963263</c:v>
                  </c:pt>
                  <c:pt idx="5">
                    <c:v>69.1702464338036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R2'!$B$6:$B$11</c:f>
              <c:numCache>
                <c:formatCode>General</c:formatCode>
                <c:ptCount val="6"/>
                <c:pt idx="0">
                  <c:v>0</c:v>
                </c:pt>
                <c:pt idx="1">
                  <c:v>7</c:v>
                </c:pt>
                <c:pt idx="2">
                  <c:v>16</c:v>
                </c:pt>
                <c:pt idx="3">
                  <c:v>17</c:v>
                </c:pt>
                <c:pt idx="4">
                  <c:v>23</c:v>
                </c:pt>
                <c:pt idx="5">
                  <c:v>30</c:v>
                </c:pt>
              </c:numCache>
            </c:numRef>
          </c:cat>
          <c:val>
            <c:numRef>
              <c:f>'R2'!$I$6:$I$11</c:f>
              <c:numCache>
                <c:formatCode>General</c:formatCode>
                <c:ptCount val="6"/>
                <c:pt idx="0">
                  <c:v>482.6133333333334</c:v>
                </c:pt>
                <c:pt idx="1">
                  <c:v>553.57569138194822</c:v>
                </c:pt>
                <c:pt idx="2">
                  <c:v>1627.5528639442882</c:v>
                </c:pt>
                <c:pt idx="3">
                  <c:v>796.04015913241449</c:v>
                </c:pt>
                <c:pt idx="4">
                  <c:v>968.17353283938871</c:v>
                </c:pt>
                <c:pt idx="5">
                  <c:v>728.922028752972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99C5-4387-9684-E6778697B75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5571968"/>
        <c:axId val="210035072"/>
      </c:lineChart>
      <c:dateAx>
        <c:axId val="20557196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</a:t>
                </a:r>
                <a:r>
                  <a:rPr lang="en-US" altLang="ja-JP" sz="600" b="0" i="0" u="none" strike="noStrike" baseline="0" dirty="0">
                    <a:effectLst/>
                  </a:rPr>
                  <a:t>(relative to calving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#,##0_ " sourceLinked="0"/>
        <c:majorTickMark val="out"/>
        <c:minorTickMark val="out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600" b="0" i="0" u="none" strike="noStrike" kern="1200" baseline="0">
                <a:solidFill>
                  <a:schemeClr val="bg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10035072"/>
        <c:crosses val="autoZero"/>
        <c:auto val="0"/>
        <c:lblOffset val="100"/>
        <c:baseTimeUnit val="days"/>
        <c:majorUnit val="7"/>
        <c:majorTimeUnit val="days"/>
      </c:dateAx>
      <c:valAx>
        <c:axId val="21003507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E</a:t>
                </a:r>
                <a:r>
                  <a:rPr lang="en-US" altLang="ja-JP" sz="600" baseline="-250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</a:t>
                </a:r>
                <a:r>
                  <a:rPr lang="en-US" altLang="ja-JP" sz="6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</a:t>
                </a: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mL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5.5556628973592308E-2"/>
              <c:y val="0.21136126110115241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#,##0_);[Red]\(#,##0\)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05571968"/>
        <c:crosses val="autoZero"/>
        <c:crossBetween val="between"/>
        <c:majorUnit val="3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v>gp51</c:v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dPt>
            <c:idx val="2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F424-455F-A510-CA2CCF4E2A88}"/>
              </c:ext>
            </c:extLst>
          </c:dPt>
          <c:dPt>
            <c:idx val="3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F424-455F-A510-CA2CCF4E2A88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'R2'!$O$16:$O$21</c:f>
                <c:numCache>
                  <c:formatCode>General</c:formatCode>
                  <c:ptCount val="6"/>
                  <c:pt idx="0">
                    <c:v>2.6413821297865163</c:v>
                  </c:pt>
                  <c:pt idx="1">
                    <c:v>2.5720425519203389</c:v>
                  </c:pt>
                  <c:pt idx="2">
                    <c:v>1.5077940472388427</c:v>
                  </c:pt>
                  <c:pt idx="3">
                    <c:v>24.187205906337354</c:v>
                  </c:pt>
                  <c:pt idx="4">
                    <c:v>10.86098866995491</c:v>
                  </c:pt>
                  <c:pt idx="5">
                    <c:v>10.102174496392118</c:v>
                  </c:pt>
                </c:numCache>
              </c:numRef>
            </c:plus>
            <c:minus>
              <c:numRef>
                <c:f>'R2'!$O$16:$O$21</c:f>
                <c:numCache>
                  <c:formatCode>General</c:formatCode>
                  <c:ptCount val="6"/>
                  <c:pt idx="0">
                    <c:v>2.6413821297865163</c:v>
                  </c:pt>
                  <c:pt idx="1">
                    <c:v>2.5720425519203389</c:v>
                  </c:pt>
                  <c:pt idx="2">
                    <c:v>1.5077940472388427</c:v>
                  </c:pt>
                  <c:pt idx="3">
                    <c:v>24.187205906337354</c:v>
                  </c:pt>
                  <c:pt idx="4">
                    <c:v>10.86098866995491</c:v>
                  </c:pt>
                  <c:pt idx="5">
                    <c:v>10.10217449639211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R2'!$B$6:$B$11</c:f>
              <c:numCache>
                <c:formatCode>General</c:formatCode>
                <c:ptCount val="6"/>
                <c:pt idx="0">
                  <c:v>0</c:v>
                </c:pt>
                <c:pt idx="1">
                  <c:v>7</c:v>
                </c:pt>
                <c:pt idx="2">
                  <c:v>16</c:v>
                </c:pt>
                <c:pt idx="3">
                  <c:v>17</c:v>
                </c:pt>
                <c:pt idx="4">
                  <c:v>23</c:v>
                </c:pt>
                <c:pt idx="5">
                  <c:v>30</c:v>
                </c:pt>
              </c:numCache>
            </c:numRef>
          </c:cat>
          <c:val>
            <c:numRef>
              <c:f>'R2'!$N$16:$N$21</c:f>
              <c:numCache>
                <c:formatCode>General</c:formatCode>
                <c:ptCount val="6"/>
                <c:pt idx="0">
                  <c:v>27.380666666666666</c:v>
                </c:pt>
                <c:pt idx="1">
                  <c:v>30.100666666666665</c:v>
                </c:pt>
                <c:pt idx="2">
                  <c:v>17.069666666666667</c:v>
                </c:pt>
                <c:pt idx="3">
                  <c:v>129.90566666666666</c:v>
                </c:pt>
                <c:pt idx="4">
                  <c:v>30.647666666666666</c:v>
                </c:pt>
                <c:pt idx="5">
                  <c:v>25.72866666666666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F424-455F-A510-CA2CCF4E2A8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98189056"/>
        <c:axId val="198310528"/>
      </c:lineChart>
      <c:dateAx>
        <c:axId val="19818905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</a:t>
                </a:r>
                <a:r>
                  <a:rPr lang="en-US" altLang="ja-JP" sz="600" b="0" i="0" u="none" strike="noStrike" baseline="0" dirty="0">
                    <a:effectLst/>
                  </a:rPr>
                  <a:t>(relative to calving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3361513733655177"/>
              <c:y val="0.7965862948617433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_ " sourceLinked="0"/>
        <c:majorTickMark val="out"/>
        <c:minorTickMark val="out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bg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98310528"/>
        <c:crosses val="autoZero"/>
        <c:auto val="0"/>
        <c:lblOffset val="100"/>
        <c:baseTimeUnit val="days"/>
        <c:majorUnit val="7"/>
        <c:majorTimeUnit val="days"/>
      </c:dateAx>
      <c:valAx>
        <c:axId val="19831052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FN-γ (</a:t>
                </a:r>
                <a:r>
                  <a:rPr lang="en-US" altLang="ja-JP" sz="6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</a:t>
                </a: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mL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5.57739514837911E-2"/>
              <c:y val="0.2129696806581088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_);[Red]\(#,##0\)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98189056"/>
        <c:crosses val="autoZero"/>
        <c:crossBetween val="between"/>
        <c:majorUnit val="3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9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1022F-DE56-4A38-804B-03CA95AF64B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21795-5A08-4B44-81B2-900484F4B7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75063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1022F-DE56-4A38-804B-03CA95AF64B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21795-5A08-4B44-81B2-900484F4B7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74263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1022F-DE56-4A38-804B-03CA95AF64B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21795-5A08-4B44-81B2-900484F4B7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33355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1022F-DE56-4A38-804B-03CA95AF64B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21795-5A08-4B44-81B2-900484F4B7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18114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1022F-DE56-4A38-804B-03CA95AF64B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21795-5A08-4B44-81B2-900484F4B7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60253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1022F-DE56-4A38-804B-03CA95AF64B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21795-5A08-4B44-81B2-900484F4B7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63597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1022F-DE56-4A38-804B-03CA95AF64B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21795-5A08-4B44-81B2-900484F4B7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05109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1022F-DE56-4A38-804B-03CA95AF64B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21795-5A08-4B44-81B2-900484F4B7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9490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1022F-DE56-4A38-804B-03CA95AF64B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21795-5A08-4B44-81B2-900484F4B7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95158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1022F-DE56-4A38-804B-03CA95AF64B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21795-5A08-4B44-81B2-900484F4B7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46251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1022F-DE56-4A38-804B-03CA95AF64B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21795-5A08-4B44-81B2-900484F4B7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34571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91022F-DE56-4A38-804B-03CA95AF64B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D21795-5A08-4B44-81B2-900484F4B7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74193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13" Type="http://schemas.openxmlformats.org/officeDocument/2006/relationships/chart" Target="../charts/chart12.xml"/><Relationship Id="rId18" Type="http://schemas.openxmlformats.org/officeDocument/2006/relationships/chart" Target="../charts/chart17.xml"/><Relationship Id="rId3" Type="http://schemas.openxmlformats.org/officeDocument/2006/relationships/chart" Target="../charts/chart2.xml"/><Relationship Id="rId21" Type="http://schemas.openxmlformats.org/officeDocument/2006/relationships/chart" Target="../charts/chart20.xml"/><Relationship Id="rId7" Type="http://schemas.openxmlformats.org/officeDocument/2006/relationships/chart" Target="../charts/chart6.xml"/><Relationship Id="rId12" Type="http://schemas.openxmlformats.org/officeDocument/2006/relationships/chart" Target="../charts/chart11.xml"/><Relationship Id="rId17" Type="http://schemas.openxmlformats.org/officeDocument/2006/relationships/chart" Target="../charts/chart16.xml"/><Relationship Id="rId2" Type="http://schemas.openxmlformats.org/officeDocument/2006/relationships/chart" Target="../charts/chart1.xml"/><Relationship Id="rId16" Type="http://schemas.openxmlformats.org/officeDocument/2006/relationships/chart" Target="../charts/chart15.xml"/><Relationship Id="rId20" Type="http://schemas.openxmlformats.org/officeDocument/2006/relationships/chart" Target="../charts/chart19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5" Type="http://schemas.openxmlformats.org/officeDocument/2006/relationships/chart" Target="../charts/chart14.xml"/><Relationship Id="rId10" Type="http://schemas.openxmlformats.org/officeDocument/2006/relationships/chart" Target="../charts/chart9.xml"/><Relationship Id="rId19" Type="http://schemas.openxmlformats.org/officeDocument/2006/relationships/chart" Target="../charts/chart18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Relationship Id="rId14" Type="http://schemas.openxmlformats.org/officeDocument/2006/relationships/chart" Target="../charts/char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56" name="表 155">
            <a:extLst>
              <a:ext uri="{FF2B5EF4-FFF2-40B4-BE49-F238E27FC236}">
                <a16:creationId xmlns:a16="http://schemas.microsoft.com/office/drawing/2014/main" id="{96020893-7042-40DD-B397-AF04A8A5C00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57053345"/>
              </p:ext>
            </p:extLst>
          </p:nvPr>
        </p:nvGraphicFramePr>
        <p:xfrm>
          <a:off x="992106" y="764601"/>
          <a:ext cx="8064175" cy="48960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612835">
                  <a:extLst>
                    <a:ext uri="{9D8B030D-6E8A-4147-A177-3AD203B41FA5}">
                      <a16:colId xmlns:a16="http://schemas.microsoft.com/office/drawing/2014/main" val="3619079823"/>
                    </a:ext>
                  </a:extLst>
                </a:gridCol>
                <a:gridCol w="1612835">
                  <a:extLst>
                    <a:ext uri="{9D8B030D-6E8A-4147-A177-3AD203B41FA5}">
                      <a16:colId xmlns:a16="http://schemas.microsoft.com/office/drawing/2014/main" val="2155430796"/>
                    </a:ext>
                  </a:extLst>
                </a:gridCol>
                <a:gridCol w="1612835">
                  <a:extLst>
                    <a:ext uri="{9D8B030D-6E8A-4147-A177-3AD203B41FA5}">
                      <a16:colId xmlns:a16="http://schemas.microsoft.com/office/drawing/2014/main" val="2874739532"/>
                    </a:ext>
                  </a:extLst>
                </a:gridCol>
                <a:gridCol w="1612835">
                  <a:extLst>
                    <a:ext uri="{9D8B030D-6E8A-4147-A177-3AD203B41FA5}">
                      <a16:colId xmlns:a16="http://schemas.microsoft.com/office/drawing/2014/main" val="4000538848"/>
                    </a:ext>
                  </a:extLst>
                </a:gridCol>
                <a:gridCol w="1612835">
                  <a:extLst>
                    <a:ext uri="{9D8B030D-6E8A-4147-A177-3AD203B41FA5}">
                      <a16:colId xmlns:a16="http://schemas.microsoft.com/office/drawing/2014/main" val="2025257637"/>
                    </a:ext>
                  </a:extLst>
                </a:gridCol>
              </a:tblGrid>
              <a:tr h="1224000">
                <a:tc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72631903"/>
                  </a:ext>
                </a:extLst>
              </a:tr>
              <a:tr h="1224000">
                <a:tc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32098076"/>
                  </a:ext>
                </a:extLst>
              </a:tr>
              <a:tr h="1224000">
                <a:tc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8735713"/>
                  </a:ext>
                </a:extLst>
              </a:tr>
              <a:tr h="1224000">
                <a:tc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46389948"/>
                  </a:ext>
                </a:extLst>
              </a:tr>
            </a:tbl>
          </a:graphicData>
        </a:graphic>
      </p:graphicFrame>
      <p:grpSp>
        <p:nvGrpSpPr>
          <p:cNvPr id="178" name="グループ化 177">
            <a:extLst>
              <a:ext uri="{FF2B5EF4-FFF2-40B4-BE49-F238E27FC236}">
                <a16:creationId xmlns:a16="http://schemas.microsoft.com/office/drawing/2014/main" id="{17690C5A-1723-49C8-9F6D-5B106591572F}"/>
              </a:ext>
            </a:extLst>
          </p:cNvPr>
          <p:cNvGrpSpPr/>
          <p:nvPr/>
        </p:nvGrpSpPr>
        <p:grpSpPr>
          <a:xfrm>
            <a:off x="5851129" y="783227"/>
            <a:ext cx="1656184" cy="1367313"/>
            <a:chOff x="3664521" y="615691"/>
            <a:chExt cx="1656184" cy="1367313"/>
          </a:xfrm>
        </p:grpSpPr>
        <p:graphicFrame>
          <p:nvGraphicFramePr>
            <p:cNvPr id="179" name="グラフ 178">
              <a:extLst>
                <a:ext uri="{FF2B5EF4-FFF2-40B4-BE49-F238E27FC236}">
                  <a16:creationId xmlns:a16="http://schemas.microsoft.com/office/drawing/2014/main" id="{5FC289DF-BA61-4871-8CE3-AE97D0155184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15048957"/>
                </p:ext>
              </p:extLst>
            </p:nvPr>
          </p:nvGraphicFramePr>
          <p:xfrm>
            <a:off x="3664521" y="615691"/>
            <a:ext cx="1656184" cy="136731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80" name="テキスト ボックス 179">
              <a:extLst>
                <a:ext uri="{FF2B5EF4-FFF2-40B4-BE49-F238E27FC236}">
                  <a16:creationId xmlns:a16="http://schemas.microsoft.com/office/drawing/2014/main" id="{264D2F33-BF72-46A4-8E96-75D76C067EAC}"/>
                </a:ext>
              </a:extLst>
            </p:cNvPr>
            <p:cNvSpPr txBox="1"/>
            <p:nvPr/>
          </p:nvSpPr>
          <p:spPr>
            <a:xfrm>
              <a:off x="4505645" y="1513673"/>
              <a:ext cx="11963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1" name="テキスト ボックス 180">
              <a:extLst>
                <a:ext uri="{FF2B5EF4-FFF2-40B4-BE49-F238E27FC236}">
                  <a16:creationId xmlns:a16="http://schemas.microsoft.com/office/drawing/2014/main" id="{9BD2254F-C19C-466C-8C60-5C3548205235}"/>
                </a:ext>
              </a:extLst>
            </p:cNvPr>
            <p:cNvSpPr txBox="1"/>
            <p:nvPr/>
          </p:nvSpPr>
          <p:spPr>
            <a:xfrm>
              <a:off x="4755481" y="1513673"/>
              <a:ext cx="15782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2" name="テキスト ボックス 181">
              <a:extLst>
                <a:ext uri="{FF2B5EF4-FFF2-40B4-BE49-F238E27FC236}">
                  <a16:creationId xmlns:a16="http://schemas.microsoft.com/office/drawing/2014/main" id="{039D163F-59F3-4545-971B-8E80EA513F21}"/>
                </a:ext>
              </a:extLst>
            </p:cNvPr>
            <p:cNvSpPr txBox="1"/>
            <p:nvPr/>
          </p:nvSpPr>
          <p:spPr>
            <a:xfrm>
              <a:off x="4984176" y="1513673"/>
              <a:ext cx="26239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3" name="テキスト ボックス 182">
              <a:extLst>
                <a:ext uri="{FF2B5EF4-FFF2-40B4-BE49-F238E27FC236}">
                  <a16:creationId xmlns:a16="http://schemas.microsoft.com/office/drawing/2014/main" id="{EA006F58-140A-4136-80B0-D1B83E89CC43}"/>
                </a:ext>
              </a:extLst>
            </p:cNvPr>
            <p:cNvSpPr txBox="1"/>
            <p:nvPr/>
          </p:nvSpPr>
          <p:spPr>
            <a:xfrm>
              <a:off x="4218860" y="1513673"/>
              <a:ext cx="26239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−</a:t>
              </a:r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4" name="テキスト ボックス 183">
              <a:extLst>
                <a:ext uri="{FF2B5EF4-FFF2-40B4-BE49-F238E27FC236}">
                  <a16:creationId xmlns:a16="http://schemas.microsoft.com/office/drawing/2014/main" id="{4B881471-FF67-4400-BB68-157F40B23126}"/>
                </a:ext>
              </a:extLst>
            </p:cNvPr>
            <p:cNvSpPr txBox="1"/>
            <p:nvPr/>
          </p:nvSpPr>
          <p:spPr>
            <a:xfrm>
              <a:off x="3905195" y="1513673"/>
              <a:ext cx="313417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−</a:t>
              </a:r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2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6" name="グループ化 15">
            <a:extLst>
              <a:ext uri="{FF2B5EF4-FFF2-40B4-BE49-F238E27FC236}">
                <a16:creationId xmlns:a16="http://schemas.microsoft.com/office/drawing/2014/main" id="{B993CF61-7C51-4103-B6EC-1B08611A8C58}"/>
              </a:ext>
            </a:extLst>
          </p:cNvPr>
          <p:cNvGrpSpPr/>
          <p:nvPr/>
        </p:nvGrpSpPr>
        <p:grpSpPr>
          <a:xfrm>
            <a:off x="5889438" y="3271834"/>
            <a:ext cx="1656184" cy="1322726"/>
            <a:chOff x="5889438" y="3271834"/>
            <a:chExt cx="1656184" cy="1322726"/>
          </a:xfrm>
        </p:grpSpPr>
        <p:graphicFrame>
          <p:nvGraphicFramePr>
            <p:cNvPr id="203" name="グラフ 202">
              <a:extLst>
                <a:ext uri="{FF2B5EF4-FFF2-40B4-BE49-F238E27FC236}">
                  <a16:creationId xmlns:a16="http://schemas.microsoft.com/office/drawing/2014/main" id="{66B028DD-37F9-4778-81DC-F3028C748A3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019845372"/>
                </p:ext>
              </p:extLst>
            </p:nvPr>
          </p:nvGraphicFramePr>
          <p:xfrm>
            <a:off x="5889438" y="3271834"/>
            <a:ext cx="1656184" cy="132272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204" name="テキスト ボックス 203">
              <a:extLst>
                <a:ext uri="{FF2B5EF4-FFF2-40B4-BE49-F238E27FC236}">
                  <a16:creationId xmlns:a16="http://schemas.microsoft.com/office/drawing/2014/main" id="{0802CD19-DB20-49F2-A6BB-6A8C3D0ABCD6}"/>
                </a:ext>
              </a:extLst>
            </p:cNvPr>
            <p:cNvSpPr txBox="1"/>
            <p:nvPr/>
          </p:nvSpPr>
          <p:spPr>
            <a:xfrm>
              <a:off x="6668243" y="4182677"/>
              <a:ext cx="11963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5" name="テキスト ボックス 204">
              <a:extLst>
                <a:ext uri="{FF2B5EF4-FFF2-40B4-BE49-F238E27FC236}">
                  <a16:creationId xmlns:a16="http://schemas.microsoft.com/office/drawing/2014/main" id="{17160D7E-FD91-4AD5-8210-857F5E7A9BD5}"/>
                </a:ext>
              </a:extLst>
            </p:cNvPr>
            <p:cNvSpPr txBox="1"/>
            <p:nvPr/>
          </p:nvSpPr>
          <p:spPr>
            <a:xfrm>
              <a:off x="6953022" y="4182677"/>
              <a:ext cx="15782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6" name="テキスト ボックス 205">
              <a:extLst>
                <a:ext uri="{FF2B5EF4-FFF2-40B4-BE49-F238E27FC236}">
                  <a16:creationId xmlns:a16="http://schemas.microsoft.com/office/drawing/2014/main" id="{2282024B-C8B5-4EB0-AD3F-F981B7E23CB3}"/>
                </a:ext>
              </a:extLst>
            </p:cNvPr>
            <p:cNvSpPr txBox="1"/>
            <p:nvPr/>
          </p:nvSpPr>
          <p:spPr>
            <a:xfrm>
              <a:off x="7182856" y="4182677"/>
              <a:ext cx="26239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7" name="テキスト ボックス 206">
              <a:extLst>
                <a:ext uri="{FF2B5EF4-FFF2-40B4-BE49-F238E27FC236}">
                  <a16:creationId xmlns:a16="http://schemas.microsoft.com/office/drawing/2014/main" id="{0A527773-E1A2-4E82-BAFC-43C6DFAC76E0}"/>
                </a:ext>
              </a:extLst>
            </p:cNvPr>
            <p:cNvSpPr txBox="1"/>
            <p:nvPr/>
          </p:nvSpPr>
          <p:spPr>
            <a:xfrm>
              <a:off x="6381458" y="4182677"/>
              <a:ext cx="26239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−</a:t>
              </a:r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8" name="テキスト ボックス 207">
              <a:extLst>
                <a:ext uri="{FF2B5EF4-FFF2-40B4-BE49-F238E27FC236}">
                  <a16:creationId xmlns:a16="http://schemas.microsoft.com/office/drawing/2014/main" id="{A0B6099F-3D33-4E27-A28A-6CC8393BC4D9}"/>
                </a:ext>
              </a:extLst>
            </p:cNvPr>
            <p:cNvSpPr txBox="1"/>
            <p:nvPr/>
          </p:nvSpPr>
          <p:spPr>
            <a:xfrm>
              <a:off x="6067793" y="4182677"/>
              <a:ext cx="313417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−</a:t>
              </a:r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2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38" name="グループ化 237">
            <a:extLst>
              <a:ext uri="{FF2B5EF4-FFF2-40B4-BE49-F238E27FC236}">
                <a16:creationId xmlns:a16="http://schemas.microsoft.com/office/drawing/2014/main" id="{244B0FFD-3C66-415C-ABFB-316E6B40E8D4}"/>
              </a:ext>
            </a:extLst>
          </p:cNvPr>
          <p:cNvGrpSpPr/>
          <p:nvPr/>
        </p:nvGrpSpPr>
        <p:grpSpPr>
          <a:xfrm>
            <a:off x="5700214" y="2038918"/>
            <a:ext cx="1815459" cy="1318772"/>
            <a:chOff x="3628096" y="1880907"/>
            <a:chExt cx="1694619" cy="1318772"/>
          </a:xfrm>
        </p:grpSpPr>
        <p:graphicFrame>
          <p:nvGraphicFramePr>
            <p:cNvPr id="240" name="グラフ 239">
              <a:extLst>
                <a:ext uri="{FF2B5EF4-FFF2-40B4-BE49-F238E27FC236}">
                  <a16:creationId xmlns:a16="http://schemas.microsoft.com/office/drawing/2014/main" id="{31063F1D-5182-4B03-9B0C-07C71806D984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325941490"/>
                </p:ext>
              </p:extLst>
            </p:nvPr>
          </p:nvGraphicFramePr>
          <p:xfrm>
            <a:off x="3628096" y="1880907"/>
            <a:ext cx="1694619" cy="131877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241" name="テキスト ボックス 240">
              <a:extLst>
                <a:ext uri="{FF2B5EF4-FFF2-40B4-BE49-F238E27FC236}">
                  <a16:creationId xmlns:a16="http://schemas.microsoft.com/office/drawing/2014/main" id="{4D77AD86-80E1-4227-AF8A-DB28F5BA05FB}"/>
                </a:ext>
              </a:extLst>
            </p:cNvPr>
            <p:cNvSpPr txBox="1"/>
            <p:nvPr/>
          </p:nvSpPr>
          <p:spPr>
            <a:xfrm>
              <a:off x="4581399" y="2801301"/>
              <a:ext cx="11963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2" name="テキスト ボックス 241">
              <a:extLst>
                <a:ext uri="{FF2B5EF4-FFF2-40B4-BE49-F238E27FC236}">
                  <a16:creationId xmlns:a16="http://schemas.microsoft.com/office/drawing/2014/main" id="{39AD8013-BA82-4173-B2AD-5D56D2C65860}"/>
                </a:ext>
              </a:extLst>
            </p:cNvPr>
            <p:cNvSpPr txBox="1"/>
            <p:nvPr/>
          </p:nvSpPr>
          <p:spPr>
            <a:xfrm>
              <a:off x="4824292" y="2801301"/>
              <a:ext cx="15782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3" name="テキスト ボックス 242">
              <a:extLst>
                <a:ext uri="{FF2B5EF4-FFF2-40B4-BE49-F238E27FC236}">
                  <a16:creationId xmlns:a16="http://schemas.microsoft.com/office/drawing/2014/main" id="{E84401AF-9733-4715-BB65-E313432CCFF2}"/>
                </a:ext>
              </a:extLst>
            </p:cNvPr>
            <p:cNvSpPr txBox="1"/>
            <p:nvPr/>
          </p:nvSpPr>
          <p:spPr>
            <a:xfrm>
              <a:off x="5010250" y="2801301"/>
              <a:ext cx="26239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4" name="テキスト ボックス 243">
              <a:extLst>
                <a:ext uri="{FF2B5EF4-FFF2-40B4-BE49-F238E27FC236}">
                  <a16:creationId xmlns:a16="http://schemas.microsoft.com/office/drawing/2014/main" id="{C2C33936-FC31-4911-878C-14AADE6FBB5C}"/>
                </a:ext>
              </a:extLst>
            </p:cNvPr>
            <p:cNvSpPr txBox="1"/>
            <p:nvPr/>
          </p:nvSpPr>
          <p:spPr>
            <a:xfrm>
              <a:off x="4309462" y="2801301"/>
              <a:ext cx="26239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−</a:t>
              </a:r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5" name="テキスト ボックス 244">
              <a:extLst>
                <a:ext uri="{FF2B5EF4-FFF2-40B4-BE49-F238E27FC236}">
                  <a16:creationId xmlns:a16="http://schemas.microsoft.com/office/drawing/2014/main" id="{7DA8FB3C-9968-497F-A23F-03DB90D0C9A8}"/>
                </a:ext>
              </a:extLst>
            </p:cNvPr>
            <p:cNvSpPr txBox="1"/>
            <p:nvPr/>
          </p:nvSpPr>
          <p:spPr>
            <a:xfrm>
              <a:off x="3988136" y="2801301"/>
              <a:ext cx="313417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−</a:t>
              </a:r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2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57" name="グループ化 156">
            <a:extLst>
              <a:ext uri="{FF2B5EF4-FFF2-40B4-BE49-F238E27FC236}">
                <a16:creationId xmlns:a16="http://schemas.microsoft.com/office/drawing/2014/main" id="{E1B9FD43-D08C-431D-B1DD-B3DE34C4537C}"/>
              </a:ext>
            </a:extLst>
          </p:cNvPr>
          <p:cNvGrpSpPr/>
          <p:nvPr/>
        </p:nvGrpSpPr>
        <p:grpSpPr>
          <a:xfrm>
            <a:off x="928435" y="749795"/>
            <a:ext cx="1656184" cy="1367312"/>
            <a:chOff x="-1207373" y="582259"/>
            <a:chExt cx="1656184" cy="1367312"/>
          </a:xfrm>
        </p:grpSpPr>
        <p:graphicFrame>
          <p:nvGraphicFramePr>
            <p:cNvPr id="158" name="グラフ 157">
              <a:extLst>
                <a:ext uri="{FF2B5EF4-FFF2-40B4-BE49-F238E27FC236}">
                  <a16:creationId xmlns:a16="http://schemas.microsoft.com/office/drawing/2014/main" id="{A86D53E3-F83A-48EF-B7DA-15C08373D70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11620512"/>
                </p:ext>
              </p:extLst>
            </p:nvPr>
          </p:nvGraphicFramePr>
          <p:xfrm>
            <a:off x="-1207373" y="582259"/>
            <a:ext cx="1656184" cy="136731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159" name="テキスト ボックス 158">
              <a:extLst>
                <a:ext uri="{FF2B5EF4-FFF2-40B4-BE49-F238E27FC236}">
                  <a16:creationId xmlns:a16="http://schemas.microsoft.com/office/drawing/2014/main" id="{DF14CEA4-AEE2-4978-8FB3-CC6C6D5A29D3}"/>
                </a:ext>
              </a:extLst>
            </p:cNvPr>
            <p:cNvSpPr txBox="1"/>
            <p:nvPr/>
          </p:nvSpPr>
          <p:spPr>
            <a:xfrm>
              <a:off x="-262799" y="1492125"/>
              <a:ext cx="11711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0" name="テキスト ボックス 159">
              <a:extLst>
                <a:ext uri="{FF2B5EF4-FFF2-40B4-BE49-F238E27FC236}">
                  <a16:creationId xmlns:a16="http://schemas.microsoft.com/office/drawing/2014/main" id="{5920A195-D77D-4ADD-871A-3FAEDF1ABAAF}"/>
                </a:ext>
              </a:extLst>
            </p:cNvPr>
            <p:cNvSpPr txBox="1"/>
            <p:nvPr/>
          </p:nvSpPr>
          <p:spPr>
            <a:xfrm>
              <a:off x="-11002" y="1492125"/>
              <a:ext cx="11711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" name="テキスト ボックス 160">
              <a:extLst>
                <a:ext uri="{FF2B5EF4-FFF2-40B4-BE49-F238E27FC236}">
                  <a16:creationId xmlns:a16="http://schemas.microsoft.com/office/drawing/2014/main" id="{3F04AAE2-74CF-4C11-AFF0-543D5E6F8717}"/>
                </a:ext>
              </a:extLst>
            </p:cNvPr>
            <p:cNvSpPr txBox="1"/>
            <p:nvPr/>
          </p:nvSpPr>
          <p:spPr>
            <a:xfrm>
              <a:off x="163219" y="1492125"/>
              <a:ext cx="25688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" name="テキスト ボックス 161">
              <a:extLst>
                <a:ext uri="{FF2B5EF4-FFF2-40B4-BE49-F238E27FC236}">
                  <a16:creationId xmlns:a16="http://schemas.microsoft.com/office/drawing/2014/main" id="{81B99CFB-29A3-4C89-A529-360E8BABA293}"/>
                </a:ext>
              </a:extLst>
            </p:cNvPr>
            <p:cNvSpPr txBox="1"/>
            <p:nvPr/>
          </p:nvSpPr>
          <p:spPr>
            <a:xfrm>
              <a:off x="-642811" y="1492125"/>
              <a:ext cx="30682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−</a:t>
              </a:r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" name="テキスト ボックス 162">
              <a:extLst>
                <a:ext uri="{FF2B5EF4-FFF2-40B4-BE49-F238E27FC236}">
                  <a16:creationId xmlns:a16="http://schemas.microsoft.com/office/drawing/2014/main" id="{3BFAC2C9-34D9-48AD-854B-C1A414D2933E}"/>
                </a:ext>
              </a:extLst>
            </p:cNvPr>
            <p:cNvSpPr txBox="1"/>
            <p:nvPr/>
          </p:nvSpPr>
          <p:spPr>
            <a:xfrm>
              <a:off x="-886574" y="1493102"/>
              <a:ext cx="30682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−</a:t>
              </a:r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7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0" name="グループ化 9">
            <a:extLst>
              <a:ext uri="{FF2B5EF4-FFF2-40B4-BE49-F238E27FC236}">
                <a16:creationId xmlns:a16="http://schemas.microsoft.com/office/drawing/2014/main" id="{D10B65A6-B7F2-4CC8-9B23-8DD22B70097A}"/>
              </a:ext>
            </a:extLst>
          </p:cNvPr>
          <p:cNvGrpSpPr/>
          <p:nvPr/>
        </p:nvGrpSpPr>
        <p:grpSpPr>
          <a:xfrm>
            <a:off x="982664" y="3180794"/>
            <a:ext cx="1656184" cy="1367312"/>
            <a:chOff x="982664" y="3189086"/>
            <a:chExt cx="1656184" cy="1367312"/>
          </a:xfrm>
        </p:grpSpPr>
        <p:graphicFrame>
          <p:nvGraphicFramePr>
            <p:cNvPr id="185" name="グラフ 184">
              <a:extLst>
                <a:ext uri="{FF2B5EF4-FFF2-40B4-BE49-F238E27FC236}">
                  <a16:creationId xmlns:a16="http://schemas.microsoft.com/office/drawing/2014/main" id="{B61A9DB8-44E9-47FD-96F9-16518CB7028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384072967"/>
                </p:ext>
              </p:extLst>
            </p:nvPr>
          </p:nvGraphicFramePr>
          <p:xfrm>
            <a:off x="982664" y="3189086"/>
            <a:ext cx="1656184" cy="136731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186" name="テキスト ボックス 185">
              <a:extLst>
                <a:ext uri="{FF2B5EF4-FFF2-40B4-BE49-F238E27FC236}">
                  <a16:creationId xmlns:a16="http://schemas.microsoft.com/office/drawing/2014/main" id="{C5AC0A60-5888-4CAE-BF52-08B5904C8587}"/>
                </a:ext>
              </a:extLst>
            </p:cNvPr>
            <p:cNvSpPr txBox="1"/>
            <p:nvPr/>
          </p:nvSpPr>
          <p:spPr>
            <a:xfrm>
              <a:off x="1945304" y="4161154"/>
              <a:ext cx="11711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7" name="テキスト ボックス 186">
              <a:extLst>
                <a:ext uri="{FF2B5EF4-FFF2-40B4-BE49-F238E27FC236}">
                  <a16:creationId xmlns:a16="http://schemas.microsoft.com/office/drawing/2014/main" id="{E832913E-0367-44DB-A4E0-627E8C0F1049}"/>
                </a:ext>
              </a:extLst>
            </p:cNvPr>
            <p:cNvSpPr txBox="1"/>
            <p:nvPr/>
          </p:nvSpPr>
          <p:spPr>
            <a:xfrm>
              <a:off x="2196212" y="4161153"/>
              <a:ext cx="11711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8" name="テキスト ボックス 187">
              <a:extLst>
                <a:ext uri="{FF2B5EF4-FFF2-40B4-BE49-F238E27FC236}">
                  <a16:creationId xmlns:a16="http://schemas.microsoft.com/office/drawing/2014/main" id="{CF25B6D6-43B1-49C8-87EC-41D34E834645}"/>
                </a:ext>
              </a:extLst>
            </p:cNvPr>
            <p:cNvSpPr txBox="1"/>
            <p:nvPr/>
          </p:nvSpPr>
          <p:spPr>
            <a:xfrm>
              <a:off x="2355902" y="4161153"/>
              <a:ext cx="25688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9" name="テキスト ボックス 188">
              <a:extLst>
                <a:ext uri="{FF2B5EF4-FFF2-40B4-BE49-F238E27FC236}">
                  <a16:creationId xmlns:a16="http://schemas.microsoft.com/office/drawing/2014/main" id="{9648D695-15BE-4F30-A6D2-D10B371E1412}"/>
                </a:ext>
              </a:extLst>
            </p:cNvPr>
            <p:cNvSpPr txBox="1"/>
            <p:nvPr/>
          </p:nvSpPr>
          <p:spPr>
            <a:xfrm>
              <a:off x="1510056" y="4161154"/>
              <a:ext cx="30682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−</a:t>
              </a:r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0" name="テキスト ボックス 189">
              <a:extLst>
                <a:ext uri="{FF2B5EF4-FFF2-40B4-BE49-F238E27FC236}">
                  <a16:creationId xmlns:a16="http://schemas.microsoft.com/office/drawing/2014/main" id="{A510BB8F-5E5E-4B3F-A3C2-61F589909377}"/>
                </a:ext>
              </a:extLst>
            </p:cNvPr>
            <p:cNvSpPr txBox="1"/>
            <p:nvPr/>
          </p:nvSpPr>
          <p:spPr>
            <a:xfrm>
              <a:off x="1268050" y="4161154"/>
              <a:ext cx="30682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−</a:t>
              </a:r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7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9" name="グループ化 8">
            <a:extLst>
              <a:ext uri="{FF2B5EF4-FFF2-40B4-BE49-F238E27FC236}">
                <a16:creationId xmlns:a16="http://schemas.microsoft.com/office/drawing/2014/main" id="{9D2128F1-42F6-44D8-B0FB-56D5DEC35194}"/>
              </a:ext>
            </a:extLst>
          </p:cNvPr>
          <p:cNvGrpSpPr/>
          <p:nvPr/>
        </p:nvGrpSpPr>
        <p:grpSpPr>
          <a:xfrm>
            <a:off x="890619" y="2011959"/>
            <a:ext cx="1663836" cy="1324783"/>
            <a:chOff x="890619" y="1991463"/>
            <a:chExt cx="1663836" cy="1324783"/>
          </a:xfrm>
        </p:grpSpPr>
        <p:graphicFrame>
          <p:nvGraphicFramePr>
            <p:cNvPr id="217" name="グラフ 216">
              <a:extLst>
                <a:ext uri="{FF2B5EF4-FFF2-40B4-BE49-F238E27FC236}">
                  <a16:creationId xmlns:a16="http://schemas.microsoft.com/office/drawing/2014/main" id="{F2339E47-07AD-45AA-BEF4-7661370D79C3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335865782"/>
                </p:ext>
              </p:extLst>
            </p:nvPr>
          </p:nvGraphicFramePr>
          <p:xfrm>
            <a:off x="890619" y="1991463"/>
            <a:ext cx="1663836" cy="132478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218" name="テキスト ボックス 217">
              <a:extLst>
                <a:ext uri="{FF2B5EF4-FFF2-40B4-BE49-F238E27FC236}">
                  <a16:creationId xmlns:a16="http://schemas.microsoft.com/office/drawing/2014/main" id="{6E2FC8FE-C6EA-483A-A9DB-B44BD2D1ECBD}"/>
                </a:ext>
              </a:extLst>
            </p:cNvPr>
            <p:cNvSpPr txBox="1"/>
            <p:nvPr/>
          </p:nvSpPr>
          <p:spPr>
            <a:xfrm>
              <a:off x="1874505" y="2911620"/>
              <a:ext cx="11711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9" name="テキスト ボックス 218">
              <a:extLst>
                <a:ext uri="{FF2B5EF4-FFF2-40B4-BE49-F238E27FC236}">
                  <a16:creationId xmlns:a16="http://schemas.microsoft.com/office/drawing/2014/main" id="{7BA7E90C-CDFA-4D95-BD5D-9FD18C203E0D}"/>
                </a:ext>
              </a:extLst>
            </p:cNvPr>
            <p:cNvSpPr txBox="1"/>
            <p:nvPr/>
          </p:nvSpPr>
          <p:spPr>
            <a:xfrm>
              <a:off x="2106974" y="2911620"/>
              <a:ext cx="11711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0" name="テキスト ボックス 219">
              <a:extLst>
                <a:ext uri="{FF2B5EF4-FFF2-40B4-BE49-F238E27FC236}">
                  <a16:creationId xmlns:a16="http://schemas.microsoft.com/office/drawing/2014/main" id="{92257C1A-99E4-41E4-B264-77A5B85FE380}"/>
                </a:ext>
              </a:extLst>
            </p:cNvPr>
            <p:cNvSpPr txBox="1"/>
            <p:nvPr/>
          </p:nvSpPr>
          <p:spPr>
            <a:xfrm>
              <a:off x="2266664" y="2911620"/>
              <a:ext cx="25688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1" name="テキスト ボックス 220">
              <a:extLst>
                <a:ext uri="{FF2B5EF4-FFF2-40B4-BE49-F238E27FC236}">
                  <a16:creationId xmlns:a16="http://schemas.microsoft.com/office/drawing/2014/main" id="{9757DC2E-69DF-46DE-BA01-99020B17ADBA}"/>
                </a:ext>
              </a:extLst>
            </p:cNvPr>
            <p:cNvSpPr txBox="1"/>
            <p:nvPr/>
          </p:nvSpPr>
          <p:spPr>
            <a:xfrm>
              <a:off x="1459246" y="2911620"/>
              <a:ext cx="30682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−</a:t>
              </a:r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2" name="テキスト ボックス 221">
              <a:extLst>
                <a:ext uri="{FF2B5EF4-FFF2-40B4-BE49-F238E27FC236}">
                  <a16:creationId xmlns:a16="http://schemas.microsoft.com/office/drawing/2014/main" id="{693E926A-053B-48C5-BA4D-1F8C6FD17E34}"/>
                </a:ext>
              </a:extLst>
            </p:cNvPr>
            <p:cNvSpPr txBox="1"/>
            <p:nvPr/>
          </p:nvSpPr>
          <p:spPr>
            <a:xfrm>
              <a:off x="1217469" y="2911620"/>
              <a:ext cx="30682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−</a:t>
              </a:r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7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8" name="グループ化 17">
            <a:extLst>
              <a:ext uri="{FF2B5EF4-FFF2-40B4-BE49-F238E27FC236}">
                <a16:creationId xmlns:a16="http://schemas.microsoft.com/office/drawing/2014/main" id="{0E2D5BCA-DA66-4B1C-B91E-6C1E250891FF}"/>
              </a:ext>
            </a:extLst>
          </p:cNvPr>
          <p:cNvGrpSpPr/>
          <p:nvPr/>
        </p:nvGrpSpPr>
        <p:grpSpPr>
          <a:xfrm>
            <a:off x="961209" y="4393423"/>
            <a:ext cx="1656184" cy="1367312"/>
            <a:chOff x="961209" y="4393423"/>
            <a:chExt cx="1656184" cy="1367312"/>
          </a:xfrm>
        </p:grpSpPr>
        <p:graphicFrame>
          <p:nvGraphicFramePr>
            <p:cNvPr id="250" name="グラフ 249">
              <a:extLst>
                <a:ext uri="{FF2B5EF4-FFF2-40B4-BE49-F238E27FC236}">
                  <a16:creationId xmlns:a16="http://schemas.microsoft.com/office/drawing/2014/main" id="{6EAD10FA-D65A-49A6-95B9-4321DC2B44BE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728771266"/>
                </p:ext>
              </p:extLst>
            </p:nvPr>
          </p:nvGraphicFramePr>
          <p:xfrm>
            <a:off x="961209" y="4393423"/>
            <a:ext cx="1656184" cy="136731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sp>
          <p:nvSpPr>
            <p:cNvPr id="251" name="テキスト ボックス 250">
              <a:extLst>
                <a:ext uri="{FF2B5EF4-FFF2-40B4-BE49-F238E27FC236}">
                  <a16:creationId xmlns:a16="http://schemas.microsoft.com/office/drawing/2014/main" id="{327858A6-8BD7-4702-AA64-66C7353FDB49}"/>
                </a:ext>
              </a:extLst>
            </p:cNvPr>
            <p:cNvSpPr txBox="1"/>
            <p:nvPr/>
          </p:nvSpPr>
          <p:spPr>
            <a:xfrm>
              <a:off x="1912099" y="5357718"/>
              <a:ext cx="11711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2" name="テキスト ボックス 251">
              <a:extLst>
                <a:ext uri="{FF2B5EF4-FFF2-40B4-BE49-F238E27FC236}">
                  <a16:creationId xmlns:a16="http://schemas.microsoft.com/office/drawing/2014/main" id="{E8FBFB14-E75E-456B-9C75-31B9CC63A5DA}"/>
                </a:ext>
              </a:extLst>
            </p:cNvPr>
            <p:cNvSpPr txBox="1"/>
            <p:nvPr/>
          </p:nvSpPr>
          <p:spPr>
            <a:xfrm>
              <a:off x="2163007" y="5357717"/>
              <a:ext cx="11711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3" name="テキスト ボックス 252">
              <a:extLst>
                <a:ext uri="{FF2B5EF4-FFF2-40B4-BE49-F238E27FC236}">
                  <a16:creationId xmlns:a16="http://schemas.microsoft.com/office/drawing/2014/main" id="{72C8FA85-0255-487E-B937-100177028455}"/>
                </a:ext>
              </a:extLst>
            </p:cNvPr>
            <p:cNvSpPr txBox="1"/>
            <p:nvPr/>
          </p:nvSpPr>
          <p:spPr>
            <a:xfrm>
              <a:off x="2322697" y="5357717"/>
              <a:ext cx="25688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4" name="テキスト ボックス 253">
              <a:extLst>
                <a:ext uri="{FF2B5EF4-FFF2-40B4-BE49-F238E27FC236}">
                  <a16:creationId xmlns:a16="http://schemas.microsoft.com/office/drawing/2014/main" id="{5B779BCD-4354-4A05-BD9D-BDB6B012E7E3}"/>
                </a:ext>
              </a:extLst>
            </p:cNvPr>
            <p:cNvSpPr txBox="1"/>
            <p:nvPr/>
          </p:nvSpPr>
          <p:spPr>
            <a:xfrm>
              <a:off x="1476851" y="5357718"/>
              <a:ext cx="30682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−</a:t>
              </a:r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5" name="テキスト ボックス 254">
              <a:extLst>
                <a:ext uri="{FF2B5EF4-FFF2-40B4-BE49-F238E27FC236}">
                  <a16:creationId xmlns:a16="http://schemas.microsoft.com/office/drawing/2014/main" id="{15D5D17E-E35D-4A87-852A-87B5DE35D7ED}"/>
                </a:ext>
              </a:extLst>
            </p:cNvPr>
            <p:cNvSpPr txBox="1"/>
            <p:nvPr/>
          </p:nvSpPr>
          <p:spPr>
            <a:xfrm>
              <a:off x="1234845" y="5357718"/>
              <a:ext cx="30682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−</a:t>
              </a:r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7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9A958313-3D83-40CD-9200-C980C5416034}"/>
              </a:ext>
            </a:extLst>
          </p:cNvPr>
          <p:cNvGrpSpPr/>
          <p:nvPr/>
        </p:nvGrpSpPr>
        <p:grpSpPr>
          <a:xfrm>
            <a:off x="2540544" y="721534"/>
            <a:ext cx="1701335" cy="5066565"/>
            <a:chOff x="2623094" y="746758"/>
            <a:chExt cx="1701335" cy="5066565"/>
          </a:xfrm>
        </p:grpSpPr>
        <p:grpSp>
          <p:nvGrpSpPr>
            <p:cNvPr id="164" name="グループ化 163">
              <a:extLst>
                <a:ext uri="{FF2B5EF4-FFF2-40B4-BE49-F238E27FC236}">
                  <a16:creationId xmlns:a16="http://schemas.microsoft.com/office/drawing/2014/main" id="{C53FA3F6-E1FF-4946-B6F7-ACE8DB30211B}"/>
                </a:ext>
              </a:extLst>
            </p:cNvPr>
            <p:cNvGrpSpPr/>
            <p:nvPr/>
          </p:nvGrpSpPr>
          <p:grpSpPr>
            <a:xfrm>
              <a:off x="2635419" y="746758"/>
              <a:ext cx="1656184" cy="1367313"/>
              <a:chOff x="448811" y="553998"/>
              <a:chExt cx="1656184" cy="1367313"/>
            </a:xfrm>
          </p:grpSpPr>
          <p:graphicFrame>
            <p:nvGraphicFramePr>
              <p:cNvPr id="165" name="グラフ 164">
                <a:extLst>
                  <a:ext uri="{FF2B5EF4-FFF2-40B4-BE49-F238E27FC236}">
                    <a16:creationId xmlns:a16="http://schemas.microsoft.com/office/drawing/2014/main" id="{5F045005-E219-4875-ADE8-EA8B36B2231C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795310691"/>
                  </p:ext>
                </p:extLst>
              </p:nvPr>
            </p:nvGraphicFramePr>
            <p:xfrm>
              <a:off x="448811" y="553998"/>
              <a:ext cx="1656184" cy="1367313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9"/>
              </a:graphicData>
            </a:graphic>
          </p:graphicFrame>
          <p:sp>
            <p:nvSpPr>
              <p:cNvPr id="166" name="テキスト ボックス 165">
                <a:extLst>
                  <a:ext uri="{FF2B5EF4-FFF2-40B4-BE49-F238E27FC236}">
                    <a16:creationId xmlns:a16="http://schemas.microsoft.com/office/drawing/2014/main" id="{8B442921-0E25-49E0-A975-B8BA362AFDCF}"/>
                  </a:ext>
                </a:extLst>
              </p:cNvPr>
              <p:cNvSpPr txBox="1"/>
              <p:nvPr/>
            </p:nvSpPr>
            <p:spPr>
              <a:xfrm>
                <a:off x="1403695" y="1500055"/>
                <a:ext cx="11974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7" name="テキスト ボックス 166">
                <a:extLst>
                  <a:ext uri="{FF2B5EF4-FFF2-40B4-BE49-F238E27FC236}">
                    <a16:creationId xmlns:a16="http://schemas.microsoft.com/office/drawing/2014/main" id="{F074A7D3-08BF-43C7-903B-0F436E5E533B}"/>
                  </a:ext>
                </a:extLst>
              </p:cNvPr>
              <p:cNvSpPr txBox="1"/>
              <p:nvPr/>
            </p:nvSpPr>
            <p:spPr>
              <a:xfrm>
                <a:off x="1636192" y="1500055"/>
                <a:ext cx="11974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</a:t>
                </a:r>
                <a:endPara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8" name="テキスト ボックス 167">
                <a:extLst>
                  <a:ext uri="{FF2B5EF4-FFF2-40B4-BE49-F238E27FC236}">
                    <a16:creationId xmlns:a16="http://schemas.microsoft.com/office/drawing/2014/main" id="{9032340E-4F8B-450B-8C78-AE54C40B2066}"/>
                  </a:ext>
                </a:extLst>
              </p:cNvPr>
              <p:cNvSpPr txBox="1"/>
              <p:nvPr/>
            </p:nvSpPr>
            <p:spPr>
              <a:xfrm>
                <a:off x="1799315" y="1500055"/>
                <a:ext cx="262647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4</a:t>
                </a:r>
                <a:endPara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9" name="テキスト ボックス 168">
                <a:extLst>
                  <a:ext uri="{FF2B5EF4-FFF2-40B4-BE49-F238E27FC236}">
                    <a16:creationId xmlns:a16="http://schemas.microsoft.com/office/drawing/2014/main" id="{A071BD76-4826-49B7-9626-72781101F724}"/>
                  </a:ext>
                </a:extLst>
              </p:cNvPr>
              <p:cNvSpPr txBox="1"/>
              <p:nvPr/>
            </p:nvSpPr>
            <p:spPr>
              <a:xfrm>
                <a:off x="1006925" y="1500055"/>
                <a:ext cx="30157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ja-JP" altLang="en-US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−</a:t>
                </a:r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</a:t>
                </a:r>
                <a:endPara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0" name="テキスト ボックス 169">
                <a:extLst>
                  <a:ext uri="{FF2B5EF4-FFF2-40B4-BE49-F238E27FC236}">
                    <a16:creationId xmlns:a16="http://schemas.microsoft.com/office/drawing/2014/main" id="{98D6FF27-44E9-434E-B4DE-B2E3680CA687}"/>
                  </a:ext>
                </a:extLst>
              </p:cNvPr>
              <p:cNvSpPr txBox="1"/>
              <p:nvPr/>
            </p:nvSpPr>
            <p:spPr>
              <a:xfrm>
                <a:off x="779970" y="1500055"/>
                <a:ext cx="293727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ja-JP" altLang="en-US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−</a:t>
                </a:r>
                <a:r>
                  <a:rPr kumimoji="1" lang="en-US" altLang="ja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6</a:t>
                </a:r>
                <a:endPara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aphicFrame>
          <p:nvGraphicFramePr>
            <p:cNvPr id="191" name="グラフ 190">
              <a:extLst>
                <a:ext uri="{FF2B5EF4-FFF2-40B4-BE49-F238E27FC236}">
                  <a16:creationId xmlns:a16="http://schemas.microsoft.com/office/drawing/2014/main" id="{06D92484-6432-4C61-AEF9-A73665EDFD21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898642370"/>
                </p:ext>
              </p:extLst>
            </p:nvPr>
          </p:nvGraphicFramePr>
          <p:xfrm>
            <a:off x="2663582" y="3207089"/>
            <a:ext cx="1660847" cy="136731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0"/>
            </a:graphicData>
          </a:graphic>
        </p:graphicFrame>
        <p:sp>
          <p:nvSpPr>
            <p:cNvPr id="192" name="テキスト ボックス 191">
              <a:extLst>
                <a:ext uri="{FF2B5EF4-FFF2-40B4-BE49-F238E27FC236}">
                  <a16:creationId xmlns:a16="http://schemas.microsoft.com/office/drawing/2014/main" id="{BA6CF664-816D-4735-BDDE-D47B73D7AFB2}"/>
                </a:ext>
              </a:extLst>
            </p:cNvPr>
            <p:cNvSpPr txBox="1"/>
            <p:nvPr/>
          </p:nvSpPr>
          <p:spPr>
            <a:xfrm>
              <a:off x="3597201" y="4178174"/>
              <a:ext cx="11974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3" name="テキスト ボックス 192">
              <a:extLst>
                <a:ext uri="{FF2B5EF4-FFF2-40B4-BE49-F238E27FC236}">
                  <a16:creationId xmlns:a16="http://schemas.microsoft.com/office/drawing/2014/main" id="{F9D388E4-CAD6-4880-90AD-2B2581D5EB0E}"/>
                </a:ext>
              </a:extLst>
            </p:cNvPr>
            <p:cNvSpPr txBox="1"/>
            <p:nvPr/>
          </p:nvSpPr>
          <p:spPr>
            <a:xfrm>
              <a:off x="3844516" y="4178174"/>
              <a:ext cx="11974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4" name="テキスト ボックス 193">
              <a:extLst>
                <a:ext uri="{FF2B5EF4-FFF2-40B4-BE49-F238E27FC236}">
                  <a16:creationId xmlns:a16="http://schemas.microsoft.com/office/drawing/2014/main" id="{EA83CB7D-2BBA-4E53-A4CF-5152A7C8CCAB}"/>
                </a:ext>
              </a:extLst>
            </p:cNvPr>
            <p:cNvSpPr txBox="1"/>
            <p:nvPr/>
          </p:nvSpPr>
          <p:spPr>
            <a:xfrm>
              <a:off x="4020610" y="4178174"/>
              <a:ext cx="26264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5" name="テキスト ボックス 194">
              <a:extLst>
                <a:ext uri="{FF2B5EF4-FFF2-40B4-BE49-F238E27FC236}">
                  <a16:creationId xmlns:a16="http://schemas.microsoft.com/office/drawing/2014/main" id="{984545F1-3A6D-40AB-8611-762DE6C96A84}"/>
                </a:ext>
              </a:extLst>
            </p:cNvPr>
            <p:cNvSpPr txBox="1"/>
            <p:nvPr/>
          </p:nvSpPr>
          <p:spPr>
            <a:xfrm>
              <a:off x="3191993" y="4178173"/>
              <a:ext cx="29213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−</a:t>
              </a:r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6" name="テキスト ボックス 195">
              <a:extLst>
                <a:ext uri="{FF2B5EF4-FFF2-40B4-BE49-F238E27FC236}">
                  <a16:creationId xmlns:a16="http://schemas.microsoft.com/office/drawing/2014/main" id="{91B54072-5D49-46BC-8B06-795C1D8A299F}"/>
                </a:ext>
              </a:extLst>
            </p:cNvPr>
            <p:cNvSpPr txBox="1"/>
            <p:nvPr/>
          </p:nvSpPr>
          <p:spPr>
            <a:xfrm>
              <a:off x="2935113" y="4178174"/>
              <a:ext cx="31371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−</a:t>
              </a:r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6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223" name="グラフ 222">
              <a:extLst>
                <a:ext uri="{FF2B5EF4-FFF2-40B4-BE49-F238E27FC236}">
                  <a16:creationId xmlns:a16="http://schemas.microsoft.com/office/drawing/2014/main" id="{9706F61B-CE4D-425B-86A7-A102B2B7C09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155630870"/>
                </p:ext>
              </p:extLst>
            </p:nvPr>
          </p:nvGraphicFramePr>
          <p:xfrm>
            <a:off x="2623094" y="2046101"/>
            <a:ext cx="1681388" cy="132162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1"/>
            </a:graphicData>
          </a:graphic>
        </p:graphicFrame>
        <p:sp>
          <p:nvSpPr>
            <p:cNvPr id="224" name="テキスト ボックス 223">
              <a:extLst>
                <a:ext uri="{FF2B5EF4-FFF2-40B4-BE49-F238E27FC236}">
                  <a16:creationId xmlns:a16="http://schemas.microsoft.com/office/drawing/2014/main" id="{F3759522-E82F-4BB7-B97A-7856EDAFD59E}"/>
                </a:ext>
              </a:extLst>
            </p:cNvPr>
            <p:cNvSpPr txBox="1"/>
            <p:nvPr/>
          </p:nvSpPr>
          <p:spPr>
            <a:xfrm>
              <a:off x="3597846" y="2968290"/>
              <a:ext cx="11974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5" name="テキスト ボックス 224">
              <a:extLst>
                <a:ext uri="{FF2B5EF4-FFF2-40B4-BE49-F238E27FC236}">
                  <a16:creationId xmlns:a16="http://schemas.microsoft.com/office/drawing/2014/main" id="{7E247AD8-CFD4-4053-AF13-FE53C42E37FC}"/>
                </a:ext>
              </a:extLst>
            </p:cNvPr>
            <p:cNvSpPr txBox="1"/>
            <p:nvPr/>
          </p:nvSpPr>
          <p:spPr>
            <a:xfrm>
              <a:off x="3831788" y="2968290"/>
              <a:ext cx="11974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6" name="テキスト ボックス 225">
              <a:extLst>
                <a:ext uri="{FF2B5EF4-FFF2-40B4-BE49-F238E27FC236}">
                  <a16:creationId xmlns:a16="http://schemas.microsoft.com/office/drawing/2014/main" id="{528C8A2D-7D0A-44A3-A870-B07DF8E97DEA}"/>
                </a:ext>
              </a:extLst>
            </p:cNvPr>
            <p:cNvSpPr txBox="1"/>
            <p:nvPr/>
          </p:nvSpPr>
          <p:spPr>
            <a:xfrm>
              <a:off x="3998362" y="2968290"/>
              <a:ext cx="248567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7" name="テキスト ボックス 226">
              <a:extLst>
                <a:ext uri="{FF2B5EF4-FFF2-40B4-BE49-F238E27FC236}">
                  <a16:creationId xmlns:a16="http://schemas.microsoft.com/office/drawing/2014/main" id="{C799317E-A908-4D46-8C5B-32C889D7E8F9}"/>
                </a:ext>
              </a:extLst>
            </p:cNvPr>
            <p:cNvSpPr txBox="1"/>
            <p:nvPr/>
          </p:nvSpPr>
          <p:spPr>
            <a:xfrm>
              <a:off x="3216038" y="2968290"/>
              <a:ext cx="277207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−</a:t>
              </a:r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8" name="テキスト ボックス 227">
              <a:extLst>
                <a:ext uri="{FF2B5EF4-FFF2-40B4-BE49-F238E27FC236}">
                  <a16:creationId xmlns:a16="http://schemas.microsoft.com/office/drawing/2014/main" id="{6C09E27F-C500-4772-BA11-356F2BDD671E}"/>
                </a:ext>
              </a:extLst>
            </p:cNvPr>
            <p:cNvSpPr txBox="1"/>
            <p:nvPr/>
          </p:nvSpPr>
          <p:spPr>
            <a:xfrm>
              <a:off x="2962334" y="2968290"/>
              <a:ext cx="31371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−</a:t>
              </a:r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6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256" name="グラフ 255">
              <a:extLst>
                <a:ext uri="{FF2B5EF4-FFF2-40B4-BE49-F238E27FC236}">
                  <a16:creationId xmlns:a16="http://schemas.microsoft.com/office/drawing/2014/main" id="{BBDA184A-E404-48FA-9F5C-72665BA84AB7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730498592"/>
                </p:ext>
              </p:extLst>
            </p:nvPr>
          </p:nvGraphicFramePr>
          <p:xfrm>
            <a:off x="2649148" y="4446010"/>
            <a:ext cx="1650292" cy="136731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2"/>
            </a:graphicData>
          </a:graphic>
        </p:graphicFrame>
        <p:sp>
          <p:nvSpPr>
            <p:cNvPr id="257" name="テキスト ボックス 256">
              <a:extLst>
                <a:ext uri="{FF2B5EF4-FFF2-40B4-BE49-F238E27FC236}">
                  <a16:creationId xmlns:a16="http://schemas.microsoft.com/office/drawing/2014/main" id="{8FCFDE26-2295-40CA-A3C8-754F571F9569}"/>
                </a:ext>
              </a:extLst>
            </p:cNvPr>
            <p:cNvSpPr txBox="1"/>
            <p:nvPr/>
          </p:nvSpPr>
          <p:spPr>
            <a:xfrm>
              <a:off x="3582997" y="5413969"/>
              <a:ext cx="11974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8" name="テキスト ボックス 257">
              <a:extLst>
                <a:ext uri="{FF2B5EF4-FFF2-40B4-BE49-F238E27FC236}">
                  <a16:creationId xmlns:a16="http://schemas.microsoft.com/office/drawing/2014/main" id="{3B39C3A2-0506-4D0D-B276-9D24574463D3}"/>
                </a:ext>
              </a:extLst>
            </p:cNvPr>
            <p:cNvSpPr txBox="1"/>
            <p:nvPr/>
          </p:nvSpPr>
          <p:spPr>
            <a:xfrm>
              <a:off x="3822561" y="5413969"/>
              <a:ext cx="11974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9" name="テキスト ボックス 258">
              <a:extLst>
                <a:ext uri="{FF2B5EF4-FFF2-40B4-BE49-F238E27FC236}">
                  <a16:creationId xmlns:a16="http://schemas.microsoft.com/office/drawing/2014/main" id="{E9C70C97-57B9-4EE5-9B83-7F8E0C5A8374}"/>
                </a:ext>
              </a:extLst>
            </p:cNvPr>
            <p:cNvSpPr txBox="1"/>
            <p:nvPr/>
          </p:nvSpPr>
          <p:spPr>
            <a:xfrm>
              <a:off x="3993891" y="5413969"/>
              <a:ext cx="26264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0" name="テキスト ボックス 259">
              <a:extLst>
                <a:ext uri="{FF2B5EF4-FFF2-40B4-BE49-F238E27FC236}">
                  <a16:creationId xmlns:a16="http://schemas.microsoft.com/office/drawing/2014/main" id="{98069722-5013-4222-82CA-121717460469}"/>
                </a:ext>
              </a:extLst>
            </p:cNvPr>
            <p:cNvSpPr txBox="1"/>
            <p:nvPr/>
          </p:nvSpPr>
          <p:spPr>
            <a:xfrm>
              <a:off x="3174380" y="5416169"/>
              <a:ext cx="31371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−</a:t>
              </a:r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1" name="テキスト ボックス 260">
              <a:extLst>
                <a:ext uri="{FF2B5EF4-FFF2-40B4-BE49-F238E27FC236}">
                  <a16:creationId xmlns:a16="http://schemas.microsoft.com/office/drawing/2014/main" id="{54A10165-9D78-4D2D-B2FA-8C0B7425ED3F}"/>
                </a:ext>
              </a:extLst>
            </p:cNvPr>
            <p:cNvSpPr txBox="1"/>
            <p:nvPr/>
          </p:nvSpPr>
          <p:spPr>
            <a:xfrm>
              <a:off x="2941948" y="5413969"/>
              <a:ext cx="31371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−</a:t>
              </a:r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6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68" name="グループ化 267">
            <a:extLst>
              <a:ext uri="{FF2B5EF4-FFF2-40B4-BE49-F238E27FC236}">
                <a16:creationId xmlns:a16="http://schemas.microsoft.com/office/drawing/2014/main" id="{3D0D53C5-B584-405E-BA17-01CD6BE9D5F9}"/>
              </a:ext>
            </a:extLst>
          </p:cNvPr>
          <p:cNvGrpSpPr/>
          <p:nvPr/>
        </p:nvGrpSpPr>
        <p:grpSpPr>
          <a:xfrm>
            <a:off x="5727092" y="4462709"/>
            <a:ext cx="1759724" cy="1317320"/>
            <a:chOff x="3634033" y="4295173"/>
            <a:chExt cx="1696655" cy="1317320"/>
          </a:xfrm>
        </p:grpSpPr>
        <p:graphicFrame>
          <p:nvGraphicFramePr>
            <p:cNvPr id="270" name="グラフ 269">
              <a:extLst>
                <a:ext uri="{FF2B5EF4-FFF2-40B4-BE49-F238E27FC236}">
                  <a16:creationId xmlns:a16="http://schemas.microsoft.com/office/drawing/2014/main" id="{2DFF4885-54C5-45DA-81E1-ACA75356CE7E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090501627"/>
                </p:ext>
              </p:extLst>
            </p:nvPr>
          </p:nvGraphicFramePr>
          <p:xfrm>
            <a:off x="3634033" y="4295173"/>
            <a:ext cx="1696655" cy="131732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3"/>
            </a:graphicData>
          </a:graphic>
        </p:graphicFrame>
        <p:sp>
          <p:nvSpPr>
            <p:cNvPr id="271" name="テキスト ボックス 270">
              <a:extLst>
                <a:ext uri="{FF2B5EF4-FFF2-40B4-BE49-F238E27FC236}">
                  <a16:creationId xmlns:a16="http://schemas.microsoft.com/office/drawing/2014/main" id="{DA74ED6A-4B8E-4E3D-A239-3587E6B3D6CA}"/>
                </a:ext>
              </a:extLst>
            </p:cNvPr>
            <p:cNvSpPr txBox="1"/>
            <p:nvPr/>
          </p:nvSpPr>
          <p:spPr>
            <a:xfrm>
              <a:off x="4545520" y="5219870"/>
              <a:ext cx="11963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2" name="テキスト ボックス 271">
              <a:extLst>
                <a:ext uri="{FF2B5EF4-FFF2-40B4-BE49-F238E27FC236}">
                  <a16:creationId xmlns:a16="http://schemas.microsoft.com/office/drawing/2014/main" id="{BC109208-BDC3-4FFD-8B82-C322183F632E}"/>
                </a:ext>
              </a:extLst>
            </p:cNvPr>
            <p:cNvSpPr txBox="1"/>
            <p:nvPr/>
          </p:nvSpPr>
          <p:spPr>
            <a:xfrm>
              <a:off x="4788413" y="5219870"/>
              <a:ext cx="15782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3" name="テキスト ボックス 272">
              <a:extLst>
                <a:ext uri="{FF2B5EF4-FFF2-40B4-BE49-F238E27FC236}">
                  <a16:creationId xmlns:a16="http://schemas.microsoft.com/office/drawing/2014/main" id="{7F5DEF64-4ACB-4208-A41A-FDCD9101EE1F}"/>
                </a:ext>
              </a:extLst>
            </p:cNvPr>
            <p:cNvSpPr txBox="1"/>
            <p:nvPr/>
          </p:nvSpPr>
          <p:spPr>
            <a:xfrm>
              <a:off x="5019943" y="5219870"/>
              <a:ext cx="26239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4" name="テキスト ボックス 273">
              <a:extLst>
                <a:ext uri="{FF2B5EF4-FFF2-40B4-BE49-F238E27FC236}">
                  <a16:creationId xmlns:a16="http://schemas.microsoft.com/office/drawing/2014/main" id="{8D1470D4-A33B-412D-8E16-5C5460158A9B}"/>
                </a:ext>
              </a:extLst>
            </p:cNvPr>
            <p:cNvSpPr txBox="1"/>
            <p:nvPr/>
          </p:nvSpPr>
          <p:spPr>
            <a:xfrm>
              <a:off x="4273583" y="5219870"/>
              <a:ext cx="26239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−</a:t>
              </a:r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5" name="テキスト ボックス 274">
              <a:extLst>
                <a:ext uri="{FF2B5EF4-FFF2-40B4-BE49-F238E27FC236}">
                  <a16:creationId xmlns:a16="http://schemas.microsoft.com/office/drawing/2014/main" id="{8079BFBE-B2EF-40F6-A6DF-94BFA977FD9A}"/>
                </a:ext>
              </a:extLst>
            </p:cNvPr>
            <p:cNvSpPr txBox="1"/>
            <p:nvPr/>
          </p:nvSpPr>
          <p:spPr>
            <a:xfrm>
              <a:off x="3952257" y="5219870"/>
              <a:ext cx="313417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−</a:t>
              </a:r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2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2" name="グループ化 11">
            <a:extLst>
              <a:ext uri="{FF2B5EF4-FFF2-40B4-BE49-F238E27FC236}">
                <a16:creationId xmlns:a16="http://schemas.microsoft.com/office/drawing/2014/main" id="{36541772-1164-4173-ABF4-A504A338E005}"/>
              </a:ext>
            </a:extLst>
          </p:cNvPr>
          <p:cNvGrpSpPr/>
          <p:nvPr/>
        </p:nvGrpSpPr>
        <p:grpSpPr>
          <a:xfrm>
            <a:off x="7387133" y="777359"/>
            <a:ext cx="1756867" cy="1317321"/>
            <a:chOff x="7387133" y="802583"/>
            <a:chExt cx="1650292" cy="1317321"/>
          </a:xfrm>
        </p:grpSpPr>
        <p:graphicFrame>
          <p:nvGraphicFramePr>
            <p:cNvPr id="280" name="グラフ 279">
              <a:extLst>
                <a:ext uri="{FF2B5EF4-FFF2-40B4-BE49-F238E27FC236}">
                  <a16:creationId xmlns:a16="http://schemas.microsoft.com/office/drawing/2014/main" id="{174292F9-FB69-47A8-B448-2C7C84C7A30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953806265"/>
                </p:ext>
              </p:extLst>
            </p:nvPr>
          </p:nvGraphicFramePr>
          <p:xfrm>
            <a:off x="7387133" y="802583"/>
            <a:ext cx="1650292" cy="131732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4"/>
            </a:graphicData>
          </a:graphic>
        </p:graphicFrame>
        <p:sp>
          <p:nvSpPr>
            <p:cNvPr id="282" name="テキスト ボックス 281">
              <a:extLst>
                <a:ext uri="{FF2B5EF4-FFF2-40B4-BE49-F238E27FC236}">
                  <a16:creationId xmlns:a16="http://schemas.microsoft.com/office/drawing/2014/main" id="{8C726B29-A140-4897-A9A8-977F37691526}"/>
                </a:ext>
              </a:extLst>
            </p:cNvPr>
            <p:cNvSpPr txBox="1"/>
            <p:nvPr/>
          </p:nvSpPr>
          <p:spPr>
            <a:xfrm>
              <a:off x="8347042" y="1746777"/>
              <a:ext cx="11974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3" name="テキスト ボックス 282">
              <a:extLst>
                <a:ext uri="{FF2B5EF4-FFF2-40B4-BE49-F238E27FC236}">
                  <a16:creationId xmlns:a16="http://schemas.microsoft.com/office/drawing/2014/main" id="{1B3B7593-7D43-4074-9E20-B8014DEEF24E}"/>
                </a:ext>
              </a:extLst>
            </p:cNvPr>
            <p:cNvSpPr txBox="1"/>
            <p:nvPr/>
          </p:nvSpPr>
          <p:spPr>
            <a:xfrm>
              <a:off x="8569791" y="1746777"/>
              <a:ext cx="11974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4" name="テキスト ボックス 283">
              <a:extLst>
                <a:ext uri="{FF2B5EF4-FFF2-40B4-BE49-F238E27FC236}">
                  <a16:creationId xmlns:a16="http://schemas.microsoft.com/office/drawing/2014/main" id="{1F06DFD7-F970-4334-9698-762826FADEBB}"/>
                </a:ext>
              </a:extLst>
            </p:cNvPr>
            <p:cNvSpPr txBox="1"/>
            <p:nvPr/>
          </p:nvSpPr>
          <p:spPr>
            <a:xfrm>
              <a:off x="8713807" y="1746777"/>
              <a:ext cx="26264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5" name="テキスト ボックス 284">
              <a:extLst>
                <a:ext uri="{FF2B5EF4-FFF2-40B4-BE49-F238E27FC236}">
                  <a16:creationId xmlns:a16="http://schemas.microsoft.com/office/drawing/2014/main" id="{77827F01-2AB7-49F3-B850-C7D085627869}"/>
                </a:ext>
              </a:extLst>
            </p:cNvPr>
            <p:cNvSpPr txBox="1"/>
            <p:nvPr/>
          </p:nvSpPr>
          <p:spPr>
            <a:xfrm>
              <a:off x="7954727" y="1746776"/>
              <a:ext cx="31371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−</a:t>
              </a:r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6" name="テキスト ボックス 285">
              <a:extLst>
                <a:ext uri="{FF2B5EF4-FFF2-40B4-BE49-F238E27FC236}">
                  <a16:creationId xmlns:a16="http://schemas.microsoft.com/office/drawing/2014/main" id="{17EEFA33-6122-43A6-B63E-3D58B9701D7C}"/>
                </a:ext>
              </a:extLst>
            </p:cNvPr>
            <p:cNvSpPr txBox="1"/>
            <p:nvPr/>
          </p:nvSpPr>
          <p:spPr>
            <a:xfrm>
              <a:off x="7697847" y="1746777"/>
              <a:ext cx="31371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−</a:t>
              </a:r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6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1" name="グループ化 10">
            <a:extLst>
              <a:ext uri="{FF2B5EF4-FFF2-40B4-BE49-F238E27FC236}">
                <a16:creationId xmlns:a16="http://schemas.microsoft.com/office/drawing/2014/main" id="{F6AB37EA-CAC2-46B2-955B-0AA8697E5BAE}"/>
              </a:ext>
            </a:extLst>
          </p:cNvPr>
          <p:cNvGrpSpPr/>
          <p:nvPr/>
        </p:nvGrpSpPr>
        <p:grpSpPr>
          <a:xfrm>
            <a:off x="7400096" y="2032549"/>
            <a:ext cx="1738670" cy="1317322"/>
            <a:chOff x="7400096" y="2057773"/>
            <a:chExt cx="1656185" cy="1317322"/>
          </a:xfrm>
        </p:grpSpPr>
        <p:graphicFrame>
          <p:nvGraphicFramePr>
            <p:cNvPr id="287" name="グラフ 286">
              <a:extLst>
                <a:ext uri="{FF2B5EF4-FFF2-40B4-BE49-F238E27FC236}">
                  <a16:creationId xmlns:a16="http://schemas.microsoft.com/office/drawing/2014/main" id="{AA910E78-1DD2-453C-837A-935C9EFA4B7B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506618882"/>
                </p:ext>
              </p:extLst>
            </p:nvPr>
          </p:nvGraphicFramePr>
          <p:xfrm>
            <a:off x="7400096" y="2057773"/>
            <a:ext cx="1656185" cy="131732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5"/>
            </a:graphicData>
          </a:graphic>
        </p:graphicFrame>
        <p:sp>
          <p:nvSpPr>
            <p:cNvPr id="289" name="テキスト ボックス 288">
              <a:extLst>
                <a:ext uri="{FF2B5EF4-FFF2-40B4-BE49-F238E27FC236}">
                  <a16:creationId xmlns:a16="http://schemas.microsoft.com/office/drawing/2014/main" id="{94F61617-08BD-48B9-985C-8C53BC8CC5F7}"/>
                </a:ext>
              </a:extLst>
            </p:cNvPr>
            <p:cNvSpPr txBox="1"/>
            <p:nvPr/>
          </p:nvSpPr>
          <p:spPr>
            <a:xfrm>
              <a:off x="8370953" y="2990587"/>
              <a:ext cx="11974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0" name="テキスト ボックス 289">
              <a:extLst>
                <a:ext uri="{FF2B5EF4-FFF2-40B4-BE49-F238E27FC236}">
                  <a16:creationId xmlns:a16="http://schemas.microsoft.com/office/drawing/2014/main" id="{49BFD723-E8ED-4978-A793-E159F330966B}"/>
                </a:ext>
              </a:extLst>
            </p:cNvPr>
            <p:cNvSpPr txBox="1"/>
            <p:nvPr/>
          </p:nvSpPr>
          <p:spPr>
            <a:xfrm>
              <a:off x="8593702" y="2990587"/>
              <a:ext cx="11974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1" name="テキスト ボックス 290">
              <a:extLst>
                <a:ext uri="{FF2B5EF4-FFF2-40B4-BE49-F238E27FC236}">
                  <a16:creationId xmlns:a16="http://schemas.microsoft.com/office/drawing/2014/main" id="{A5184D62-7D89-4F83-B741-25121F962CF5}"/>
                </a:ext>
              </a:extLst>
            </p:cNvPr>
            <p:cNvSpPr txBox="1"/>
            <p:nvPr/>
          </p:nvSpPr>
          <p:spPr>
            <a:xfrm>
              <a:off x="8737718" y="2990587"/>
              <a:ext cx="26264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2" name="テキスト ボックス 291">
              <a:extLst>
                <a:ext uri="{FF2B5EF4-FFF2-40B4-BE49-F238E27FC236}">
                  <a16:creationId xmlns:a16="http://schemas.microsoft.com/office/drawing/2014/main" id="{929A22C6-5894-47BE-9572-B08CE7044CEF}"/>
                </a:ext>
              </a:extLst>
            </p:cNvPr>
            <p:cNvSpPr txBox="1"/>
            <p:nvPr/>
          </p:nvSpPr>
          <p:spPr>
            <a:xfrm>
              <a:off x="7978638" y="2990586"/>
              <a:ext cx="31371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−</a:t>
              </a:r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3" name="テキスト ボックス 292">
              <a:extLst>
                <a:ext uri="{FF2B5EF4-FFF2-40B4-BE49-F238E27FC236}">
                  <a16:creationId xmlns:a16="http://schemas.microsoft.com/office/drawing/2014/main" id="{CAA03D73-4625-452F-97F2-AD2772DAD273}"/>
                </a:ext>
              </a:extLst>
            </p:cNvPr>
            <p:cNvSpPr txBox="1"/>
            <p:nvPr/>
          </p:nvSpPr>
          <p:spPr>
            <a:xfrm>
              <a:off x="7721758" y="2990587"/>
              <a:ext cx="31371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−</a:t>
              </a:r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6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C65EA468-A233-40C9-8795-C55863616DA0}"/>
              </a:ext>
            </a:extLst>
          </p:cNvPr>
          <p:cNvGrpSpPr/>
          <p:nvPr/>
        </p:nvGrpSpPr>
        <p:grpSpPr>
          <a:xfrm>
            <a:off x="7418923" y="3254455"/>
            <a:ext cx="1709366" cy="1317321"/>
            <a:chOff x="7418923" y="3279679"/>
            <a:chExt cx="1696655" cy="1317321"/>
          </a:xfrm>
        </p:grpSpPr>
        <p:graphicFrame>
          <p:nvGraphicFramePr>
            <p:cNvPr id="294" name="グラフ 293">
              <a:extLst>
                <a:ext uri="{FF2B5EF4-FFF2-40B4-BE49-F238E27FC236}">
                  <a16:creationId xmlns:a16="http://schemas.microsoft.com/office/drawing/2014/main" id="{31DEE228-4445-4CE6-A3A2-DBDB8184063C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036738681"/>
                </p:ext>
              </p:extLst>
            </p:nvPr>
          </p:nvGraphicFramePr>
          <p:xfrm>
            <a:off x="7418923" y="3279679"/>
            <a:ext cx="1696655" cy="131732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6"/>
            </a:graphicData>
          </a:graphic>
        </p:graphicFrame>
        <p:sp>
          <p:nvSpPr>
            <p:cNvPr id="295" name="テキスト ボックス 294">
              <a:extLst>
                <a:ext uri="{FF2B5EF4-FFF2-40B4-BE49-F238E27FC236}">
                  <a16:creationId xmlns:a16="http://schemas.microsoft.com/office/drawing/2014/main" id="{059E56EA-E8C5-4B86-80C0-16F9CD504743}"/>
                </a:ext>
              </a:extLst>
            </p:cNvPr>
            <p:cNvSpPr txBox="1"/>
            <p:nvPr/>
          </p:nvSpPr>
          <p:spPr>
            <a:xfrm>
              <a:off x="8376186" y="4207901"/>
              <a:ext cx="11974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6" name="テキスト ボックス 295">
              <a:extLst>
                <a:ext uri="{FF2B5EF4-FFF2-40B4-BE49-F238E27FC236}">
                  <a16:creationId xmlns:a16="http://schemas.microsoft.com/office/drawing/2014/main" id="{8C19291E-79D5-4363-BFE8-2EA843C8D36C}"/>
                </a:ext>
              </a:extLst>
            </p:cNvPr>
            <p:cNvSpPr txBox="1"/>
            <p:nvPr/>
          </p:nvSpPr>
          <p:spPr>
            <a:xfrm>
              <a:off x="8639944" y="4207901"/>
              <a:ext cx="11974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7" name="テキスト ボックス 296">
              <a:extLst>
                <a:ext uri="{FF2B5EF4-FFF2-40B4-BE49-F238E27FC236}">
                  <a16:creationId xmlns:a16="http://schemas.microsoft.com/office/drawing/2014/main" id="{1972CA3F-7001-4EAA-A25B-5257C98F41A9}"/>
                </a:ext>
              </a:extLst>
            </p:cNvPr>
            <p:cNvSpPr txBox="1"/>
            <p:nvPr/>
          </p:nvSpPr>
          <p:spPr>
            <a:xfrm>
              <a:off x="8809347" y="4207901"/>
              <a:ext cx="26264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8" name="テキスト ボックス 297">
              <a:extLst>
                <a:ext uri="{FF2B5EF4-FFF2-40B4-BE49-F238E27FC236}">
                  <a16:creationId xmlns:a16="http://schemas.microsoft.com/office/drawing/2014/main" id="{D83C961B-7C6D-4114-94D4-EE5C1413BD70}"/>
                </a:ext>
              </a:extLst>
            </p:cNvPr>
            <p:cNvSpPr txBox="1"/>
            <p:nvPr/>
          </p:nvSpPr>
          <p:spPr>
            <a:xfrm>
              <a:off x="7954727" y="4207900"/>
              <a:ext cx="31371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−</a:t>
              </a:r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9" name="テキスト ボックス 298">
              <a:extLst>
                <a:ext uri="{FF2B5EF4-FFF2-40B4-BE49-F238E27FC236}">
                  <a16:creationId xmlns:a16="http://schemas.microsoft.com/office/drawing/2014/main" id="{49F96C2D-3663-49DC-AD20-85432AD4A34A}"/>
                </a:ext>
              </a:extLst>
            </p:cNvPr>
            <p:cNvSpPr txBox="1"/>
            <p:nvPr/>
          </p:nvSpPr>
          <p:spPr>
            <a:xfrm>
              <a:off x="7697942" y="4207901"/>
              <a:ext cx="31371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−</a:t>
              </a:r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6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4" name="グループ化 13">
            <a:extLst>
              <a:ext uri="{FF2B5EF4-FFF2-40B4-BE49-F238E27FC236}">
                <a16:creationId xmlns:a16="http://schemas.microsoft.com/office/drawing/2014/main" id="{1F3D668B-7FE1-4C08-8B21-C56885343819}"/>
              </a:ext>
            </a:extLst>
          </p:cNvPr>
          <p:cNvGrpSpPr/>
          <p:nvPr/>
        </p:nvGrpSpPr>
        <p:grpSpPr>
          <a:xfrm>
            <a:off x="7446195" y="4451504"/>
            <a:ext cx="1697805" cy="1317262"/>
            <a:chOff x="7446195" y="4476728"/>
            <a:chExt cx="1697805" cy="1317262"/>
          </a:xfrm>
        </p:grpSpPr>
        <p:graphicFrame>
          <p:nvGraphicFramePr>
            <p:cNvPr id="300" name="グラフ 299">
              <a:extLst>
                <a:ext uri="{FF2B5EF4-FFF2-40B4-BE49-F238E27FC236}">
                  <a16:creationId xmlns:a16="http://schemas.microsoft.com/office/drawing/2014/main" id="{1C8B0379-6084-470E-AEE9-DF23B7E6EB64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660299726"/>
                </p:ext>
              </p:extLst>
            </p:nvPr>
          </p:nvGraphicFramePr>
          <p:xfrm>
            <a:off x="7446195" y="4476728"/>
            <a:ext cx="1697805" cy="131726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7"/>
            </a:graphicData>
          </a:graphic>
        </p:graphicFrame>
        <p:sp>
          <p:nvSpPr>
            <p:cNvPr id="301" name="テキスト ボックス 300">
              <a:extLst>
                <a:ext uri="{FF2B5EF4-FFF2-40B4-BE49-F238E27FC236}">
                  <a16:creationId xmlns:a16="http://schemas.microsoft.com/office/drawing/2014/main" id="{09A01A72-C029-4176-B467-BC6AF3731D12}"/>
                </a:ext>
              </a:extLst>
            </p:cNvPr>
            <p:cNvSpPr txBox="1"/>
            <p:nvPr/>
          </p:nvSpPr>
          <p:spPr>
            <a:xfrm>
              <a:off x="8402750" y="5403600"/>
              <a:ext cx="11974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2" name="テキスト ボックス 301">
              <a:extLst>
                <a:ext uri="{FF2B5EF4-FFF2-40B4-BE49-F238E27FC236}">
                  <a16:creationId xmlns:a16="http://schemas.microsoft.com/office/drawing/2014/main" id="{B03278C9-30AE-4090-A3C0-249D0E780AC5}"/>
                </a:ext>
              </a:extLst>
            </p:cNvPr>
            <p:cNvSpPr txBox="1"/>
            <p:nvPr/>
          </p:nvSpPr>
          <p:spPr>
            <a:xfrm>
              <a:off x="8666508" y="5403600"/>
              <a:ext cx="11974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3" name="テキスト ボックス 302">
              <a:extLst>
                <a:ext uri="{FF2B5EF4-FFF2-40B4-BE49-F238E27FC236}">
                  <a16:creationId xmlns:a16="http://schemas.microsoft.com/office/drawing/2014/main" id="{902C64A1-AD08-40C4-9860-D96D22B2F645}"/>
                </a:ext>
              </a:extLst>
            </p:cNvPr>
            <p:cNvSpPr txBox="1"/>
            <p:nvPr/>
          </p:nvSpPr>
          <p:spPr>
            <a:xfrm>
              <a:off x="8835911" y="5403600"/>
              <a:ext cx="26264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4" name="テキスト ボックス 303">
              <a:extLst>
                <a:ext uri="{FF2B5EF4-FFF2-40B4-BE49-F238E27FC236}">
                  <a16:creationId xmlns:a16="http://schemas.microsoft.com/office/drawing/2014/main" id="{79C5837E-38B8-428F-AD2F-5BAF3B5C7040}"/>
                </a:ext>
              </a:extLst>
            </p:cNvPr>
            <p:cNvSpPr txBox="1"/>
            <p:nvPr/>
          </p:nvSpPr>
          <p:spPr>
            <a:xfrm>
              <a:off x="7981291" y="5403599"/>
              <a:ext cx="31371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−</a:t>
              </a:r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5" name="テキスト ボックス 304">
              <a:extLst>
                <a:ext uri="{FF2B5EF4-FFF2-40B4-BE49-F238E27FC236}">
                  <a16:creationId xmlns:a16="http://schemas.microsoft.com/office/drawing/2014/main" id="{E0CC233F-1819-448D-B78C-16CF417E10A3}"/>
                </a:ext>
              </a:extLst>
            </p:cNvPr>
            <p:cNvSpPr txBox="1"/>
            <p:nvPr/>
          </p:nvSpPr>
          <p:spPr>
            <a:xfrm>
              <a:off x="7724506" y="5403600"/>
              <a:ext cx="31371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−</a:t>
              </a:r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6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08" name="テキスト ボックス 307">
            <a:extLst>
              <a:ext uri="{FF2B5EF4-FFF2-40B4-BE49-F238E27FC236}">
                <a16:creationId xmlns:a16="http://schemas.microsoft.com/office/drawing/2014/main" id="{8A6F30CD-D532-4CA6-9841-22602DF89725}"/>
              </a:ext>
            </a:extLst>
          </p:cNvPr>
          <p:cNvSpPr txBox="1"/>
          <p:nvPr/>
        </p:nvSpPr>
        <p:spPr>
          <a:xfrm>
            <a:off x="79987" y="1260625"/>
            <a:ext cx="900119" cy="2528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PGE</a:t>
            </a:r>
            <a:r>
              <a:rPr kumimoji="1" lang="en-US" altLang="ja-JP" sz="10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1" lang="ja-JP" altLang="en-US" sz="1000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9" name="テキスト ボックス 308">
            <a:extLst>
              <a:ext uri="{FF2B5EF4-FFF2-40B4-BE49-F238E27FC236}">
                <a16:creationId xmlns:a16="http://schemas.microsoft.com/office/drawing/2014/main" id="{7C92B87B-CC46-4D21-BB8F-D53E6DDB4792}"/>
              </a:ext>
            </a:extLst>
          </p:cNvPr>
          <p:cNvSpPr txBox="1"/>
          <p:nvPr/>
        </p:nvSpPr>
        <p:spPr>
          <a:xfrm>
            <a:off x="78489" y="2427064"/>
            <a:ext cx="900119" cy="5689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IFN-γ</a:t>
            </a:r>
          </a:p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Stimulation: Con A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0" name="テキスト ボックス 309">
            <a:extLst>
              <a:ext uri="{FF2B5EF4-FFF2-40B4-BE49-F238E27FC236}">
                <a16:creationId xmlns:a16="http://schemas.microsoft.com/office/drawing/2014/main" id="{80EB3888-B9C9-4315-B4A0-56B89F6B3D24}"/>
              </a:ext>
            </a:extLst>
          </p:cNvPr>
          <p:cNvSpPr txBox="1"/>
          <p:nvPr/>
        </p:nvSpPr>
        <p:spPr>
          <a:xfrm>
            <a:off x="75536" y="3565222"/>
            <a:ext cx="900119" cy="5689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 IFN-γ</a:t>
            </a:r>
          </a:p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Stimulation: BLV antigen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1" name="テキスト ボックス 310">
            <a:extLst>
              <a:ext uri="{FF2B5EF4-FFF2-40B4-BE49-F238E27FC236}">
                <a16:creationId xmlns:a16="http://schemas.microsoft.com/office/drawing/2014/main" id="{CC823E47-B3A3-4341-A6DB-3BAC2163F0C8}"/>
              </a:ext>
            </a:extLst>
          </p:cNvPr>
          <p:cNvSpPr txBox="1"/>
          <p:nvPr/>
        </p:nvSpPr>
        <p:spPr>
          <a:xfrm>
            <a:off x="79987" y="4953968"/>
            <a:ext cx="900119" cy="2528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 Estradiol</a:t>
            </a:r>
          </a:p>
        </p:txBody>
      </p:sp>
      <p:sp>
        <p:nvSpPr>
          <p:cNvPr id="138" name="テキスト ボックス 137">
            <a:extLst>
              <a:ext uri="{FF2B5EF4-FFF2-40B4-BE49-F238E27FC236}">
                <a16:creationId xmlns:a16="http://schemas.microsoft.com/office/drawing/2014/main" id="{DFDF95D8-B357-43DF-9B17-8601D803838E}"/>
              </a:ext>
            </a:extLst>
          </p:cNvPr>
          <p:cNvSpPr txBox="1"/>
          <p:nvPr/>
        </p:nvSpPr>
        <p:spPr>
          <a:xfrm>
            <a:off x="1028069" y="508746"/>
            <a:ext cx="16054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imal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#1</a:t>
            </a:r>
          </a:p>
        </p:txBody>
      </p:sp>
      <p:sp>
        <p:nvSpPr>
          <p:cNvPr id="139" name="テキスト ボックス 138">
            <a:extLst>
              <a:ext uri="{FF2B5EF4-FFF2-40B4-BE49-F238E27FC236}">
                <a16:creationId xmlns:a16="http://schemas.microsoft.com/office/drawing/2014/main" id="{CD601760-96FA-4B3A-8C3A-744723CEDE29}"/>
              </a:ext>
            </a:extLst>
          </p:cNvPr>
          <p:cNvSpPr txBox="1"/>
          <p:nvPr/>
        </p:nvSpPr>
        <p:spPr>
          <a:xfrm>
            <a:off x="2633514" y="506490"/>
            <a:ext cx="16054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imal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#2</a:t>
            </a:r>
          </a:p>
        </p:txBody>
      </p:sp>
      <p:grpSp>
        <p:nvGrpSpPr>
          <p:cNvPr id="171" name="グループ化 170">
            <a:extLst>
              <a:ext uri="{FF2B5EF4-FFF2-40B4-BE49-F238E27FC236}">
                <a16:creationId xmlns:a16="http://schemas.microsoft.com/office/drawing/2014/main" id="{D301B339-8E17-45F2-A858-119DB467AB8A}"/>
              </a:ext>
            </a:extLst>
          </p:cNvPr>
          <p:cNvGrpSpPr/>
          <p:nvPr/>
        </p:nvGrpSpPr>
        <p:grpSpPr>
          <a:xfrm>
            <a:off x="4164379" y="722373"/>
            <a:ext cx="1656185" cy="1322726"/>
            <a:chOff x="2066670" y="554837"/>
            <a:chExt cx="1656185" cy="1322726"/>
          </a:xfrm>
        </p:grpSpPr>
        <p:graphicFrame>
          <p:nvGraphicFramePr>
            <p:cNvPr id="172" name="グラフ 171">
              <a:extLst>
                <a:ext uri="{FF2B5EF4-FFF2-40B4-BE49-F238E27FC236}">
                  <a16:creationId xmlns:a16="http://schemas.microsoft.com/office/drawing/2014/main" id="{5BBDF09F-DC20-4D43-B98A-E806D3FE970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829141594"/>
                </p:ext>
              </p:extLst>
            </p:nvPr>
          </p:nvGraphicFramePr>
          <p:xfrm>
            <a:off x="2066670" y="554837"/>
            <a:ext cx="1656185" cy="132272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8"/>
            </a:graphicData>
          </a:graphic>
        </p:graphicFrame>
        <p:sp>
          <p:nvSpPr>
            <p:cNvPr id="173" name="テキスト ボックス 172">
              <a:extLst>
                <a:ext uri="{FF2B5EF4-FFF2-40B4-BE49-F238E27FC236}">
                  <a16:creationId xmlns:a16="http://schemas.microsoft.com/office/drawing/2014/main" id="{F13CDC7E-C4F3-4DE4-A3CC-8B52AB6CD831}"/>
                </a:ext>
              </a:extLst>
            </p:cNvPr>
            <p:cNvSpPr txBox="1"/>
            <p:nvPr/>
          </p:nvSpPr>
          <p:spPr>
            <a:xfrm>
              <a:off x="2973500" y="1523811"/>
              <a:ext cx="12654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4" name="テキスト ボックス 173">
              <a:extLst>
                <a:ext uri="{FF2B5EF4-FFF2-40B4-BE49-F238E27FC236}">
                  <a16:creationId xmlns:a16="http://schemas.microsoft.com/office/drawing/2014/main" id="{BAA83713-84FE-4495-AFF1-F38DA056634D}"/>
                </a:ext>
              </a:extLst>
            </p:cNvPr>
            <p:cNvSpPr txBox="1"/>
            <p:nvPr/>
          </p:nvSpPr>
          <p:spPr>
            <a:xfrm>
              <a:off x="3236862" y="1523811"/>
              <a:ext cx="12654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5" name="テキスト ボックス 174">
              <a:extLst>
                <a:ext uri="{FF2B5EF4-FFF2-40B4-BE49-F238E27FC236}">
                  <a16:creationId xmlns:a16="http://schemas.microsoft.com/office/drawing/2014/main" id="{A9862BD3-23C0-4D96-AA31-2186B5B8749A}"/>
                </a:ext>
              </a:extLst>
            </p:cNvPr>
            <p:cNvSpPr txBox="1"/>
            <p:nvPr/>
          </p:nvSpPr>
          <p:spPr>
            <a:xfrm>
              <a:off x="3418227" y="1523811"/>
              <a:ext cx="27756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6" name="テキスト ボックス 175">
              <a:extLst>
                <a:ext uri="{FF2B5EF4-FFF2-40B4-BE49-F238E27FC236}">
                  <a16:creationId xmlns:a16="http://schemas.microsoft.com/office/drawing/2014/main" id="{860A76EC-30E8-49BA-BD85-720C65EFF34A}"/>
                </a:ext>
              </a:extLst>
            </p:cNvPr>
            <p:cNvSpPr txBox="1"/>
            <p:nvPr/>
          </p:nvSpPr>
          <p:spPr>
            <a:xfrm>
              <a:off x="2648214" y="1523811"/>
              <a:ext cx="27756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−</a:t>
              </a:r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7" name="テキスト ボックス 176">
              <a:extLst>
                <a:ext uri="{FF2B5EF4-FFF2-40B4-BE49-F238E27FC236}">
                  <a16:creationId xmlns:a16="http://schemas.microsoft.com/office/drawing/2014/main" id="{331B80B6-FADF-41AE-AAC1-3DD17F0F2E37}"/>
                </a:ext>
              </a:extLst>
            </p:cNvPr>
            <p:cNvSpPr txBox="1"/>
            <p:nvPr/>
          </p:nvSpPr>
          <p:spPr>
            <a:xfrm>
              <a:off x="2345628" y="1523811"/>
              <a:ext cx="331537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−</a:t>
              </a:r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DE80BE6E-0CC8-4C43-99BE-B86CF2E32327}"/>
              </a:ext>
            </a:extLst>
          </p:cNvPr>
          <p:cNvGrpSpPr/>
          <p:nvPr/>
        </p:nvGrpSpPr>
        <p:grpSpPr>
          <a:xfrm>
            <a:off x="4238960" y="3204158"/>
            <a:ext cx="1621341" cy="1322726"/>
            <a:chOff x="4179469" y="3229382"/>
            <a:chExt cx="1680831" cy="1322726"/>
          </a:xfrm>
        </p:grpSpPr>
        <p:graphicFrame>
          <p:nvGraphicFramePr>
            <p:cNvPr id="197" name="グラフ 196">
              <a:extLst>
                <a:ext uri="{FF2B5EF4-FFF2-40B4-BE49-F238E27FC236}">
                  <a16:creationId xmlns:a16="http://schemas.microsoft.com/office/drawing/2014/main" id="{E0322D5B-3510-41A8-8E34-142DC2943786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51472479"/>
                </p:ext>
              </p:extLst>
            </p:nvPr>
          </p:nvGraphicFramePr>
          <p:xfrm>
            <a:off x="4179469" y="3229382"/>
            <a:ext cx="1680831" cy="132272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9"/>
            </a:graphicData>
          </a:graphic>
        </p:graphicFrame>
        <p:sp>
          <p:nvSpPr>
            <p:cNvPr id="198" name="テキスト ボックス 197">
              <a:extLst>
                <a:ext uri="{FF2B5EF4-FFF2-40B4-BE49-F238E27FC236}">
                  <a16:creationId xmlns:a16="http://schemas.microsoft.com/office/drawing/2014/main" id="{C56CC5CC-0C8D-4748-B02B-1002330D026B}"/>
                </a:ext>
              </a:extLst>
            </p:cNvPr>
            <p:cNvSpPr txBox="1"/>
            <p:nvPr/>
          </p:nvSpPr>
          <p:spPr>
            <a:xfrm>
              <a:off x="5089881" y="4184607"/>
              <a:ext cx="12654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9" name="テキスト ボックス 198">
              <a:extLst>
                <a:ext uri="{FF2B5EF4-FFF2-40B4-BE49-F238E27FC236}">
                  <a16:creationId xmlns:a16="http://schemas.microsoft.com/office/drawing/2014/main" id="{C9EA6BCF-D25D-4918-B286-37DD2524E253}"/>
                </a:ext>
              </a:extLst>
            </p:cNvPr>
            <p:cNvSpPr txBox="1"/>
            <p:nvPr/>
          </p:nvSpPr>
          <p:spPr>
            <a:xfrm>
              <a:off x="5353243" y="4184607"/>
              <a:ext cx="12654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0" name="テキスト ボックス 199">
              <a:extLst>
                <a:ext uri="{FF2B5EF4-FFF2-40B4-BE49-F238E27FC236}">
                  <a16:creationId xmlns:a16="http://schemas.microsoft.com/office/drawing/2014/main" id="{87F0C18E-4067-4FE0-B3E2-4F6B61793AAC}"/>
                </a:ext>
              </a:extLst>
            </p:cNvPr>
            <p:cNvSpPr txBox="1"/>
            <p:nvPr/>
          </p:nvSpPr>
          <p:spPr>
            <a:xfrm>
              <a:off x="5534608" y="4184607"/>
              <a:ext cx="27756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1" name="テキスト ボックス 200">
              <a:extLst>
                <a:ext uri="{FF2B5EF4-FFF2-40B4-BE49-F238E27FC236}">
                  <a16:creationId xmlns:a16="http://schemas.microsoft.com/office/drawing/2014/main" id="{00B7A9C0-938B-4662-B7B0-37964C841919}"/>
                </a:ext>
              </a:extLst>
            </p:cNvPr>
            <p:cNvSpPr txBox="1"/>
            <p:nvPr/>
          </p:nvSpPr>
          <p:spPr>
            <a:xfrm>
              <a:off x="4764595" y="4184607"/>
              <a:ext cx="27756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−</a:t>
              </a:r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2" name="テキスト ボックス 201">
              <a:extLst>
                <a:ext uri="{FF2B5EF4-FFF2-40B4-BE49-F238E27FC236}">
                  <a16:creationId xmlns:a16="http://schemas.microsoft.com/office/drawing/2014/main" id="{DF91B22E-480F-4CD6-B722-E70845FA29EE}"/>
                </a:ext>
              </a:extLst>
            </p:cNvPr>
            <p:cNvSpPr txBox="1"/>
            <p:nvPr/>
          </p:nvSpPr>
          <p:spPr>
            <a:xfrm>
              <a:off x="4462009" y="4184607"/>
              <a:ext cx="331537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−</a:t>
              </a:r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9BE6D51C-D593-4FF4-8141-2F4998AC97DA}"/>
              </a:ext>
            </a:extLst>
          </p:cNvPr>
          <p:cNvGrpSpPr/>
          <p:nvPr/>
        </p:nvGrpSpPr>
        <p:grpSpPr>
          <a:xfrm>
            <a:off x="4134740" y="2060205"/>
            <a:ext cx="1738670" cy="1321579"/>
            <a:chOff x="4227016" y="2085429"/>
            <a:chExt cx="1646394" cy="1321579"/>
          </a:xfrm>
        </p:grpSpPr>
        <p:graphicFrame>
          <p:nvGraphicFramePr>
            <p:cNvPr id="232" name="グラフ 231">
              <a:extLst>
                <a:ext uri="{FF2B5EF4-FFF2-40B4-BE49-F238E27FC236}">
                  <a16:creationId xmlns:a16="http://schemas.microsoft.com/office/drawing/2014/main" id="{C9E90149-A703-46B5-843B-74B000577C0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943324328"/>
                </p:ext>
              </p:extLst>
            </p:nvPr>
          </p:nvGraphicFramePr>
          <p:xfrm>
            <a:off x="4227016" y="2085429"/>
            <a:ext cx="1646394" cy="132157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0"/>
            </a:graphicData>
          </a:graphic>
        </p:graphicFrame>
        <p:sp>
          <p:nvSpPr>
            <p:cNvPr id="233" name="テキスト ボックス 232">
              <a:extLst>
                <a:ext uri="{FF2B5EF4-FFF2-40B4-BE49-F238E27FC236}">
                  <a16:creationId xmlns:a16="http://schemas.microsoft.com/office/drawing/2014/main" id="{95B2932A-AB12-4075-8E46-B8F3ABBB5D28}"/>
                </a:ext>
              </a:extLst>
            </p:cNvPr>
            <p:cNvSpPr txBox="1"/>
            <p:nvPr/>
          </p:nvSpPr>
          <p:spPr>
            <a:xfrm>
              <a:off x="5136764" y="2985761"/>
              <a:ext cx="12654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4" name="テキスト ボックス 233">
              <a:extLst>
                <a:ext uri="{FF2B5EF4-FFF2-40B4-BE49-F238E27FC236}">
                  <a16:creationId xmlns:a16="http://schemas.microsoft.com/office/drawing/2014/main" id="{01352B0C-F3A1-4C7F-BF6A-75ECE51561D8}"/>
                </a:ext>
              </a:extLst>
            </p:cNvPr>
            <p:cNvSpPr txBox="1"/>
            <p:nvPr/>
          </p:nvSpPr>
          <p:spPr>
            <a:xfrm>
              <a:off x="5396152" y="2985761"/>
              <a:ext cx="12654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5" name="テキスト ボックス 234">
              <a:extLst>
                <a:ext uri="{FF2B5EF4-FFF2-40B4-BE49-F238E27FC236}">
                  <a16:creationId xmlns:a16="http://schemas.microsoft.com/office/drawing/2014/main" id="{7F5A224F-7F53-416C-9ECC-E04D82990C2C}"/>
                </a:ext>
              </a:extLst>
            </p:cNvPr>
            <p:cNvSpPr txBox="1"/>
            <p:nvPr/>
          </p:nvSpPr>
          <p:spPr>
            <a:xfrm>
              <a:off x="5554784" y="2981562"/>
              <a:ext cx="27756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6" name="テキスト ボックス 235">
              <a:extLst>
                <a:ext uri="{FF2B5EF4-FFF2-40B4-BE49-F238E27FC236}">
                  <a16:creationId xmlns:a16="http://schemas.microsoft.com/office/drawing/2014/main" id="{3595137E-9CDD-422B-8092-F736368397BE}"/>
                </a:ext>
              </a:extLst>
            </p:cNvPr>
            <p:cNvSpPr txBox="1"/>
            <p:nvPr/>
          </p:nvSpPr>
          <p:spPr>
            <a:xfrm>
              <a:off x="4834063" y="2990354"/>
              <a:ext cx="27756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−</a:t>
              </a:r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7" name="テキスト ボックス 236">
              <a:extLst>
                <a:ext uri="{FF2B5EF4-FFF2-40B4-BE49-F238E27FC236}">
                  <a16:creationId xmlns:a16="http://schemas.microsoft.com/office/drawing/2014/main" id="{FAEB6979-1048-42BA-BBD9-31A01E91B0D9}"/>
                </a:ext>
              </a:extLst>
            </p:cNvPr>
            <p:cNvSpPr txBox="1"/>
            <p:nvPr/>
          </p:nvSpPr>
          <p:spPr>
            <a:xfrm>
              <a:off x="4550818" y="2985761"/>
              <a:ext cx="331537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−</a:t>
              </a:r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BC69CD75-CBAE-4804-BDF4-348C5967991B}"/>
              </a:ext>
            </a:extLst>
          </p:cNvPr>
          <p:cNvGrpSpPr/>
          <p:nvPr/>
        </p:nvGrpSpPr>
        <p:grpSpPr>
          <a:xfrm>
            <a:off x="4179530" y="4470779"/>
            <a:ext cx="1680173" cy="1317320"/>
            <a:chOff x="4209822" y="4496003"/>
            <a:chExt cx="1649881" cy="1317320"/>
          </a:xfrm>
        </p:grpSpPr>
        <p:graphicFrame>
          <p:nvGraphicFramePr>
            <p:cNvPr id="262" name="グラフ 261">
              <a:extLst>
                <a:ext uri="{FF2B5EF4-FFF2-40B4-BE49-F238E27FC236}">
                  <a16:creationId xmlns:a16="http://schemas.microsoft.com/office/drawing/2014/main" id="{960D1463-B49D-49DA-A644-AB09A65C280E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655047375"/>
                </p:ext>
              </p:extLst>
            </p:nvPr>
          </p:nvGraphicFramePr>
          <p:xfrm>
            <a:off x="4209822" y="4496003"/>
            <a:ext cx="1649881" cy="131732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1"/>
            </a:graphicData>
          </a:graphic>
        </p:graphicFrame>
        <p:sp>
          <p:nvSpPr>
            <p:cNvPr id="263" name="テキスト ボックス 262">
              <a:extLst>
                <a:ext uri="{FF2B5EF4-FFF2-40B4-BE49-F238E27FC236}">
                  <a16:creationId xmlns:a16="http://schemas.microsoft.com/office/drawing/2014/main" id="{E5C405F5-39E6-46E6-9F14-294D56A71467}"/>
                </a:ext>
              </a:extLst>
            </p:cNvPr>
            <p:cNvSpPr txBox="1"/>
            <p:nvPr/>
          </p:nvSpPr>
          <p:spPr>
            <a:xfrm>
              <a:off x="5089662" y="5425707"/>
              <a:ext cx="12654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4" name="テキスト ボックス 263">
              <a:extLst>
                <a:ext uri="{FF2B5EF4-FFF2-40B4-BE49-F238E27FC236}">
                  <a16:creationId xmlns:a16="http://schemas.microsoft.com/office/drawing/2014/main" id="{2D825B21-5197-4185-88AA-78049B60F06A}"/>
                </a:ext>
              </a:extLst>
            </p:cNvPr>
            <p:cNvSpPr txBox="1"/>
            <p:nvPr/>
          </p:nvSpPr>
          <p:spPr>
            <a:xfrm>
              <a:off x="5353024" y="5425707"/>
              <a:ext cx="12654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5" name="テキスト ボックス 264">
              <a:extLst>
                <a:ext uri="{FF2B5EF4-FFF2-40B4-BE49-F238E27FC236}">
                  <a16:creationId xmlns:a16="http://schemas.microsoft.com/office/drawing/2014/main" id="{A771C0A4-AE16-41E3-87E3-36A7342619E5}"/>
                </a:ext>
              </a:extLst>
            </p:cNvPr>
            <p:cNvSpPr txBox="1"/>
            <p:nvPr/>
          </p:nvSpPr>
          <p:spPr>
            <a:xfrm>
              <a:off x="5534389" y="5425707"/>
              <a:ext cx="27756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6" name="テキスト ボックス 265">
              <a:extLst>
                <a:ext uri="{FF2B5EF4-FFF2-40B4-BE49-F238E27FC236}">
                  <a16:creationId xmlns:a16="http://schemas.microsoft.com/office/drawing/2014/main" id="{C4144025-4C2B-4EDD-B4B5-B497CA5A6C58}"/>
                </a:ext>
              </a:extLst>
            </p:cNvPr>
            <p:cNvSpPr txBox="1"/>
            <p:nvPr/>
          </p:nvSpPr>
          <p:spPr>
            <a:xfrm>
              <a:off x="4772231" y="5420405"/>
              <a:ext cx="27756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−</a:t>
              </a:r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7" name="テキスト ボックス 266">
              <a:extLst>
                <a:ext uri="{FF2B5EF4-FFF2-40B4-BE49-F238E27FC236}">
                  <a16:creationId xmlns:a16="http://schemas.microsoft.com/office/drawing/2014/main" id="{DB7CDFDA-6EE1-4F55-A68B-087871343034}"/>
                </a:ext>
              </a:extLst>
            </p:cNvPr>
            <p:cNvSpPr txBox="1"/>
            <p:nvPr/>
          </p:nvSpPr>
          <p:spPr>
            <a:xfrm>
              <a:off x="4496627" y="5425707"/>
              <a:ext cx="331537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−</a:t>
              </a:r>
              <a:r>
                <a:rPr kumimoji="1" lang="en-US" altLang="ja-JP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  <a:endParaRPr kumimoji="1" lang="ja-JP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40" name="テキスト ボックス 139">
            <a:extLst>
              <a:ext uri="{FF2B5EF4-FFF2-40B4-BE49-F238E27FC236}">
                <a16:creationId xmlns:a16="http://schemas.microsoft.com/office/drawing/2014/main" id="{59D467CB-33B1-4CA3-8E6D-3183ED61E224}"/>
              </a:ext>
            </a:extLst>
          </p:cNvPr>
          <p:cNvSpPr txBox="1"/>
          <p:nvPr/>
        </p:nvSpPr>
        <p:spPr>
          <a:xfrm>
            <a:off x="4179530" y="509141"/>
            <a:ext cx="16054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imal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#3</a:t>
            </a:r>
          </a:p>
        </p:txBody>
      </p:sp>
      <p:sp>
        <p:nvSpPr>
          <p:cNvPr id="141" name="テキスト ボックス 140">
            <a:extLst>
              <a:ext uri="{FF2B5EF4-FFF2-40B4-BE49-F238E27FC236}">
                <a16:creationId xmlns:a16="http://schemas.microsoft.com/office/drawing/2014/main" id="{1AFC04EB-1A16-4F14-A864-35E7E44F8273}"/>
              </a:ext>
            </a:extLst>
          </p:cNvPr>
          <p:cNvSpPr txBox="1"/>
          <p:nvPr/>
        </p:nvSpPr>
        <p:spPr>
          <a:xfrm>
            <a:off x="5873874" y="507262"/>
            <a:ext cx="16054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imal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#4</a:t>
            </a:r>
          </a:p>
        </p:txBody>
      </p:sp>
      <p:sp>
        <p:nvSpPr>
          <p:cNvPr id="142" name="テキスト ボックス 141">
            <a:extLst>
              <a:ext uri="{FF2B5EF4-FFF2-40B4-BE49-F238E27FC236}">
                <a16:creationId xmlns:a16="http://schemas.microsoft.com/office/drawing/2014/main" id="{5F15F3C2-BFC9-4ECD-A783-3B956FD0F51C}"/>
              </a:ext>
            </a:extLst>
          </p:cNvPr>
          <p:cNvSpPr txBox="1"/>
          <p:nvPr/>
        </p:nvSpPr>
        <p:spPr>
          <a:xfrm>
            <a:off x="7508789" y="510375"/>
            <a:ext cx="16054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imal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#5</a:t>
            </a:r>
          </a:p>
        </p:txBody>
      </p:sp>
      <p:sp>
        <p:nvSpPr>
          <p:cNvPr id="143" name="TextBox 7">
            <a:extLst>
              <a:ext uri="{FF2B5EF4-FFF2-40B4-BE49-F238E27FC236}">
                <a16:creationId xmlns:a16="http://schemas.microsoft.com/office/drawing/2014/main" id="{D1DF9BC9-7D86-44CB-AE48-35613DCE802F}"/>
              </a:ext>
            </a:extLst>
          </p:cNvPr>
          <p:cNvSpPr txBox="1"/>
          <p:nvPr/>
        </p:nvSpPr>
        <p:spPr>
          <a:xfrm>
            <a:off x="143065" y="103003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/>
              <a:t>Supplementary Figure 1</a:t>
            </a:r>
            <a:endParaRPr lang="en-US" b="1" dirty="0"/>
          </a:p>
        </p:txBody>
      </p:sp>
      <p:sp>
        <p:nvSpPr>
          <p:cNvPr id="153" name="テキスト ボックス 152">
            <a:extLst>
              <a:ext uri="{FF2B5EF4-FFF2-40B4-BE49-F238E27FC236}">
                <a16:creationId xmlns:a16="http://schemas.microsoft.com/office/drawing/2014/main" id="{E3FB41F5-2D7E-4E2A-AF55-2A8448859765}"/>
              </a:ext>
            </a:extLst>
          </p:cNvPr>
          <p:cNvSpPr txBox="1"/>
          <p:nvPr/>
        </p:nvSpPr>
        <p:spPr>
          <a:xfrm>
            <a:off x="285919" y="5963452"/>
            <a:ext cx="8549992" cy="57708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050" b="1" dirty="0"/>
              <a:t>Supplementary Figure </a:t>
            </a:r>
            <a:r>
              <a:rPr lang="en-US" altLang="ja-JP" sz="105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. Analyses of BLV-infected pregnant cattle (raw data). </a:t>
            </a:r>
            <a:endParaRPr lang="ja-JP" altLang="ja-JP" sz="1050" b="1" kern="100" dirty="0">
              <a:effectLst/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05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a) The concentrations of PGE</a:t>
            </a:r>
            <a:r>
              <a:rPr lang="en-US" altLang="ja-JP" sz="1050" kern="100" baseline="-25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2</a:t>
            </a:r>
            <a:r>
              <a:rPr lang="en-US" altLang="ja-JP" sz="105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in the sera were determined by ELISA. (b and c) Whole-blood culture or PBMC culture was performed to evaluate IFN-γ production in response to Con A or gp51 peptide mix, respectively. (d) The concentrations of estradiol in the sera were determined by ELISA.</a:t>
            </a:r>
            <a:endParaRPr lang="ja-JP" altLang="ja-JP" sz="1050" kern="100" dirty="0">
              <a:effectLst/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825257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Paper format">
      <a:majorFont>
        <a:latin typeface="Times New Roman"/>
        <a:ea typeface="ＭＳ 明朝"/>
        <a:cs typeface=""/>
      </a:majorFont>
      <a:minorFont>
        <a:latin typeface="Times New Roman"/>
        <a:ea typeface="ＭＳ 明朝"/>
        <a:cs typeface="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2</TotalTime>
  <Words>497</Words>
  <Application>Microsoft Office PowerPoint</Application>
  <PresentationFormat>On-screen Show (4:3)</PresentationFormat>
  <Paragraphs>15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Times New Roman</vt:lpstr>
      <vt:lpstr>Office テーマ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orting information 1</dc:title>
  <dc:creator>大和 佐治木</dc:creator>
  <cp:lastModifiedBy>Saranya Siva</cp:lastModifiedBy>
  <cp:revision>15</cp:revision>
  <dcterms:created xsi:type="dcterms:W3CDTF">2020-02-18T07:37:16Z</dcterms:created>
  <dcterms:modified xsi:type="dcterms:W3CDTF">2022-02-15T03:40:45Z</dcterms:modified>
</cp:coreProperties>
</file>